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9" d="100"/>
          <a:sy n="79" d="100"/>
        </p:scale>
        <p:origin x="42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62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2000" b="1" dirty="0">
                <a:solidFill>
                  <a:schemeClr val="tx1"/>
                </a:solidFill>
              </a:rPr>
              <a:t>VS-GY</a:t>
            </a:r>
          </a:p>
        </c:rich>
      </c:tx>
      <c:layout>
        <c:manualLayout>
          <c:xMode val="edge"/>
          <c:yMode val="edge"/>
          <c:x val="0.42029431321084865"/>
          <c:y val="3.086419753086419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62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Sheet1!$H$1</c:f>
              <c:strCache>
                <c:ptCount val="1"/>
                <c:pt idx="0">
                  <c:v>GY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0.13808223972003508"/>
                  <c:y val="-0.25765147412129041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1197" b="0" i="0" u="none" strike="noStrike" kern="1200" baseline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b="1" baseline="0" dirty="0">
                        <a:solidFill>
                          <a:schemeClr val="tx1"/>
                        </a:solidFill>
                      </a:rPr>
                      <a:t>y = 49.697x - 38.217</a:t>
                    </a:r>
                    <a:br>
                      <a:rPr lang="en-US" b="1" baseline="0" dirty="0">
                        <a:solidFill>
                          <a:schemeClr val="tx1"/>
                        </a:solidFill>
                      </a:rPr>
                    </a:br>
                    <a:r>
                      <a:rPr lang="en-US" b="1" baseline="0" dirty="0">
                        <a:solidFill>
                          <a:schemeClr val="tx1"/>
                        </a:solidFill>
                      </a:rPr>
                      <a:t>R² = 0.6262</a:t>
                    </a:r>
                    <a:endParaRPr lang="en-US" b="1" dirty="0">
                      <a:solidFill>
                        <a:schemeClr val="tx1"/>
                      </a:solidFill>
                    </a:endParaRP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197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Sheet1!$B$2:$B$293</c:f>
              <c:numCache>
                <c:formatCode>0.00</c:formatCode>
                <c:ptCount val="292"/>
                <c:pt idx="0">
                  <c:v>1.88529246100041</c:v>
                </c:pt>
                <c:pt idx="1">
                  <c:v>1.64203715057111</c:v>
                </c:pt>
                <c:pt idx="2">
                  <c:v>1.7772126812440501</c:v>
                </c:pt>
                <c:pt idx="3">
                  <c:v>2.03135453248243</c:v>
                </c:pt>
                <c:pt idx="4">
                  <c:v>1.8058810322782199</c:v>
                </c:pt>
                <c:pt idx="5">
                  <c:v>1.97727377610321</c:v>
                </c:pt>
                <c:pt idx="6">
                  <c:v>1.97011987035223</c:v>
                </c:pt>
                <c:pt idx="7">
                  <c:v>1.8095628552859999</c:v>
                </c:pt>
                <c:pt idx="8">
                  <c:v>1.60525788973566</c:v>
                </c:pt>
                <c:pt idx="9">
                  <c:v>1.5618280650926399</c:v>
                </c:pt>
                <c:pt idx="10">
                  <c:v>1.8395147611009599</c:v>
                </c:pt>
                <c:pt idx="11">
                  <c:v>1.8203385612746701</c:v>
                </c:pt>
                <c:pt idx="12">
                  <c:v>1.76556617895213</c:v>
                </c:pt>
                <c:pt idx="13">
                  <c:v>1.9774873320038899</c:v>
                </c:pt>
                <c:pt idx="14">
                  <c:v>1.78482755329551</c:v>
                </c:pt>
                <c:pt idx="15">
                  <c:v>1.76004117141022</c:v>
                </c:pt>
                <c:pt idx="16">
                  <c:v>1.9253087635886399</c:v>
                </c:pt>
                <c:pt idx="17">
                  <c:v>1.82572941551236</c:v>
                </c:pt>
                <c:pt idx="18">
                  <c:v>1.7654535745158499</c:v>
                </c:pt>
                <c:pt idx="19">
                  <c:v>1.8795681788447101</c:v>
                </c:pt>
                <c:pt idx="20">
                  <c:v>1.7362504733520301</c:v>
                </c:pt>
                <c:pt idx="21">
                  <c:v>1.75035413393098</c:v>
                </c:pt>
                <c:pt idx="22">
                  <c:v>1.8896722412728799</c:v>
                </c:pt>
                <c:pt idx="23">
                  <c:v>1.77943925281615</c:v>
                </c:pt>
                <c:pt idx="24">
                  <c:v>1.8197970270572099</c:v>
                </c:pt>
                <c:pt idx="25">
                  <c:v>1.0906972010585501</c:v>
                </c:pt>
                <c:pt idx="26">
                  <c:v>1.8700903769164801</c:v>
                </c:pt>
                <c:pt idx="27">
                  <c:v>1.8166388287952699</c:v>
                </c:pt>
                <c:pt idx="28">
                  <c:v>1.8627040190917901</c:v>
                </c:pt>
                <c:pt idx="29">
                  <c:v>1.5002533909081099</c:v>
                </c:pt>
                <c:pt idx="30">
                  <c:v>1.9379701687261199</c:v>
                </c:pt>
                <c:pt idx="31">
                  <c:v>1.9806830772928601</c:v>
                </c:pt>
                <c:pt idx="32">
                  <c:v>1.7624219797567999</c:v>
                </c:pt>
                <c:pt idx="33">
                  <c:v>2.02445966223247</c:v>
                </c:pt>
                <c:pt idx="34">
                  <c:v>1.94600721161173</c:v>
                </c:pt>
                <c:pt idx="35">
                  <c:v>1.79359596482801</c:v>
                </c:pt>
                <c:pt idx="36">
                  <c:v>2.07831677183224</c:v>
                </c:pt>
                <c:pt idx="37">
                  <c:v>1.85960266027244</c:v>
                </c:pt>
                <c:pt idx="38">
                  <c:v>1.85458963701882</c:v>
                </c:pt>
                <c:pt idx="39">
                  <c:v>2.0145551375287001</c:v>
                </c:pt>
                <c:pt idx="40">
                  <c:v>1.93912866661564</c:v>
                </c:pt>
                <c:pt idx="41">
                  <c:v>1.88072432465621</c:v>
                </c:pt>
                <c:pt idx="42">
                  <c:v>1.79916928593491</c:v>
                </c:pt>
                <c:pt idx="43">
                  <c:v>1.54422903754703</c:v>
                </c:pt>
                <c:pt idx="44">
                  <c:v>1.9629582025265799</c:v>
                </c:pt>
                <c:pt idx="45">
                  <c:v>1.71635635895273</c:v>
                </c:pt>
                <c:pt idx="46">
                  <c:v>1.1539558544949799</c:v>
                </c:pt>
                <c:pt idx="47">
                  <c:v>1.8604293098731499</c:v>
                </c:pt>
                <c:pt idx="48">
                  <c:v>2.0406532102784398</c:v>
                </c:pt>
                <c:pt idx="49">
                  <c:v>1.73352077636358</c:v>
                </c:pt>
                <c:pt idx="50">
                  <c:v>1.7468546004641301</c:v>
                </c:pt>
                <c:pt idx="51">
                  <c:v>1.6051717658301401</c:v>
                </c:pt>
                <c:pt idx="52">
                  <c:v>2.0115461364540601</c:v>
                </c:pt>
                <c:pt idx="53">
                  <c:v>1.8832805438137901</c:v>
                </c:pt>
                <c:pt idx="54">
                  <c:v>2.0788618759579802</c:v>
                </c:pt>
                <c:pt idx="55">
                  <c:v>1.9388499478168899</c:v>
                </c:pt>
                <c:pt idx="56">
                  <c:v>1.8736320846004</c:v>
                </c:pt>
                <c:pt idx="57">
                  <c:v>1.7740610602856299</c:v>
                </c:pt>
                <c:pt idx="58">
                  <c:v>2.1187149205462998</c:v>
                </c:pt>
                <c:pt idx="59">
                  <c:v>1.60395576716142</c:v>
                </c:pt>
                <c:pt idx="60">
                  <c:v>1.98673701197653</c:v>
                </c:pt>
                <c:pt idx="61">
                  <c:v>1.7511270605684599</c:v>
                </c:pt>
                <c:pt idx="62">
                  <c:v>1.7167167950323301</c:v>
                </c:pt>
                <c:pt idx="63">
                  <c:v>1.49461652609887</c:v>
                </c:pt>
                <c:pt idx="64">
                  <c:v>1.9856765143185799</c:v>
                </c:pt>
                <c:pt idx="65">
                  <c:v>1.9479322198219899</c:v>
                </c:pt>
                <c:pt idx="66">
                  <c:v>1.7892240938511199</c:v>
                </c:pt>
                <c:pt idx="67">
                  <c:v>1.7761777941646599</c:v>
                </c:pt>
                <c:pt idx="68">
                  <c:v>1.64391699762849</c:v>
                </c:pt>
                <c:pt idx="69">
                  <c:v>1.90010977828922</c:v>
                </c:pt>
                <c:pt idx="70">
                  <c:v>1.32844771083855</c:v>
                </c:pt>
                <c:pt idx="71">
                  <c:v>1.3489422258083399</c:v>
                </c:pt>
                <c:pt idx="72">
                  <c:v>1.8126401900265501</c:v>
                </c:pt>
                <c:pt idx="73">
                  <c:v>1.7304158150356299</c:v>
                </c:pt>
                <c:pt idx="74">
                  <c:v>2.0544517935023401</c:v>
                </c:pt>
                <c:pt idx="75">
                  <c:v>1.73473829271071</c:v>
                </c:pt>
                <c:pt idx="76">
                  <c:v>1.9572981239188401</c:v>
                </c:pt>
                <c:pt idx="77">
                  <c:v>1.695336458286</c:v>
                </c:pt>
                <c:pt idx="78">
                  <c:v>1.7922978677414201</c:v>
                </c:pt>
                <c:pt idx="79">
                  <c:v>1.43653998693527</c:v>
                </c:pt>
                <c:pt idx="80">
                  <c:v>1.8960520417964599</c:v>
                </c:pt>
                <c:pt idx="81">
                  <c:v>2.0028346781330701</c:v>
                </c:pt>
                <c:pt idx="82">
                  <c:v>1.60098801115427</c:v>
                </c:pt>
                <c:pt idx="83">
                  <c:v>1.85854329800431</c:v>
                </c:pt>
                <c:pt idx="84">
                  <c:v>1.8868070670216099</c:v>
                </c:pt>
                <c:pt idx="85">
                  <c:v>1.53581540726293</c:v>
                </c:pt>
                <c:pt idx="86">
                  <c:v>1.6925685932682999</c:v>
                </c:pt>
                <c:pt idx="87">
                  <c:v>1.43931534086127</c:v>
                </c:pt>
                <c:pt idx="88">
                  <c:v>1.54551688594847</c:v>
                </c:pt>
                <c:pt idx="89">
                  <c:v>1.7267611064645301</c:v>
                </c:pt>
                <c:pt idx="90">
                  <c:v>1.7079761867099801</c:v>
                </c:pt>
                <c:pt idx="91">
                  <c:v>1.85984924864609</c:v>
                </c:pt>
                <c:pt idx="92">
                  <c:v>1.9444371233096001</c:v>
                </c:pt>
                <c:pt idx="93">
                  <c:v>1.74172895523489</c:v>
                </c:pt>
                <c:pt idx="94">
                  <c:v>1.9648655593592299</c:v>
                </c:pt>
                <c:pt idx="95">
                  <c:v>1.7831111172501199</c:v>
                </c:pt>
                <c:pt idx="96">
                  <c:v>1.68896194463073</c:v>
                </c:pt>
                <c:pt idx="97">
                  <c:v>2.0411916213158601</c:v>
                </c:pt>
                <c:pt idx="98">
                  <c:v>1.9003900506851701</c:v>
                </c:pt>
                <c:pt idx="99">
                  <c:v>1.82223363377944</c:v>
                </c:pt>
                <c:pt idx="100">
                  <c:v>1.91384772875442</c:v>
                </c:pt>
                <c:pt idx="101">
                  <c:v>2.02132738059565</c:v>
                </c:pt>
                <c:pt idx="102">
                  <c:v>1.8866614587916799</c:v>
                </c:pt>
                <c:pt idx="103">
                  <c:v>1.87480822954135</c:v>
                </c:pt>
                <c:pt idx="104">
                  <c:v>1.92779388130138</c:v>
                </c:pt>
                <c:pt idx="105">
                  <c:v>1.82002788710997</c:v>
                </c:pt>
                <c:pt idx="106">
                  <c:v>2.0526265200654201</c:v>
                </c:pt>
                <c:pt idx="107">
                  <c:v>1.9762051036870101</c:v>
                </c:pt>
                <c:pt idx="108">
                  <c:v>1.8207566134725399</c:v>
                </c:pt>
                <c:pt idx="109">
                  <c:v>1.9840689709227799</c:v>
                </c:pt>
                <c:pt idx="110">
                  <c:v>2.0693110717135101</c:v>
                </c:pt>
                <c:pt idx="111">
                  <c:v>1.8627821072569</c:v>
                </c:pt>
                <c:pt idx="112">
                  <c:v>1.7351018519064501</c:v>
                </c:pt>
                <c:pt idx="113">
                  <c:v>1.8524254816650101</c:v>
                </c:pt>
                <c:pt idx="114">
                  <c:v>1.88830099632098</c:v>
                </c:pt>
                <c:pt idx="115">
                  <c:v>2.0120229255978899</c:v>
                </c:pt>
                <c:pt idx="116">
                  <c:v>1.89395831143195</c:v>
                </c:pt>
                <c:pt idx="117">
                  <c:v>1.54750183816285</c:v>
                </c:pt>
                <c:pt idx="118">
                  <c:v>1.95347216107344</c:v>
                </c:pt>
                <c:pt idx="119">
                  <c:v>1.7939492216511701</c:v>
                </c:pt>
                <c:pt idx="120">
                  <c:v>1.86606069485392</c:v>
                </c:pt>
                <c:pt idx="121">
                  <c:v>1.81411444246696</c:v>
                </c:pt>
                <c:pt idx="122">
                  <c:v>1.9007800444353999</c:v>
                </c:pt>
                <c:pt idx="123">
                  <c:v>1.9744308672515301</c:v>
                </c:pt>
                <c:pt idx="124">
                  <c:v>1.9093328774485001</c:v>
                </c:pt>
                <c:pt idx="125">
                  <c:v>1.72393795274004</c:v>
                </c:pt>
                <c:pt idx="126">
                  <c:v>1.9938410353877301</c:v>
                </c:pt>
                <c:pt idx="127">
                  <c:v>1.93966534869601</c:v>
                </c:pt>
                <c:pt idx="128">
                  <c:v>2.0675200940816101</c:v>
                </c:pt>
                <c:pt idx="129">
                  <c:v>2.0025335185728799</c:v>
                </c:pt>
                <c:pt idx="130">
                  <c:v>1.9738383461046101</c:v>
                </c:pt>
                <c:pt idx="131">
                  <c:v>1.8943704320071899</c:v>
                </c:pt>
                <c:pt idx="132">
                  <c:v>1.95665164602476</c:v>
                </c:pt>
                <c:pt idx="133">
                  <c:v>1.77213557128216</c:v>
                </c:pt>
                <c:pt idx="134">
                  <c:v>1.9201473571462999</c:v>
                </c:pt>
                <c:pt idx="135">
                  <c:v>1.9770258265751</c:v>
                </c:pt>
                <c:pt idx="136">
                  <c:v>1.59979081038921</c:v>
                </c:pt>
                <c:pt idx="137">
                  <c:v>2.0819457923973199</c:v>
                </c:pt>
                <c:pt idx="138">
                  <c:v>1.6980433205566701</c:v>
                </c:pt>
                <c:pt idx="139">
                  <c:v>1.9174305447036899</c:v>
                </c:pt>
                <c:pt idx="140">
                  <c:v>1.99276946893741</c:v>
                </c:pt>
                <c:pt idx="141">
                  <c:v>1.8180111078582699</c:v>
                </c:pt>
                <c:pt idx="142">
                  <c:v>1.64705385075621</c:v>
                </c:pt>
                <c:pt idx="143">
                  <c:v>1.8600236309757401</c:v>
                </c:pt>
                <c:pt idx="144">
                  <c:v>2.06429984635324</c:v>
                </c:pt>
                <c:pt idx="145">
                  <c:v>1.7828583487109899</c:v>
                </c:pt>
                <c:pt idx="146">
                  <c:v>1.9451274869981801</c:v>
                </c:pt>
                <c:pt idx="147">
                  <c:v>1.83995126379413</c:v>
                </c:pt>
                <c:pt idx="148">
                  <c:v>1.8273008790730301</c:v>
                </c:pt>
                <c:pt idx="149">
                  <c:v>2.0437114654868802</c:v>
                </c:pt>
                <c:pt idx="150">
                  <c:v>1.97290196604143</c:v>
                </c:pt>
                <c:pt idx="151">
                  <c:v>1.7443949941397301</c:v>
                </c:pt>
                <c:pt idx="152">
                  <c:v>2.1422864139526299</c:v>
                </c:pt>
                <c:pt idx="153">
                  <c:v>1.8063058364487701</c:v>
                </c:pt>
                <c:pt idx="154">
                  <c:v>1.9360417308483</c:v>
                </c:pt>
                <c:pt idx="155">
                  <c:v>1.85588230259686</c:v>
                </c:pt>
                <c:pt idx="156">
                  <c:v>1.7621890762040999</c:v>
                </c:pt>
                <c:pt idx="157">
                  <c:v>1.8180984915696301</c:v>
                </c:pt>
                <c:pt idx="158">
                  <c:v>2.0706742474816</c:v>
                </c:pt>
                <c:pt idx="159">
                  <c:v>1.89532328566251</c:v>
                </c:pt>
                <c:pt idx="160">
                  <c:v>2.0744532648496201</c:v>
                </c:pt>
                <c:pt idx="161">
                  <c:v>1.85964088670589</c:v>
                </c:pt>
                <c:pt idx="162">
                  <c:v>2.0649278451573498</c:v>
                </c:pt>
                <c:pt idx="163">
                  <c:v>2.0447210860001102</c:v>
                </c:pt>
                <c:pt idx="164">
                  <c:v>2.01648343449083</c:v>
                </c:pt>
                <c:pt idx="165">
                  <c:v>1.7712500424994799</c:v>
                </c:pt>
                <c:pt idx="166">
                  <c:v>1.86715618126824</c:v>
                </c:pt>
                <c:pt idx="167">
                  <c:v>1.8093628128774999</c:v>
                </c:pt>
                <c:pt idx="168">
                  <c:v>1.90094849986075</c:v>
                </c:pt>
                <c:pt idx="169">
                  <c:v>1.97750945020522</c:v>
                </c:pt>
                <c:pt idx="170">
                  <c:v>1.78330555429286</c:v>
                </c:pt>
                <c:pt idx="171">
                  <c:v>1.89968052804805</c:v>
                </c:pt>
                <c:pt idx="172">
                  <c:v>2.0075687296103299</c:v>
                </c:pt>
                <c:pt idx="173">
                  <c:v>1.68944824569553</c:v>
                </c:pt>
                <c:pt idx="174">
                  <c:v>2.0882089914921398</c:v>
                </c:pt>
                <c:pt idx="175">
                  <c:v>1.83032920204717</c:v>
                </c:pt>
                <c:pt idx="176">
                  <c:v>1.9293174431875</c:v>
                </c:pt>
                <c:pt idx="177">
                  <c:v>2.04952918443573</c:v>
                </c:pt>
                <c:pt idx="178">
                  <c:v>1.8643661141005301</c:v>
                </c:pt>
                <c:pt idx="179">
                  <c:v>1.9492625905913901</c:v>
                </c:pt>
                <c:pt idx="180">
                  <c:v>1.74972512518042</c:v>
                </c:pt>
                <c:pt idx="181">
                  <c:v>1.8300970035619</c:v>
                </c:pt>
                <c:pt idx="182">
                  <c:v>2.0144801890340598</c:v>
                </c:pt>
                <c:pt idx="183">
                  <c:v>1.2204242581659599</c:v>
                </c:pt>
                <c:pt idx="184">
                  <c:v>1.99005463411254</c:v>
                </c:pt>
                <c:pt idx="185">
                  <c:v>1.8685092109488901</c:v>
                </c:pt>
                <c:pt idx="186">
                  <c:v>1.85864618577618</c:v>
                </c:pt>
                <c:pt idx="187">
                  <c:v>1.89945641248046</c:v>
                </c:pt>
                <c:pt idx="188">
                  <c:v>1.9707730056347399</c:v>
                </c:pt>
                <c:pt idx="189">
                  <c:v>1.8926021008075999</c:v>
                </c:pt>
                <c:pt idx="190">
                  <c:v>1.9155961687655201</c:v>
                </c:pt>
                <c:pt idx="191">
                  <c:v>1.8907216557431299</c:v>
                </c:pt>
                <c:pt idx="192">
                  <c:v>2.0842261067069301</c:v>
                </c:pt>
                <c:pt idx="193">
                  <c:v>1.85206994467137</c:v>
                </c:pt>
                <c:pt idx="194">
                  <c:v>1.7502907922078299</c:v>
                </c:pt>
                <c:pt idx="195">
                  <c:v>1.81259649455911</c:v>
                </c:pt>
                <c:pt idx="196">
                  <c:v>2.0010535075132299</c:v>
                </c:pt>
                <c:pt idx="197">
                  <c:v>1.5682769996789201</c:v>
                </c:pt>
                <c:pt idx="198">
                  <c:v>2.05329292061296</c:v>
                </c:pt>
                <c:pt idx="199">
                  <c:v>2.0397542116913501</c:v>
                </c:pt>
                <c:pt idx="200">
                  <c:v>1.59251569663337</c:v>
                </c:pt>
                <c:pt idx="201">
                  <c:v>2.0377653515690799</c:v>
                </c:pt>
                <c:pt idx="202">
                  <c:v>1.9650217993349699</c:v>
                </c:pt>
                <c:pt idx="203">
                  <c:v>1.66163750436257</c:v>
                </c:pt>
                <c:pt idx="204">
                  <c:v>1.97702325495415</c:v>
                </c:pt>
                <c:pt idx="205">
                  <c:v>1.51566977286385</c:v>
                </c:pt>
                <c:pt idx="206">
                  <c:v>1.94720236700782</c:v>
                </c:pt>
                <c:pt idx="207">
                  <c:v>1.5593954416842699</c:v>
                </c:pt>
                <c:pt idx="208">
                  <c:v>1.9196012704316601</c:v>
                </c:pt>
                <c:pt idx="209">
                  <c:v>1.8708965026050099</c:v>
                </c:pt>
                <c:pt idx="210">
                  <c:v>1.98008128454471</c:v>
                </c:pt>
                <c:pt idx="211">
                  <c:v>1.7815145452515999</c:v>
                </c:pt>
                <c:pt idx="212">
                  <c:v>1.7553815133897599</c:v>
                </c:pt>
                <c:pt idx="213">
                  <c:v>1.6866030830566501</c:v>
                </c:pt>
                <c:pt idx="214">
                  <c:v>1.84836752356684</c:v>
                </c:pt>
                <c:pt idx="215">
                  <c:v>1.85653155192506</c:v>
                </c:pt>
                <c:pt idx="216">
                  <c:v>1.4942976800687899</c:v>
                </c:pt>
                <c:pt idx="217">
                  <c:v>1.73202601374484</c:v>
                </c:pt>
                <c:pt idx="218">
                  <c:v>1.78456343207354</c:v>
                </c:pt>
                <c:pt idx="219">
                  <c:v>1.97942403665055</c:v>
                </c:pt>
                <c:pt idx="220">
                  <c:v>1.39941734849128</c:v>
                </c:pt>
                <c:pt idx="221">
                  <c:v>1.8419678140699001</c:v>
                </c:pt>
                <c:pt idx="222">
                  <c:v>1.93485278352895</c:v>
                </c:pt>
                <c:pt idx="223">
                  <c:v>1.6963111833151701</c:v>
                </c:pt>
                <c:pt idx="224">
                  <c:v>1.66686931989244</c:v>
                </c:pt>
                <c:pt idx="225">
                  <c:v>2.1078118412453302</c:v>
                </c:pt>
                <c:pt idx="226">
                  <c:v>1.6861173076787099</c:v>
                </c:pt>
                <c:pt idx="227">
                  <c:v>1.5946010474949499</c:v>
                </c:pt>
                <c:pt idx="228">
                  <c:v>2.0800594182865901</c:v>
                </c:pt>
                <c:pt idx="229">
                  <c:v>1.66530677562722</c:v>
                </c:pt>
                <c:pt idx="230">
                  <c:v>2.0633126054062698</c:v>
                </c:pt>
                <c:pt idx="231">
                  <c:v>1.7804899122715101</c:v>
                </c:pt>
                <c:pt idx="232">
                  <c:v>1.9085756189952801</c:v>
                </c:pt>
                <c:pt idx="233">
                  <c:v>1.90421805594852</c:v>
                </c:pt>
                <c:pt idx="234">
                  <c:v>1.79183872959721</c:v>
                </c:pt>
                <c:pt idx="235">
                  <c:v>1.562832804049</c:v>
                </c:pt>
                <c:pt idx="236">
                  <c:v>1.8414642796141301</c:v>
                </c:pt>
                <c:pt idx="237">
                  <c:v>1.6705700748471499</c:v>
                </c:pt>
                <c:pt idx="238">
                  <c:v>1.7846812665648399</c:v>
                </c:pt>
                <c:pt idx="239">
                  <c:v>1.51256029025358</c:v>
                </c:pt>
                <c:pt idx="240">
                  <c:v>1.8642604804209699</c:v>
                </c:pt>
                <c:pt idx="241">
                  <c:v>1.8155614330279199</c:v>
                </c:pt>
                <c:pt idx="242">
                  <c:v>1.91584641113603</c:v>
                </c:pt>
                <c:pt idx="243">
                  <c:v>1.99267605726999</c:v>
                </c:pt>
                <c:pt idx="244">
                  <c:v>1.80574545620356</c:v>
                </c:pt>
                <c:pt idx="245">
                  <c:v>1.91998060720875</c:v>
                </c:pt>
                <c:pt idx="246">
                  <c:v>1.9044982665844099</c:v>
                </c:pt>
                <c:pt idx="247">
                  <c:v>1.2827473201717601</c:v>
                </c:pt>
                <c:pt idx="248">
                  <c:v>1.85067926111721</c:v>
                </c:pt>
                <c:pt idx="249">
                  <c:v>1.73606934005699</c:v>
                </c:pt>
                <c:pt idx="250">
                  <c:v>1.9368111883511401</c:v>
                </c:pt>
                <c:pt idx="251">
                  <c:v>1.77639918785283</c:v>
                </c:pt>
                <c:pt idx="252">
                  <c:v>1.7838935483851699</c:v>
                </c:pt>
                <c:pt idx="253">
                  <c:v>2.0152864265715902</c:v>
                </c:pt>
                <c:pt idx="254">
                  <c:v>2.0666460954113899</c:v>
                </c:pt>
                <c:pt idx="255">
                  <c:v>1.59414050780378</c:v>
                </c:pt>
                <c:pt idx="256">
                  <c:v>1.8064486111656799</c:v>
                </c:pt>
                <c:pt idx="257">
                  <c:v>1.9409926741927199</c:v>
                </c:pt>
                <c:pt idx="258">
                  <c:v>1.9809754254279801</c:v>
                </c:pt>
                <c:pt idx="259">
                  <c:v>1.7932256210922599</c:v>
                </c:pt>
                <c:pt idx="260">
                  <c:v>1.83321263337308</c:v>
                </c:pt>
                <c:pt idx="261">
                  <c:v>1.82272916168401</c:v>
                </c:pt>
                <c:pt idx="262">
                  <c:v>1.9183757009694</c:v>
                </c:pt>
                <c:pt idx="263">
                  <c:v>1.8390199701923</c:v>
                </c:pt>
                <c:pt idx="264">
                  <c:v>1.59714384055729</c:v>
                </c:pt>
                <c:pt idx="265">
                  <c:v>1.8839542934593001</c:v>
                </c:pt>
                <c:pt idx="266">
                  <c:v>1.8672031809854399</c:v>
                </c:pt>
                <c:pt idx="267">
                  <c:v>1.9116460503307999</c:v>
                </c:pt>
                <c:pt idx="268">
                  <c:v>1.6943705616120699</c:v>
                </c:pt>
                <c:pt idx="269">
                  <c:v>1.9742081674330101</c:v>
                </c:pt>
                <c:pt idx="270">
                  <c:v>1.7822073097825299</c:v>
                </c:pt>
                <c:pt idx="271">
                  <c:v>1.9871301624001401</c:v>
                </c:pt>
                <c:pt idx="272">
                  <c:v>1.33253296625035</c:v>
                </c:pt>
                <c:pt idx="273">
                  <c:v>1.4924915151690099</c:v>
                </c:pt>
                <c:pt idx="274">
                  <c:v>2.0853760509287902</c:v>
                </c:pt>
                <c:pt idx="275">
                  <c:v>2.0008555258426099</c:v>
                </c:pt>
                <c:pt idx="276">
                  <c:v>1.5098439591743</c:v>
                </c:pt>
                <c:pt idx="277">
                  <c:v>1.9896948364521301</c:v>
                </c:pt>
                <c:pt idx="278">
                  <c:v>1.66410749739513</c:v>
                </c:pt>
                <c:pt idx="279">
                  <c:v>1.95699450014993</c:v>
                </c:pt>
                <c:pt idx="280">
                  <c:v>1.71835452072247</c:v>
                </c:pt>
                <c:pt idx="281">
                  <c:v>1.8153827919187799</c:v>
                </c:pt>
                <c:pt idx="282">
                  <c:v>1.8619013569617899</c:v>
                </c:pt>
                <c:pt idx="283">
                  <c:v>1.9746229610014701</c:v>
                </c:pt>
                <c:pt idx="284">
                  <c:v>2.00888335351828</c:v>
                </c:pt>
                <c:pt idx="285">
                  <c:v>1.84059488156769</c:v>
                </c:pt>
                <c:pt idx="286">
                  <c:v>1.76046437783189</c:v>
                </c:pt>
                <c:pt idx="287">
                  <c:v>2.1263831214373599</c:v>
                </c:pt>
                <c:pt idx="288">
                  <c:v>2.05112087263897</c:v>
                </c:pt>
                <c:pt idx="289">
                  <c:v>1.9151150526452401</c:v>
                </c:pt>
                <c:pt idx="290">
                  <c:v>1.9080415940555799</c:v>
                </c:pt>
                <c:pt idx="291">
                  <c:v>1.86499425336709</c:v>
                </c:pt>
              </c:numCache>
            </c:numRef>
          </c:xVal>
          <c:yVal>
            <c:numRef>
              <c:f>Sheet1!$H$2:$H$293</c:f>
              <c:numCache>
                <c:formatCode>0.00</c:formatCode>
                <c:ptCount val="292"/>
                <c:pt idx="0">
                  <c:v>56.972077100385398</c:v>
                </c:pt>
                <c:pt idx="1">
                  <c:v>50.274495062583703</c:v>
                </c:pt>
                <c:pt idx="2">
                  <c:v>51.893962270069103</c:v>
                </c:pt>
                <c:pt idx="3">
                  <c:v>71.713090752602795</c:v>
                </c:pt>
                <c:pt idx="4">
                  <c:v>50.053466729707203</c:v>
                </c:pt>
                <c:pt idx="5">
                  <c:v>57.995876173584897</c:v>
                </c:pt>
                <c:pt idx="6">
                  <c:v>61.7723183678198</c:v>
                </c:pt>
                <c:pt idx="7">
                  <c:v>61.180472178970199</c:v>
                </c:pt>
                <c:pt idx="8">
                  <c:v>44.037192089527601</c:v>
                </c:pt>
                <c:pt idx="9">
                  <c:v>50.879199692966601</c:v>
                </c:pt>
                <c:pt idx="10">
                  <c:v>50.302686169060799</c:v>
                </c:pt>
                <c:pt idx="11">
                  <c:v>54.101407795382499</c:v>
                </c:pt>
                <c:pt idx="12">
                  <c:v>56.347289590662399</c:v>
                </c:pt>
                <c:pt idx="13">
                  <c:v>56.779356748393703</c:v>
                </c:pt>
                <c:pt idx="14">
                  <c:v>47.872790316589096</c:v>
                </c:pt>
                <c:pt idx="15">
                  <c:v>46.936973608139702</c:v>
                </c:pt>
                <c:pt idx="16">
                  <c:v>42.991609451018903</c:v>
                </c:pt>
                <c:pt idx="17">
                  <c:v>53.781982524356799</c:v>
                </c:pt>
                <c:pt idx="18">
                  <c:v>56.869674615574503</c:v>
                </c:pt>
                <c:pt idx="19">
                  <c:v>53.646277321138598</c:v>
                </c:pt>
                <c:pt idx="20">
                  <c:v>48.098484237270803</c:v>
                </c:pt>
                <c:pt idx="21">
                  <c:v>40.027290026322</c:v>
                </c:pt>
                <c:pt idx="22">
                  <c:v>54.007265579851101</c:v>
                </c:pt>
                <c:pt idx="23">
                  <c:v>44.144985457485802</c:v>
                </c:pt>
                <c:pt idx="24">
                  <c:v>53.762647668883702</c:v>
                </c:pt>
                <c:pt idx="25">
                  <c:v>9.0131931736008006</c:v>
                </c:pt>
                <c:pt idx="26">
                  <c:v>52.398549481149097</c:v>
                </c:pt>
                <c:pt idx="27">
                  <c:v>57.434719609964901</c:v>
                </c:pt>
                <c:pt idx="28">
                  <c:v>47.967287803390398</c:v>
                </c:pt>
                <c:pt idx="29">
                  <c:v>36.310119942835698</c:v>
                </c:pt>
                <c:pt idx="30">
                  <c:v>55.676408319631101</c:v>
                </c:pt>
                <c:pt idx="31">
                  <c:v>48.581742345490099</c:v>
                </c:pt>
                <c:pt idx="32">
                  <c:v>62.594002300875502</c:v>
                </c:pt>
                <c:pt idx="33">
                  <c:v>59.854779654009597</c:v>
                </c:pt>
                <c:pt idx="34">
                  <c:v>54.451483677633703</c:v>
                </c:pt>
                <c:pt idx="35">
                  <c:v>38.007132229040202</c:v>
                </c:pt>
                <c:pt idx="36">
                  <c:v>62.626498851359003</c:v>
                </c:pt>
                <c:pt idx="37">
                  <c:v>57.662376091029998</c:v>
                </c:pt>
                <c:pt idx="38">
                  <c:v>53.879139369179299</c:v>
                </c:pt>
                <c:pt idx="39">
                  <c:v>55.809472138745598</c:v>
                </c:pt>
                <c:pt idx="40">
                  <c:v>58.794624656558298</c:v>
                </c:pt>
                <c:pt idx="41">
                  <c:v>60.375381862704003</c:v>
                </c:pt>
                <c:pt idx="42">
                  <c:v>41.696600406779197</c:v>
                </c:pt>
                <c:pt idx="43">
                  <c:v>26.2433277633552</c:v>
                </c:pt>
                <c:pt idx="44">
                  <c:v>58.641955807548101</c:v>
                </c:pt>
                <c:pt idx="45">
                  <c:v>36.4543313130388</c:v>
                </c:pt>
                <c:pt idx="46">
                  <c:v>21.785192929797201</c:v>
                </c:pt>
                <c:pt idx="47">
                  <c:v>64.993278644278902</c:v>
                </c:pt>
                <c:pt idx="48">
                  <c:v>61.614071168195402</c:v>
                </c:pt>
                <c:pt idx="49">
                  <c:v>49.677969121519403</c:v>
                </c:pt>
                <c:pt idx="50">
                  <c:v>47.505857965697899</c:v>
                </c:pt>
                <c:pt idx="51">
                  <c:v>38.737598262460899</c:v>
                </c:pt>
                <c:pt idx="52">
                  <c:v>70.781531285897103</c:v>
                </c:pt>
                <c:pt idx="53">
                  <c:v>62.907709950822202</c:v>
                </c:pt>
                <c:pt idx="54">
                  <c:v>61.335014178162801</c:v>
                </c:pt>
                <c:pt idx="55">
                  <c:v>56.919721777076802</c:v>
                </c:pt>
                <c:pt idx="56">
                  <c:v>52.448920107840401</c:v>
                </c:pt>
                <c:pt idx="57">
                  <c:v>49.935286212189098</c:v>
                </c:pt>
                <c:pt idx="58">
                  <c:v>52.909163062357997</c:v>
                </c:pt>
                <c:pt idx="59">
                  <c:v>28.537327549817299</c:v>
                </c:pt>
                <c:pt idx="60">
                  <c:v>72.2613551862256</c:v>
                </c:pt>
                <c:pt idx="61">
                  <c:v>55.991890964098801</c:v>
                </c:pt>
                <c:pt idx="62">
                  <c:v>56.114212597211299</c:v>
                </c:pt>
                <c:pt idx="63">
                  <c:v>27.575735701159999</c:v>
                </c:pt>
                <c:pt idx="64">
                  <c:v>55.569873870355202</c:v>
                </c:pt>
                <c:pt idx="65">
                  <c:v>53.895857340886302</c:v>
                </c:pt>
                <c:pt idx="66">
                  <c:v>49.875933443380902</c:v>
                </c:pt>
                <c:pt idx="67">
                  <c:v>46.410331813190403</c:v>
                </c:pt>
                <c:pt idx="68">
                  <c:v>38.706625116673301</c:v>
                </c:pt>
                <c:pt idx="69">
                  <c:v>49.195967025716698</c:v>
                </c:pt>
                <c:pt idx="70">
                  <c:v>26.5962564349357</c:v>
                </c:pt>
                <c:pt idx="71">
                  <c:v>29.163189362389101</c:v>
                </c:pt>
                <c:pt idx="72">
                  <c:v>49.660122124788501</c:v>
                </c:pt>
                <c:pt idx="73">
                  <c:v>42.178618792316598</c:v>
                </c:pt>
                <c:pt idx="74">
                  <c:v>82.350829867282002</c:v>
                </c:pt>
                <c:pt idx="75">
                  <c:v>60.671912046148798</c:v>
                </c:pt>
                <c:pt idx="76">
                  <c:v>60.504169400802198</c:v>
                </c:pt>
                <c:pt idx="77">
                  <c:v>48.896858626788699</c:v>
                </c:pt>
                <c:pt idx="78">
                  <c:v>63.628476899675597</c:v>
                </c:pt>
                <c:pt idx="79">
                  <c:v>34.696388549660398</c:v>
                </c:pt>
                <c:pt idx="80">
                  <c:v>42.325771435721897</c:v>
                </c:pt>
                <c:pt idx="81">
                  <c:v>77.710995594919694</c:v>
                </c:pt>
                <c:pt idx="82">
                  <c:v>41.556897161641103</c:v>
                </c:pt>
                <c:pt idx="83">
                  <c:v>59.164431243312002</c:v>
                </c:pt>
                <c:pt idx="84">
                  <c:v>56.008452316598699</c:v>
                </c:pt>
                <c:pt idx="85">
                  <c:v>44.163139359274098</c:v>
                </c:pt>
                <c:pt idx="86">
                  <c:v>41.953259237189698</c:v>
                </c:pt>
                <c:pt idx="87">
                  <c:v>40.528014882408897</c:v>
                </c:pt>
                <c:pt idx="88">
                  <c:v>35.529732105963497</c:v>
                </c:pt>
                <c:pt idx="89">
                  <c:v>42.404185261799498</c:v>
                </c:pt>
                <c:pt idx="90">
                  <c:v>52.576625844025799</c:v>
                </c:pt>
                <c:pt idx="91">
                  <c:v>51.104169695579998</c:v>
                </c:pt>
                <c:pt idx="92">
                  <c:v>55.760705799723297</c:v>
                </c:pt>
                <c:pt idx="93">
                  <c:v>54.631439628722099</c:v>
                </c:pt>
                <c:pt idx="94">
                  <c:v>58.180254171333502</c:v>
                </c:pt>
                <c:pt idx="95">
                  <c:v>45.070798536212799</c:v>
                </c:pt>
                <c:pt idx="96">
                  <c:v>47.922707330841099</c:v>
                </c:pt>
                <c:pt idx="97">
                  <c:v>54.428116453079099</c:v>
                </c:pt>
                <c:pt idx="98">
                  <c:v>58.625309188636201</c:v>
                </c:pt>
                <c:pt idx="99">
                  <c:v>59.299487585082801</c:v>
                </c:pt>
                <c:pt idx="100">
                  <c:v>60.443382341604</c:v>
                </c:pt>
                <c:pt idx="101">
                  <c:v>47.891579937556301</c:v>
                </c:pt>
                <c:pt idx="102">
                  <c:v>64.870201651673696</c:v>
                </c:pt>
                <c:pt idx="103">
                  <c:v>53.223518046519999</c:v>
                </c:pt>
                <c:pt idx="104">
                  <c:v>58.926591542835297</c:v>
                </c:pt>
                <c:pt idx="105">
                  <c:v>48.721980122787798</c:v>
                </c:pt>
                <c:pt idx="106">
                  <c:v>59.578476197647198</c:v>
                </c:pt>
                <c:pt idx="107">
                  <c:v>58.823210911687397</c:v>
                </c:pt>
                <c:pt idx="108">
                  <c:v>56.118116021475402</c:v>
                </c:pt>
                <c:pt idx="109">
                  <c:v>61.316908802032501</c:v>
                </c:pt>
                <c:pt idx="110">
                  <c:v>58.807713792167696</c:v>
                </c:pt>
                <c:pt idx="111">
                  <c:v>49.9405798905712</c:v>
                </c:pt>
                <c:pt idx="112">
                  <c:v>48.235066642264101</c:v>
                </c:pt>
                <c:pt idx="113">
                  <c:v>61.0272653661861</c:v>
                </c:pt>
                <c:pt idx="114">
                  <c:v>45.281684756388103</c:v>
                </c:pt>
                <c:pt idx="115">
                  <c:v>67.459578250342005</c:v>
                </c:pt>
                <c:pt idx="116">
                  <c:v>59.086077576673397</c:v>
                </c:pt>
                <c:pt idx="117">
                  <c:v>43.254642058866999</c:v>
                </c:pt>
                <c:pt idx="118">
                  <c:v>53.600342353512502</c:v>
                </c:pt>
                <c:pt idx="119">
                  <c:v>43.791365948270297</c:v>
                </c:pt>
                <c:pt idx="120">
                  <c:v>58.663991372634399</c:v>
                </c:pt>
                <c:pt idx="121">
                  <c:v>46.274977903686903</c:v>
                </c:pt>
                <c:pt idx="122">
                  <c:v>48.8320315144001</c:v>
                </c:pt>
                <c:pt idx="123">
                  <c:v>70.647393984881703</c:v>
                </c:pt>
                <c:pt idx="124">
                  <c:v>58.8909029726642</c:v>
                </c:pt>
                <c:pt idx="125">
                  <c:v>51.267353876218799</c:v>
                </c:pt>
                <c:pt idx="126">
                  <c:v>63.742125779656497</c:v>
                </c:pt>
                <c:pt idx="127">
                  <c:v>67.928542553243503</c:v>
                </c:pt>
                <c:pt idx="128">
                  <c:v>71.563198014722801</c:v>
                </c:pt>
                <c:pt idx="129">
                  <c:v>59.757550948477999</c:v>
                </c:pt>
                <c:pt idx="130">
                  <c:v>64.022905187432698</c:v>
                </c:pt>
                <c:pt idx="131">
                  <c:v>60.165871537049298</c:v>
                </c:pt>
                <c:pt idx="132">
                  <c:v>51.3146924951781</c:v>
                </c:pt>
                <c:pt idx="133">
                  <c:v>48.590047888970197</c:v>
                </c:pt>
                <c:pt idx="134">
                  <c:v>58.565460347918403</c:v>
                </c:pt>
                <c:pt idx="135">
                  <c:v>64.668024867013898</c:v>
                </c:pt>
                <c:pt idx="136">
                  <c:v>50.876788832705003</c:v>
                </c:pt>
                <c:pt idx="137">
                  <c:v>63.8255387105796</c:v>
                </c:pt>
                <c:pt idx="138">
                  <c:v>43.244778023986598</c:v>
                </c:pt>
                <c:pt idx="139">
                  <c:v>53.201433081363099</c:v>
                </c:pt>
                <c:pt idx="140">
                  <c:v>56.090280126204803</c:v>
                </c:pt>
                <c:pt idx="141">
                  <c:v>49.327301478742903</c:v>
                </c:pt>
                <c:pt idx="142">
                  <c:v>45.867252173397702</c:v>
                </c:pt>
                <c:pt idx="143">
                  <c:v>60.428261133375401</c:v>
                </c:pt>
                <c:pt idx="144">
                  <c:v>67.807811681852698</c:v>
                </c:pt>
                <c:pt idx="145">
                  <c:v>60.341604093229101</c:v>
                </c:pt>
                <c:pt idx="146">
                  <c:v>59.637683669478598</c:v>
                </c:pt>
                <c:pt idx="147">
                  <c:v>61.627867827255599</c:v>
                </c:pt>
                <c:pt idx="148">
                  <c:v>59.646336852831503</c:v>
                </c:pt>
                <c:pt idx="149">
                  <c:v>54.526691443738599</c:v>
                </c:pt>
                <c:pt idx="150">
                  <c:v>75.192574075260097</c:v>
                </c:pt>
                <c:pt idx="151">
                  <c:v>56.211653337613498</c:v>
                </c:pt>
                <c:pt idx="152">
                  <c:v>70.755365941206904</c:v>
                </c:pt>
                <c:pt idx="153">
                  <c:v>38.263261949967102</c:v>
                </c:pt>
                <c:pt idx="154">
                  <c:v>48.285999914370201</c:v>
                </c:pt>
                <c:pt idx="155">
                  <c:v>52.756648017187402</c:v>
                </c:pt>
                <c:pt idx="156">
                  <c:v>42.940091936150701</c:v>
                </c:pt>
                <c:pt idx="157">
                  <c:v>48.846795373706797</c:v>
                </c:pt>
                <c:pt idx="158">
                  <c:v>68.432772068902096</c:v>
                </c:pt>
                <c:pt idx="159">
                  <c:v>56.331199751485201</c:v>
                </c:pt>
                <c:pt idx="160">
                  <c:v>71.093857241296703</c:v>
                </c:pt>
                <c:pt idx="161">
                  <c:v>47.748863438948298</c:v>
                </c:pt>
                <c:pt idx="162">
                  <c:v>63.590925967021498</c:v>
                </c:pt>
                <c:pt idx="163">
                  <c:v>76.906317291512295</c:v>
                </c:pt>
                <c:pt idx="164">
                  <c:v>68.764591385139994</c:v>
                </c:pt>
                <c:pt idx="165">
                  <c:v>62.580621989055103</c:v>
                </c:pt>
                <c:pt idx="166">
                  <c:v>52.228071213885002</c:v>
                </c:pt>
                <c:pt idx="167">
                  <c:v>37.058168369218301</c:v>
                </c:pt>
                <c:pt idx="168">
                  <c:v>67.903632284165994</c:v>
                </c:pt>
                <c:pt idx="169">
                  <c:v>52.162654764120902</c:v>
                </c:pt>
                <c:pt idx="170">
                  <c:v>52.260963102452898</c:v>
                </c:pt>
                <c:pt idx="171">
                  <c:v>51.999256572090097</c:v>
                </c:pt>
                <c:pt idx="172">
                  <c:v>51.488832163144302</c:v>
                </c:pt>
                <c:pt idx="173">
                  <c:v>49.009171785412299</c:v>
                </c:pt>
                <c:pt idx="174">
                  <c:v>67.635396416586602</c:v>
                </c:pt>
                <c:pt idx="175">
                  <c:v>52.979734934627999</c:v>
                </c:pt>
                <c:pt idx="176">
                  <c:v>43.989570135946799</c:v>
                </c:pt>
                <c:pt idx="177">
                  <c:v>70.651179203688301</c:v>
                </c:pt>
                <c:pt idx="178">
                  <c:v>53.847698009892</c:v>
                </c:pt>
                <c:pt idx="179">
                  <c:v>64.782492550404001</c:v>
                </c:pt>
                <c:pt idx="180">
                  <c:v>51.687388166452699</c:v>
                </c:pt>
                <c:pt idx="181">
                  <c:v>45.101457423431498</c:v>
                </c:pt>
                <c:pt idx="182">
                  <c:v>66.063912205334603</c:v>
                </c:pt>
                <c:pt idx="183">
                  <c:v>27.985881561136299</c:v>
                </c:pt>
                <c:pt idx="184">
                  <c:v>54.2592113810665</c:v>
                </c:pt>
                <c:pt idx="185">
                  <c:v>49.840392025159403</c:v>
                </c:pt>
                <c:pt idx="186">
                  <c:v>54.637563790980899</c:v>
                </c:pt>
                <c:pt idx="187">
                  <c:v>67.109259900192598</c:v>
                </c:pt>
                <c:pt idx="188">
                  <c:v>60.1512922151976</c:v>
                </c:pt>
                <c:pt idx="189">
                  <c:v>55.223437037876998</c:v>
                </c:pt>
                <c:pt idx="190">
                  <c:v>56.6625362807412</c:v>
                </c:pt>
                <c:pt idx="191">
                  <c:v>50.815543978080903</c:v>
                </c:pt>
                <c:pt idx="192">
                  <c:v>75.606846539182101</c:v>
                </c:pt>
                <c:pt idx="193">
                  <c:v>46.9869152627167</c:v>
                </c:pt>
                <c:pt idx="194">
                  <c:v>47.520139698214102</c:v>
                </c:pt>
                <c:pt idx="195">
                  <c:v>46.315987902472699</c:v>
                </c:pt>
                <c:pt idx="196">
                  <c:v>65.286724821380005</c:v>
                </c:pt>
                <c:pt idx="197">
                  <c:v>60.324440640246202</c:v>
                </c:pt>
                <c:pt idx="198">
                  <c:v>49.851426262169099</c:v>
                </c:pt>
                <c:pt idx="199">
                  <c:v>70.412289309144398</c:v>
                </c:pt>
                <c:pt idx="200">
                  <c:v>31.308167787830399</c:v>
                </c:pt>
                <c:pt idx="201">
                  <c:v>59.223889368471497</c:v>
                </c:pt>
                <c:pt idx="202">
                  <c:v>59.001077672024998</c:v>
                </c:pt>
                <c:pt idx="203">
                  <c:v>45.433091166193201</c:v>
                </c:pt>
                <c:pt idx="204">
                  <c:v>52.952952822794799</c:v>
                </c:pt>
                <c:pt idx="205">
                  <c:v>31.934683259602</c:v>
                </c:pt>
                <c:pt idx="206">
                  <c:v>66.971362683960507</c:v>
                </c:pt>
                <c:pt idx="207">
                  <c:v>36.096375649022903</c:v>
                </c:pt>
                <c:pt idx="208">
                  <c:v>59.6412817803471</c:v>
                </c:pt>
                <c:pt idx="209">
                  <c:v>54.790189522879302</c:v>
                </c:pt>
                <c:pt idx="210">
                  <c:v>60.826313233139203</c:v>
                </c:pt>
                <c:pt idx="211">
                  <c:v>51.9356854990369</c:v>
                </c:pt>
                <c:pt idx="212">
                  <c:v>59.065201713704496</c:v>
                </c:pt>
                <c:pt idx="213">
                  <c:v>42.242472159188097</c:v>
                </c:pt>
                <c:pt idx="214">
                  <c:v>54.472301503230803</c:v>
                </c:pt>
                <c:pt idx="215">
                  <c:v>60.259387955799703</c:v>
                </c:pt>
                <c:pt idx="216">
                  <c:v>30.868899475521101</c:v>
                </c:pt>
                <c:pt idx="217">
                  <c:v>36.894735270520798</c:v>
                </c:pt>
                <c:pt idx="218">
                  <c:v>45.606245925547803</c:v>
                </c:pt>
                <c:pt idx="219">
                  <c:v>55.843714523368703</c:v>
                </c:pt>
                <c:pt idx="220">
                  <c:v>31.155211776591798</c:v>
                </c:pt>
                <c:pt idx="221">
                  <c:v>50.748057305221799</c:v>
                </c:pt>
                <c:pt idx="222">
                  <c:v>58.0290247415492</c:v>
                </c:pt>
                <c:pt idx="223">
                  <c:v>41.000284984001802</c:v>
                </c:pt>
                <c:pt idx="224">
                  <c:v>54.068462339065903</c:v>
                </c:pt>
                <c:pt idx="225">
                  <c:v>69.137858767567394</c:v>
                </c:pt>
                <c:pt idx="226">
                  <c:v>42.990008479852499</c:v>
                </c:pt>
                <c:pt idx="227">
                  <c:v>33.499299100843501</c:v>
                </c:pt>
                <c:pt idx="228">
                  <c:v>59.083023540164099</c:v>
                </c:pt>
                <c:pt idx="229">
                  <c:v>54.401734980352202</c:v>
                </c:pt>
                <c:pt idx="230">
                  <c:v>70.983496962599801</c:v>
                </c:pt>
                <c:pt idx="231">
                  <c:v>42.280161391491198</c:v>
                </c:pt>
                <c:pt idx="232">
                  <c:v>56.883508068888702</c:v>
                </c:pt>
                <c:pt idx="233">
                  <c:v>57.0240135484378</c:v>
                </c:pt>
                <c:pt idx="234">
                  <c:v>57.955703235564201</c:v>
                </c:pt>
                <c:pt idx="235">
                  <c:v>43.5314750530246</c:v>
                </c:pt>
                <c:pt idx="236">
                  <c:v>50.664581374276104</c:v>
                </c:pt>
                <c:pt idx="237">
                  <c:v>36.603483778226597</c:v>
                </c:pt>
                <c:pt idx="238">
                  <c:v>54.4311322425566</c:v>
                </c:pt>
                <c:pt idx="239">
                  <c:v>40.939998979766997</c:v>
                </c:pt>
                <c:pt idx="240">
                  <c:v>49.660595598154899</c:v>
                </c:pt>
                <c:pt idx="241">
                  <c:v>49.263777346776102</c:v>
                </c:pt>
                <c:pt idx="242">
                  <c:v>51.011070271085302</c:v>
                </c:pt>
                <c:pt idx="243">
                  <c:v>66.610148000527403</c:v>
                </c:pt>
                <c:pt idx="244">
                  <c:v>47.972404582197399</c:v>
                </c:pt>
                <c:pt idx="245">
                  <c:v>61.1601612302223</c:v>
                </c:pt>
                <c:pt idx="246">
                  <c:v>60.026672189200603</c:v>
                </c:pt>
                <c:pt idx="247">
                  <c:v>21.7647749498853</c:v>
                </c:pt>
                <c:pt idx="248">
                  <c:v>58.572987816476598</c:v>
                </c:pt>
                <c:pt idx="249">
                  <c:v>52.5323875572468</c:v>
                </c:pt>
                <c:pt idx="250">
                  <c:v>52.998580150862303</c:v>
                </c:pt>
                <c:pt idx="251">
                  <c:v>54.4942167787001</c:v>
                </c:pt>
                <c:pt idx="252">
                  <c:v>49.855690965553698</c:v>
                </c:pt>
                <c:pt idx="253">
                  <c:v>58.956414858443502</c:v>
                </c:pt>
                <c:pt idx="254">
                  <c:v>76.731228560061794</c:v>
                </c:pt>
                <c:pt idx="255">
                  <c:v>27.240965868897799</c:v>
                </c:pt>
                <c:pt idx="256">
                  <c:v>50.909235898459002</c:v>
                </c:pt>
                <c:pt idx="257">
                  <c:v>68.736162365080204</c:v>
                </c:pt>
                <c:pt idx="258">
                  <c:v>73.733485074619594</c:v>
                </c:pt>
                <c:pt idx="259">
                  <c:v>46.551512182548699</c:v>
                </c:pt>
                <c:pt idx="260">
                  <c:v>53.482651487735303</c:v>
                </c:pt>
                <c:pt idx="261">
                  <c:v>39.100818098411203</c:v>
                </c:pt>
                <c:pt idx="262">
                  <c:v>51.214858763842997</c:v>
                </c:pt>
                <c:pt idx="263">
                  <c:v>46.053050275939199</c:v>
                </c:pt>
                <c:pt idx="264">
                  <c:v>35.825806557620197</c:v>
                </c:pt>
                <c:pt idx="265">
                  <c:v>62.783162679559901</c:v>
                </c:pt>
                <c:pt idx="266">
                  <c:v>46.514628516579599</c:v>
                </c:pt>
                <c:pt idx="267">
                  <c:v>53.995020481960999</c:v>
                </c:pt>
                <c:pt idx="268">
                  <c:v>43.071453824174398</c:v>
                </c:pt>
                <c:pt idx="269">
                  <c:v>49.074829233558397</c:v>
                </c:pt>
                <c:pt idx="270">
                  <c:v>49.765163778967398</c:v>
                </c:pt>
                <c:pt idx="271">
                  <c:v>61.623355253410502</c:v>
                </c:pt>
                <c:pt idx="272">
                  <c:v>32.918851551533301</c:v>
                </c:pt>
                <c:pt idx="273">
                  <c:v>43.388638800723101</c:v>
                </c:pt>
                <c:pt idx="274">
                  <c:v>60.609318615525503</c:v>
                </c:pt>
                <c:pt idx="275">
                  <c:v>63.064100310151197</c:v>
                </c:pt>
                <c:pt idx="276">
                  <c:v>32.4962147027219</c:v>
                </c:pt>
                <c:pt idx="277">
                  <c:v>58.957866142950202</c:v>
                </c:pt>
                <c:pt idx="278">
                  <c:v>41.316779690310597</c:v>
                </c:pt>
                <c:pt idx="279">
                  <c:v>52.326392150361897</c:v>
                </c:pt>
                <c:pt idx="280">
                  <c:v>62.787637125143704</c:v>
                </c:pt>
                <c:pt idx="281">
                  <c:v>64.568523738090605</c:v>
                </c:pt>
                <c:pt idx="282">
                  <c:v>58.071389846438898</c:v>
                </c:pt>
                <c:pt idx="283">
                  <c:v>51.754538072477203</c:v>
                </c:pt>
                <c:pt idx="284">
                  <c:v>55.174748251138801</c:v>
                </c:pt>
                <c:pt idx="285">
                  <c:v>53.095891989383297</c:v>
                </c:pt>
                <c:pt idx="286">
                  <c:v>44.844932333790403</c:v>
                </c:pt>
                <c:pt idx="287">
                  <c:v>69.430604336269397</c:v>
                </c:pt>
                <c:pt idx="288">
                  <c:v>58.472214987243703</c:v>
                </c:pt>
                <c:pt idx="289">
                  <c:v>59.932507698279501</c:v>
                </c:pt>
                <c:pt idx="290">
                  <c:v>59.966679205323103</c:v>
                </c:pt>
                <c:pt idx="291">
                  <c:v>49.6493396048718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299-4B35-AC1D-EDE15A26F43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2582656"/>
        <c:axId val="32596736"/>
      </c:scatterChart>
      <c:valAx>
        <c:axId val="3258265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2596736"/>
        <c:crosses val="autoZero"/>
        <c:crossBetween val="midCat"/>
      </c:valAx>
      <c:valAx>
        <c:axId val="325967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258265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62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2000" b="1" dirty="0">
                <a:solidFill>
                  <a:schemeClr val="tx1"/>
                </a:solidFill>
              </a:rPr>
              <a:t>FPod-GY</a:t>
            </a:r>
          </a:p>
        </c:rich>
      </c:tx>
      <c:layout>
        <c:manualLayout>
          <c:xMode val="edge"/>
          <c:yMode val="edge"/>
          <c:x val="0.40637777777777778"/>
          <c:y val="3.96825396825396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62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Sheet1!$H$1</c:f>
              <c:strCache>
                <c:ptCount val="1"/>
                <c:pt idx="0">
                  <c:v>GY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0.14103727034120736"/>
                  <c:y val="-0.2280426752211529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 algn="ctr" rtl="0">
                      <a:defRPr sz="1197" b="0" i="0" u="none" strike="noStrike" kern="1200" baseline="0">
                        <a:solidFill>
                          <a:prstClr val="black">
                            <a:lumMod val="65000"/>
                            <a:lumOff val="35000"/>
                          </a:prst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rPr>
                      <a:t>y = 0.1254x + 15.923</a:t>
                    </a:r>
                    <a:b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rPr>
                    </a:br>
                    <a: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rPr>
                      <a:t>R² = 0.7887</a:t>
                    </a: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 algn="ctr" rtl="0">
                    <a:defRPr sz="1197" b="0" i="0" u="none" strike="noStrike" kern="1200" baseline="0">
                      <a:solidFill>
                        <a:prstClr val="black">
                          <a:lumMod val="65000"/>
                          <a:lumOff val="35000"/>
                        </a:prst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Sheet1!$C$2:$C$293</c:f>
              <c:numCache>
                <c:formatCode>0.00</c:formatCode>
                <c:ptCount val="292"/>
                <c:pt idx="0">
                  <c:v>331.50399551089799</c:v>
                </c:pt>
                <c:pt idx="1">
                  <c:v>269.36774050964198</c:v>
                </c:pt>
                <c:pt idx="2">
                  <c:v>280.23668675944702</c:v>
                </c:pt>
                <c:pt idx="3">
                  <c:v>483.754679547259</c:v>
                </c:pt>
                <c:pt idx="4">
                  <c:v>313.91649614393702</c:v>
                </c:pt>
                <c:pt idx="5">
                  <c:v>394.910376009213</c:v>
                </c:pt>
                <c:pt idx="6">
                  <c:v>329.90218574589102</c:v>
                </c:pt>
                <c:pt idx="7">
                  <c:v>334.01386507701898</c:v>
                </c:pt>
                <c:pt idx="8">
                  <c:v>200.69153170364899</c:v>
                </c:pt>
                <c:pt idx="9">
                  <c:v>247.43846117164199</c:v>
                </c:pt>
                <c:pt idx="10">
                  <c:v>249.55067825746301</c:v>
                </c:pt>
                <c:pt idx="11">
                  <c:v>320.24492381303702</c:v>
                </c:pt>
                <c:pt idx="12">
                  <c:v>300.606667583579</c:v>
                </c:pt>
                <c:pt idx="13">
                  <c:v>295.95135253275498</c:v>
                </c:pt>
                <c:pt idx="14">
                  <c:v>203.423890150754</c:v>
                </c:pt>
                <c:pt idx="15">
                  <c:v>251.64904518229699</c:v>
                </c:pt>
                <c:pt idx="16">
                  <c:v>245.814520992159</c:v>
                </c:pt>
                <c:pt idx="17">
                  <c:v>314.87295736736598</c:v>
                </c:pt>
                <c:pt idx="18">
                  <c:v>274.14523823977203</c:v>
                </c:pt>
                <c:pt idx="19">
                  <c:v>352.30649752512699</c:v>
                </c:pt>
                <c:pt idx="20">
                  <c:v>237.16256976841299</c:v>
                </c:pt>
                <c:pt idx="21">
                  <c:v>212.34313617794899</c:v>
                </c:pt>
                <c:pt idx="22">
                  <c:v>331.48775426406098</c:v>
                </c:pt>
                <c:pt idx="23">
                  <c:v>283.06371997090997</c:v>
                </c:pt>
                <c:pt idx="24">
                  <c:v>272.22919750863099</c:v>
                </c:pt>
                <c:pt idx="25">
                  <c:v>42.284422868268301</c:v>
                </c:pt>
                <c:pt idx="26">
                  <c:v>272.91982345433001</c:v>
                </c:pt>
                <c:pt idx="27">
                  <c:v>279.80111516894402</c:v>
                </c:pt>
                <c:pt idx="28">
                  <c:v>258.25027508037101</c:v>
                </c:pt>
                <c:pt idx="29">
                  <c:v>228.807304823838</c:v>
                </c:pt>
                <c:pt idx="30">
                  <c:v>284.64183320695798</c:v>
                </c:pt>
                <c:pt idx="31">
                  <c:v>292.22875005972298</c:v>
                </c:pt>
                <c:pt idx="32">
                  <c:v>338.141412116053</c:v>
                </c:pt>
                <c:pt idx="33">
                  <c:v>398.076098135525</c:v>
                </c:pt>
                <c:pt idx="34">
                  <c:v>253.27436005388901</c:v>
                </c:pt>
                <c:pt idx="35">
                  <c:v>204.18164751671401</c:v>
                </c:pt>
                <c:pt idx="36">
                  <c:v>386.95680919173299</c:v>
                </c:pt>
                <c:pt idx="37">
                  <c:v>324.30428676675899</c:v>
                </c:pt>
                <c:pt idx="38">
                  <c:v>242.93470234524099</c:v>
                </c:pt>
                <c:pt idx="39">
                  <c:v>364.38288303216098</c:v>
                </c:pt>
                <c:pt idx="40">
                  <c:v>322.30534558124901</c:v>
                </c:pt>
                <c:pt idx="41">
                  <c:v>346.15121254258901</c:v>
                </c:pt>
                <c:pt idx="42">
                  <c:v>177.78653295248699</c:v>
                </c:pt>
                <c:pt idx="43">
                  <c:v>119.395716486293</c:v>
                </c:pt>
                <c:pt idx="44">
                  <c:v>373.08260278923098</c:v>
                </c:pt>
                <c:pt idx="45">
                  <c:v>194.983247642176</c:v>
                </c:pt>
                <c:pt idx="46">
                  <c:v>101.944223028474</c:v>
                </c:pt>
                <c:pt idx="47">
                  <c:v>291.82134061518599</c:v>
                </c:pt>
                <c:pt idx="48">
                  <c:v>429.56461754144999</c:v>
                </c:pt>
                <c:pt idx="49">
                  <c:v>280.87132360946401</c:v>
                </c:pt>
                <c:pt idx="50">
                  <c:v>213.91945590904399</c:v>
                </c:pt>
                <c:pt idx="51">
                  <c:v>184.43643854804</c:v>
                </c:pt>
                <c:pt idx="52">
                  <c:v>459.63750433450099</c:v>
                </c:pt>
                <c:pt idx="53">
                  <c:v>327.76477025293201</c:v>
                </c:pt>
                <c:pt idx="54">
                  <c:v>345.459580201986</c:v>
                </c:pt>
                <c:pt idx="55">
                  <c:v>346.89940902055798</c:v>
                </c:pt>
                <c:pt idx="56">
                  <c:v>319.71272590907</c:v>
                </c:pt>
                <c:pt idx="57">
                  <c:v>238.333245970608</c:v>
                </c:pt>
                <c:pt idx="58">
                  <c:v>273.95902530267199</c:v>
                </c:pt>
                <c:pt idx="59">
                  <c:v>143.54125480073</c:v>
                </c:pt>
                <c:pt idx="60">
                  <c:v>436.16080871279502</c:v>
                </c:pt>
                <c:pt idx="61">
                  <c:v>339.36983926365798</c:v>
                </c:pt>
                <c:pt idx="62">
                  <c:v>286.808189604944</c:v>
                </c:pt>
                <c:pt idx="63">
                  <c:v>142.040672506428</c:v>
                </c:pt>
                <c:pt idx="64">
                  <c:v>356.59730101136699</c:v>
                </c:pt>
                <c:pt idx="65">
                  <c:v>285.522662120414</c:v>
                </c:pt>
                <c:pt idx="66">
                  <c:v>245.9383548918</c:v>
                </c:pt>
                <c:pt idx="67">
                  <c:v>243.12741600726801</c:v>
                </c:pt>
                <c:pt idx="68">
                  <c:v>234.19268093964999</c:v>
                </c:pt>
                <c:pt idx="69">
                  <c:v>273.91960886498401</c:v>
                </c:pt>
                <c:pt idx="70">
                  <c:v>126.512244432816</c:v>
                </c:pt>
                <c:pt idx="71">
                  <c:v>140.04458208863801</c:v>
                </c:pt>
                <c:pt idx="72">
                  <c:v>324.94041531172701</c:v>
                </c:pt>
                <c:pt idx="73">
                  <c:v>252.14869905766199</c:v>
                </c:pt>
                <c:pt idx="74">
                  <c:v>492.69613777974598</c:v>
                </c:pt>
                <c:pt idx="75">
                  <c:v>319.807809776949</c:v>
                </c:pt>
                <c:pt idx="76">
                  <c:v>341.12866799191403</c:v>
                </c:pt>
                <c:pt idx="77">
                  <c:v>259.31294935544997</c:v>
                </c:pt>
                <c:pt idx="78">
                  <c:v>345.10912175436602</c:v>
                </c:pt>
                <c:pt idx="79">
                  <c:v>181.61922095189101</c:v>
                </c:pt>
                <c:pt idx="80">
                  <c:v>256.63766242673699</c:v>
                </c:pt>
                <c:pt idx="81">
                  <c:v>491.195501836304</c:v>
                </c:pt>
                <c:pt idx="82">
                  <c:v>238.93461308203501</c:v>
                </c:pt>
                <c:pt idx="83">
                  <c:v>301.56255035487499</c:v>
                </c:pt>
                <c:pt idx="84">
                  <c:v>250.56124955376001</c:v>
                </c:pt>
                <c:pt idx="85">
                  <c:v>253.23197806255999</c:v>
                </c:pt>
                <c:pt idx="86">
                  <c:v>187.229158131649</c:v>
                </c:pt>
                <c:pt idx="87">
                  <c:v>209.41286462789</c:v>
                </c:pt>
                <c:pt idx="88">
                  <c:v>192.40075117496701</c:v>
                </c:pt>
                <c:pt idx="89">
                  <c:v>200.82413361986201</c:v>
                </c:pt>
                <c:pt idx="90">
                  <c:v>311.45939778766098</c:v>
                </c:pt>
                <c:pt idx="91">
                  <c:v>227.59971649231801</c:v>
                </c:pt>
                <c:pt idx="92">
                  <c:v>306.53498275332299</c:v>
                </c:pt>
                <c:pt idx="93">
                  <c:v>294.75781194292102</c:v>
                </c:pt>
                <c:pt idx="94">
                  <c:v>366.06137977583802</c:v>
                </c:pt>
                <c:pt idx="95">
                  <c:v>204.97710618036501</c:v>
                </c:pt>
                <c:pt idx="96">
                  <c:v>234.83904229044299</c:v>
                </c:pt>
                <c:pt idx="97">
                  <c:v>318.39590193271601</c:v>
                </c:pt>
                <c:pt idx="98">
                  <c:v>337.24419967135702</c:v>
                </c:pt>
                <c:pt idx="99">
                  <c:v>231.458545433143</c:v>
                </c:pt>
                <c:pt idx="100">
                  <c:v>338.60453302693298</c:v>
                </c:pt>
                <c:pt idx="101">
                  <c:v>317.62442143182301</c:v>
                </c:pt>
                <c:pt idx="102">
                  <c:v>349.97232295564402</c:v>
                </c:pt>
                <c:pt idx="103">
                  <c:v>293.52298254253498</c:v>
                </c:pt>
                <c:pt idx="104">
                  <c:v>282.567705187429</c:v>
                </c:pt>
                <c:pt idx="105">
                  <c:v>296.92302536580002</c:v>
                </c:pt>
                <c:pt idx="106">
                  <c:v>360.20400593875098</c:v>
                </c:pt>
                <c:pt idx="107">
                  <c:v>363.07268421327097</c:v>
                </c:pt>
                <c:pt idx="108">
                  <c:v>316.29770122243701</c:v>
                </c:pt>
                <c:pt idx="109">
                  <c:v>322.256878391241</c:v>
                </c:pt>
                <c:pt idx="110">
                  <c:v>434.78613749490199</c:v>
                </c:pt>
                <c:pt idx="111">
                  <c:v>250.12430660805299</c:v>
                </c:pt>
                <c:pt idx="112">
                  <c:v>242.52461790832501</c:v>
                </c:pt>
                <c:pt idx="113">
                  <c:v>380.38914228061799</c:v>
                </c:pt>
                <c:pt idx="114">
                  <c:v>264.43889272682702</c:v>
                </c:pt>
                <c:pt idx="115">
                  <c:v>380.92840268239399</c:v>
                </c:pt>
                <c:pt idx="116">
                  <c:v>318.47076045932602</c:v>
                </c:pt>
                <c:pt idx="117">
                  <c:v>204.83010975460499</c:v>
                </c:pt>
                <c:pt idx="118">
                  <c:v>358.53044128253202</c:v>
                </c:pt>
                <c:pt idx="119">
                  <c:v>222.05032942025699</c:v>
                </c:pt>
                <c:pt idx="120">
                  <c:v>292.99517839556898</c:v>
                </c:pt>
                <c:pt idx="121">
                  <c:v>263.808773371082</c:v>
                </c:pt>
                <c:pt idx="122">
                  <c:v>313.02629601034198</c:v>
                </c:pt>
                <c:pt idx="123">
                  <c:v>356.138744396351</c:v>
                </c:pt>
                <c:pt idx="124">
                  <c:v>367.058604724742</c:v>
                </c:pt>
                <c:pt idx="125">
                  <c:v>256.83885124745302</c:v>
                </c:pt>
                <c:pt idx="126">
                  <c:v>404.97006229636702</c:v>
                </c:pt>
                <c:pt idx="127">
                  <c:v>353.07506662139002</c:v>
                </c:pt>
                <c:pt idx="128">
                  <c:v>365.41091339019698</c:v>
                </c:pt>
                <c:pt idx="129">
                  <c:v>325.44786331622203</c:v>
                </c:pt>
                <c:pt idx="130">
                  <c:v>333.32170815870597</c:v>
                </c:pt>
                <c:pt idx="131">
                  <c:v>305.74639530532397</c:v>
                </c:pt>
                <c:pt idx="132">
                  <c:v>307.19210748767398</c:v>
                </c:pt>
                <c:pt idx="133">
                  <c:v>235.02416406910299</c:v>
                </c:pt>
                <c:pt idx="134">
                  <c:v>291.593947243927</c:v>
                </c:pt>
                <c:pt idx="135">
                  <c:v>385.789630503691</c:v>
                </c:pt>
                <c:pt idx="136">
                  <c:v>270.662244605745</c:v>
                </c:pt>
                <c:pt idx="137">
                  <c:v>427.648947461744</c:v>
                </c:pt>
                <c:pt idx="138">
                  <c:v>235.147321416919</c:v>
                </c:pt>
                <c:pt idx="139">
                  <c:v>304.28756068575399</c:v>
                </c:pt>
                <c:pt idx="140">
                  <c:v>373.589790995116</c:v>
                </c:pt>
                <c:pt idx="141">
                  <c:v>305.41216070350498</c:v>
                </c:pt>
                <c:pt idx="142">
                  <c:v>208.95082159542801</c:v>
                </c:pt>
                <c:pt idx="143">
                  <c:v>305.63133153541202</c:v>
                </c:pt>
                <c:pt idx="144">
                  <c:v>326.39248351490897</c:v>
                </c:pt>
                <c:pt idx="145">
                  <c:v>297.95485881198402</c:v>
                </c:pt>
                <c:pt idx="146">
                  <c:v>309.35645083782998</c:v>
                </c:pt>
                <c:pt idx="147">
                  <c:v>327.069136250241</c:v>
                </c:pt>
                <c:pt idx="148">
                  <c:v>366.264816733798</c:v>
                </c:pt>
                <c:pt idx="149">
                  <c:v>366.03239256319603</c:v>
                </c:pt>
                <c:pt idx="150">
                  <c:v>397.17209073033303</c:v>
                </c:pt>
                <c:pt idx="151">
                  <c:v>311.78150230485397</c:v>
                </c:pt>
                <c:pt idx="152">
                  <c:v>395.02158827732097</c:v>
                </c:pt>
                <c:pt idx="153">
                  <c:v>237.42047895326999</c:v>
                </c:pt>
                <c:pt idx="154">
                  <c:v>245.72326264979301</c:v>
                </c:pt>
                <c:pt idx="155">
                  <c:v>308.36124335480099</c:v>
                </c:pt>
                <c:pt idx="156">
                  <c:v>246.78010972009099</c:v>
                </c:pt>
                <c:pt idx="157">
                  <c:v>269.58218251125197</c:v>
                </c:pt>
                <c:pt idx="158">
                  <c:v>370.46905727772202</c:v>
                </c:pt>
                <c:pt idx="159">
                  <c:v>286.43398538579902</c:v>
                </c:pt>
                <c:pt idx="160">
                  <c:v>455.074750004397</c:v>
                </c:pt>
                <c:pt idx="161">
                  <c:v>317.00314805412501</c:v>
                </c:pt>
                <c:pt idx="162">
                  <c:v>347.37872983081502</c:v>
                </c:pt>
                <c:pt idx="163">
                  <c:v>431.16663585466301</c:v>
                </c:pt>
                <c:pt idx="164">
                  <c:v>410.57030931830701</c:v>
                </c:pt>
                <c:pt idx="165">
                  <c:v>359.494125354544</c:v>
                </c:pt>
                <c:pt idx="166">
                  <c:v>277.60410515677</c:v>
                </c:pt>
                <c:pt idx="167">
                  <c:v>195.329462761017</c:v>
                </c:pt>
                <c:pt idx="168">
                  <c:v>384.355901789239</c:v>
                </c:pt>
                <c:pt idx="169">
                  <c:v>296.670007411705</c:v>
                </c:pt>
                <c:pt idx="170">
                  <c:v>304.62032411454197</c:v>
                </c:pt>
                <c:pt idx="171">
                  <c:v>311.22678250457199</c:v>
                </c:pt>
                <c:pt idx="172">
                  <c:v>299.18683093551101</c:v>
                </c:pt>
                <c:pt idx="173">
                  <c:v>265.27536414306502</c:v>
                </c:pt>
                <c:pt idx="174">
                  <c:v>342.77545584973097</c:v>
                </c:pt>
                <c:pt idx="175">
                  <c:v>277.88575670396199</c:v>
                </c:pt>
                <c:pt idx="176">
                  <c:v>245.19484336526801</c:v>
                </c:pt>
                <c:pt idx="177">
                  <c:v>401.26490955002998</c:v>
                </c:pt>
                <c:pt idx="178">
                  <c:v>275.18269233424098</c:v>
                </c:pt>
                <c:pt idx="179">
                  <c:v>353.28918319090297</c:v>
                </c:pt>
                <c:pt idx="180">
                  <c:v>327.469954146097</c:v>
                </c:pt>
                <c:pt idx="181">
                  <c:v>212.050716765978</c:v>
                </c:pt>
                <c:pt idx="182">
                  <c:v>422.10459383847001</c:v>
                </c:pt>
                <c:pt idx="183">
                  <c:v>116.30259970897301</c:v>
                </c:pt>
                <c:pt idx="184">
                  <c:v>329.17726577509097</c:v>
                </c:pt>
                <c:pt idx="185">
                  <c:v>297.03426909235498</c:v>
                </c:pt>
                <c:pt idx="186">
                  <c:v>330.46458881819598</c:v>
                </c:pt>
                <c:pt idx="187">
                  <c:v>294.64358229023998</c:v>
                </c:pt>
                <c:pt idx="188">
                  <c:v>329.11271837206999</c:v>
                </c:pt>
                <c:pt idx="189">
                  <c:v>387.60915987914098</c:v>
                </c:pt>
                <c:pt idx="190">
                  <c:v>334.87160086876497</c:v>
                </c:pt>
                <c:pt idx="191">
                  <c:v>322.38881848750299</c:v>
                </c:pt>
                <c:pt idx="192">
                  <c:v>427.04295086356802</c:v>
                </c:pt>
                <c:pt idx="193">
                  <c:v>223.443578441325</c:v>
                </c:pt>
                <c:pt idx="194">
                  <c:v>250.00606452196001</c:v>
                </c:pt>
                <c:pt idx="195">
                  <c:v>249.35156123327599</c:v>
                </c:pt>
                <c:pt idx="196">
                  <c:v>384.89045742688501</c:v>
                </c:pt>
                <c:pt idx="197">
                  <c:v>276.49196884816098</c:v>
                </c:pt>
                <c:pt idx="198">
                  <c:v>292.09964737520198</c:v>
                </c:pt>
                <c:pt idx="199">
                  <c:v>422.22490765895401</c:v>
                </c:pt>
                <c:pt idx="200">
                  <c:v>164.72795214204899</c:v>
                </c:pt>
                <c:pt idx="201">
                  <c:v>306.021355052427</c:v>
                </c:pt>
                <c:pt idx="202">
                  <c:v>301.155496588159</c:v>
                </c:pt>
                <c:pt idx="203">
                  <c:v>227.18391168901999</c:v>
                </c:pt>
                <c:pt idx="204">
                  <c:v>340.86113056641699</c:v>
                </c:pt>
                <c:pt idx="205">
                  <c:v>152.16180155466699</c:v>
                </c:pt>
                <c:pt idx="206">
                  <c:v>361.22825577264501</c:v>
                </c:pt>
                <c:pt idx="207">
                  <c:v>203.685898662109</c:v>
                </c:pt>
                <c:pt idx="208">
                  <c:v>319.56760972790403</c:v>
                </c:pt>
                <c:pt idx="209">
                  <c:v>345.727622129304</c:v>
                </c:pt>
                <c:pt idx="210">
                  <c:v>313.18932321792801</c:v>
                </c:pt>
                <c:pt idx="211">
                  <c:v>370.48182615098602</c:v>
                </c:pt>
                <c:pt idx="212">
                  <c:v>322.16993176721599</c:v>
                </c:pt>
                <c:pt idx="213">
                  <c:v>253.85321140646101</c:v>
                </c:pt>
                <c:pt idx="214">
                  <c:v>314.237491152774</c:v>
                </c:pt>
                <c:pt idx="215">
                  <c:v>334.12741120151099</c:v>
                </c:pt>
                <c:pt idx="216">
                  <c:v>159.721162055988</c:v>
                </c:pt>
                <c:pt idx="217">
                  <c:v>176.56808404931601</c:v>
                </c:pt>
                <c:pt idx="218">
                  <c:v>190.64287646457399</c:v>
                </c:pt>
                <c:pt idx="219">
                  <c:v>356.88135307463301</c:v>
                </c:pt>
                <c:pt idx="220">
                  <c:v>154.77733604104699</c:v>
                </c:pt>
                <c:pt idx="221">
                  <c:v>316.96812955273901</c:v>
                </c:pt>
                <c:pt idx="222">
                  <c:v>341.11336253578901</c:v>
                </c:pt>
                <c:pt idx="223">
                  <c:v>205.33804112049799</c:v>
                </c:pt>
                <c:pt idx="224">
                  <c:v>266.73628072531301</c:v>
                </c:pt>
                <c:pt idx="225">
                  <c:v>415.56806060994899</c:v>
                </c:pt>
                <c:pt idx="226">
                  <c:v>190.53612486524301</c:v>
                </c:pt>
                <c:pt idx="227">
                  <c:v>158.889106972653</c:v>
                </c:pt>
                <c:pt idx="228">
                  <c:v>396.47903733646802</c:v>
                </c:pt>
                <c:pt idx="229">
                  <c:v>241.11281719989199</c:v>
                </c:pt>
                <c:pt idx="230">
                  <c:v>407.52474222720502</c:v>
                </c:pt>
                <c:pt idx="231">
                  <c:v>211.95763584180901</c:v>
                </c:pt>
                <c:pt idx="232">
                  <c:v>280.61202616457803</c:v>
                </c:pt>
                <c:pt idx="233">
                  <c:v>275.79252502216798</c:v>
                </c:pt>
                <c:pt idx="234">
                  <c:v>244.47969973734499</c:v>
                </c:pt>
                <c:pt idx="235">
                  <c:v>194.630549080495</c:v>
                </c:pt>
                <c:pt idx="236">
                  <c:v>302.30887740475299</c:v>
                </c:pt>
                <c:pt idx="237">
                  <c:v>165.18222791701601</c:v>
                </c:pt>
                <c:pt idx="238">
                  <c:v>323.44540155133899</c:v>
                </c:pt>
                <c:pt idx="239">
                  <c:v>213.832483305919</c:v>
                </c:pt>
                <c:pt idx="240">
                  <c:v>333.61578462683502</c:v>
                </c:pt>
                <c:pt idx="241">
                  <c:v>265.46257418928502</c:v>
                </c:pt>
                <c:pt idx="242">
                  <c:v>284.87166993499301</c:v>
                </c:pt>
                <c:pt idx="243">
                  <c:v>515.99665718579399</c:v>
                </c:pt>
                <c:pt idx="244">
                  <c:v>292.63858319768502</c:v>
                </c:pt>
                <c:pt idx="245">
                  <c:v>405.60270587119601</c:v>
                </c:pt>
                <c:pt idx="246">
                  <c:v>327.40371858655601</c:v>
                </c:pt>
                <c:pt idx="247">
                  <c:v>97.725754916817195</c:v>
                </c:pt>
                <c:pt idx="248">
                  <c:v>397.11352456767901</c:v>
                </c:pt>
                <c:pt idx="249">
                  <c:v>227.80482901720299</c:v>
                </c:pt>
                <c:pt idx="250">
                  <c:v>359.48837968469599</c:v>
                </c:pt>
                <c:pt idx="251">
                  <c:v>296.676479271868</c:v>
                </c:pt>
                <c:pt idx="252">
                  <c:v>261.99286778891098</c:v>
                </c:pt>
                <c:pt idx="253">
                  <c:v>380.308868235055</c:v>
                </c:pt>
                <c:pt idx="254">
                  <c:v>428.029847140877</c:v>
                </c:pt>
                <c:pt idx="255">
                  <c:v>133.93438944158001</c:v>
                </c:pt>
                <c:pt idx="256">
                  <c:v>256.85699305277598</c:v>
                </c:pt>
                <c:pt idx="257">
                  <c:v>405.47702428709101</c:v>
                </c:pt>
                <c:pt idx="258">
                  <c:v>362.80877670847502</c:v>
                </c:pt>
                <c:pt idx="259">
                  <c:v>228.659590262183</c:v>
                </c:pt>
                <c:pt idx="260">
                  <c:v>298.66217619950402</c:v>
                </c:pt>
                <c:pt idx="261">
                  <c:v>185.70511398335799</c:v>
                </c:pt>
                <c:pt idx="262">
                  <c:v>339.12445266302302</c:v>
                </c:pt>
                <c:pt idx="263">
                  <c:v>290.40521659031401</c:v>
                </c:pt>
                <c:pt idx="264">
                  <c:v>176.58662081386601</c:v>
                </c:pt>
                <c:pt idx="265">
                  <c:v>383.41224353743797</c:v>
                </c:pt>
                <c:pt idx="266">
                  <c:v>240.25512591073101</c:v>
                </c:pt>
                <c:pt idx="267">
                  <c:v>269.95402215905801</c:v>
                </c:pt>
                <c:pt idx="268">
                  <c:v>196.51243012914401</c:v>
                </c:pt>
                <c:pt idx="269">
                  <c:v>343.09383865543998</c:v>
                </c:pt>
                <c:pt idx="270">
                  <c:v>284.32072925388798</c:v>
                </c:pt>
                <c:pt idx="271">
                  <c:v>388.14536619667098</c:v>
                </c:pt>
                <c:pt idx="272">
                  <c:v>176.24967792809801</c:v>
                </c:pt>
                <c:pt idx="273">
                  <c:v>229.87192896221401</c:v>
                </c:pt>
                <c:pt idx="274">
                  <c:v>430.22057716929999</c:v>
                </c:pt>
                <c:pt idx="275">
                  <c:v>355.38330207633601</c:v>
                </c:pt>
                <c:pt idx="276">
                  <c:v>168.84083433387499</c:v>
                </c:pt>
                <c:pt idx="277">
                  <c:v>380.97203400492901</c:v>
                </c:pt>
                <c:pt idx="278">
                  <c:v>226.37060749824599</c:v>
                </c:pt>
                <c:pt idx="279">
                  <c:v>318.624253672701</c:v>
                </c:pt>
                <c:pt idx="280">
                  <c:v>282.55695316914</c:v>
                </c:pt>
                <c:pt idx="281">
                  <c:v>389.77145159183198</c:v>
                </c:pt>
                <c:pt idx="282">
                  <c:v>381.234260850586</c:v>
                </c:pt>
                <c:pt idx="283">
                  <c:v>339.474125927854</c:v>
                </c:pt>
                <c:pt idx="284">
                  <c:v>275.54382533495198</c:v>
                </c:pt>
                <c:pt idx="285">
                  <c:v>268.332910467418</c:v>
                </c:pt>
                <c:pt idx="286">
                  <c:v>280.69819695062</c:v>
                </c:pt>
                <c:pt idx="287">
                  <c:v>370.14302653573998</c:v>
                </c:pt>
                <c:pt idx="288">
                  <c:v>374.23084798109602</c:v>
                </c:pt>
                <c:pt idx="289">
                  <c:v>330.29445598369801</c:v>
                </c:pt>
                <c:pt idx="290">
                  <c:v>325.38016547576098</c:v>
                </c:pt>
                <c:pt idx="291">
                  <c:v>277.68909011923603</c:v>
                </c:pt>
              </c:numCache>
            </c:numRef>
          </c:xVal>
          <c:yVal>
            <c:numRef>
              <c:f>Sheet1!$H$2:$H$293</c:f>
              <c:numCache>
                <c:formatCode>0.00</c:formatCode>
                <c:ptCount val="292"/>
                <c:pt idx="0">
                  <c:v>56.972077100385398</c:v>
                </c:pt>
                <c:pt idx="1">
                  <c:v>50.274495062583703</c:v>
                </c:pt>
                <c:pt idx="2">
                  <c:v>51.893962270069103</c:v>
                </c:pt>
                <c:pt idx="3">
                  <c:v>71.713090752602795</c:v>
                </c:pt>
                <c:pt idx="4">
                  <c:v>50.053466729707203</c:v>
                </c:pt>
                <c:pt idx="5">
                  <c:v>57.995876173584897</c:v>
                </c:pt>
                <c:pt idx="6">
                  <c:v>61.7723183678198</c:v>
                </c:pt>
                <c:pt idx="7">
                  <c:v>61.180472178970199</c:v>
                </c:pt>
                <c:pt idx="8">
                  <c:v>44.037192089527601</c:v>
                </c:pt>
                <c:pt idx="9">
                  <c:v>50.879199692966601</c:v>
                </c:pt>
                <c:pt idx="10">
                  <c:v>50.302686169060799</c:v>
                </c:pt>
                <c:pt idx="11">
                  <c:v>54.101407795382499</c:v>
                </c:pt>
                <c:pt idx="12">
                  <c:v>56.347289590662399</c:v>
                </c:pt>
                <c:pt idx="13">
                  <c:v>56.779356748393703</c:v>
                </c:pt>
                <c:pt idx="14">
                  <c:v>47.872790316589096</c:v>
                </c:pt>
                <c:pt idx="15">
                  <c:v>46.936973608139702</c:v>
                </c:pt>
                <c:pt idx="16">
                  <c:v>42.991609451018903</c:v>
                </c:pt>
                <c:pt idx="17">
                  <c:v>53.781982524356799</c:v>
                </c:pt>
                <c:pt idx="18">
                  <c:v>56.869674615574503</c:v>
                </c:pt>
                <c:pt idx="19">
                  <c:v>53.646277321138598</c:v>
                </c:pt>
                <c:pt idx="20">
                  <c:v>48.098484237270803</c:v>
                </c:pt>
                <c:pt idx="21">
                  <c:v>40.027290026322</c:v>
                </c:pt>
                <c:pt idx="22">
                  <c:v>54.007265579851101</c:v>
                </c:pt>
                <c:pt idx="23">
                  <c:v>44.144985457485802</c:v>
                </c:pt>
                <c:pt idx="24">
                  <c:v>53.762647668883702</c:v>
                </c:pt>
                <c:pt idx="25">
                  <c:v>9.0131931736008006</c:v>
                </c:pt>
                <c:pt idx="26">
                  <c:v>52.398549481149097</c:v>
                </c:pt>
                <c:pt idx="27">
                  <c:v>57.434719609964901</c:v>
                </c:pt>
                <c:pt idx="28">
                  <c:v>47.967287803390398</c:v>
                </c:pt>
                <c:pt idx="29">
                  <c:v>36.310119942835698</c:v>
                </c:pt>
                <c:pt idx="30">
                  <c:v>55.676408319631101</c:v>
                </c:pt>
                <c:pt idx="31">
                  <c:v>48.581742345490099</c:v>
                </c:pt>
                <c:pt idx="32">
                  <c:v>62.594002300875502</c:v>
                </c:pt>
                <c:pt idx="33">
                  <c:v>59.854779654009597</c:v>
                </c:pt>
                <c:pt idx="34">
                  <c:v>54.451483677633703</c:v>
                </c:pt>
                <c:pt idx="35">
                  <c:v>38.007132229040202</c:v>
                </c:pt>
                <c:pt idx="36">
                  <c:v>62.626498851359003</c:v>
                </c:pt>
                <c:pt idx="37">
                  <c:v>57.662376091029998</c:v>
                </c:pt>
                <c:pt idx="38">
                  <c:v>53.879139369179299</c:v>
                </c:pt>
                <c:pt idx="39">
                  <c:v>55.809472138745598</c:v>
                </c:pt>
                <c:pt idx="40">
                  <c:v>58.794624656558298</c:v>
                </c:pt>
                <c:pt idx="41">
                  <c:v>60.375381862704003</c:v>
                </c:pt>
                <c:pt idx="42">
                  <c:v>41.696600406779197</c:v>
                </c:pt>
                <c:pt idx="43">
                  <c:v>26.2433277633552</c:v>
                </c:pt>
                <c:pt idx="44">
                  <c:v>58.641955807548101</c:v>
                </c:pt>
                <c:pt idx="45">
                  <c:v>36.4543313130388</c:v>
                </c:pt>
                <c:pt idx="46">
                  <c:v>21.785192929797201</c:v>
                </c:pt>
                <c:pt idx="47">
                  <c:v>64.993278644278902</c:v>
                </c:pt>
                <c:pt idx="48">
                  <c:v>61.614071168195402</c:v>
                </c:pt>
                <c:pt idx="49">
                  <c:v>49.677969121519403</c:v>
                </c:pt>
                <c:pt idx="50">
                  <c:v>47.505857965697899</c:v>
                </c:pt>
                <c:pt idx="51">
                  <c:v>38.737598262460899</c:v>
                </c:pt>
                <c:pt idx="52">
                  <c:v>70.781531285897103</c:v>
                </c:pt>
                <c:pt idx="53">
                  <c:v>62.907709950822202</c:v>
                </c:pt>
                <c:pt idx="54">
                  <c:v>61.335014178162801</c:v>
                </c:pt>
                <c:pt idx="55">
                  <c:v>56.919721777076802</c:v>
                </c:pt>
                <c:pt idx="56">
                  <c:v>52.448920107840401</c:v>
                </c:pt>
                <c:pt idx="57">
                  <c:v>49.935286212189098</c:v>
                </c:pt>
                <c:pt idx="58">
                  <c:v>52.909163062357997</c:v>
                </c:pt>
                <c:pt idx="59">
                  <c:v>28.537327549817299</c:v>
                </c:pt>
                <c:pt idx="60">
                  <c:v>72.2613551862256</c:v>
                </c:pt>
                <c:pt idx="61">
                  <c:v>55.991890964098801</c:v>
                </c:pt>
                <c:pt idx="62">
                  <c:v>56.114212597211299</c:v>
                </c:pt>
                <c:pt idx="63">
                  <c:v>27.575735701159999</c:v>
                </c:pt>
                <c:pt idx="64">
                  <c:v>55.569873870355202</c:v>
                </c:pt>
                <c:pt idx="65">
                  <c:v>53.895857340886302</c:v>
                </c:pt>
                <c:pt idx="66">
                  <c:v>49.875933443380902</c:v>
                </c:pt>
                <c:pt idx="67">
                  <c:v>46.410331813190403</c:v>
                </c:pt>
                <c:pt idx="68">
                  <c:v>38.706625116673301</c:v>
                </c:pt>
                <c:pt idx="69">
                  <c:v>49.195967025716698</c:v>
                </c:pt>
                <c:pt idx="70">
                  <c:v>26.5962564349357</c:v>
                </c:pt>
                <c:pt idx="71">
                  <c:v>29.163189362389101</c:v>
                </c:pt>
                <c:pt idx="72">
                  <c:v>49.660122124788501</c:v>
                </c:pt>
                <c:pt idx="73">
                  <c:v>42.178618792316598</c:v>
                </c:pt>
                <c:pt idx="74">
                  <c:v>82.350829867282002</c:v>
                </c:pt>
                <c:pt idx="75">
                  <c:v>60.671912046148798</c:v>
                </c:pt>
                <c:pt idx="76">
                  <c:v>60.504169400802198</c:v>
                </c:pt>
                <c:pt idx="77">
                  <c:v>48.896858626788699</c:v>
                </c:pt>
                <c:pt idx="78">
                  <c:v>63.628476899675597</c:v>
                </c:pt>
                <c:pt idx="79">
                  <c:v>34.696388549660398</c:v>
                </c:pt>
                <c:pt idx="80">
                  <c:v>42.325771435721897</c:v>
                </c:pt>
                <c:pt idx="81">
                  <c:v>77.710995594919694</c:v>
                </c:pt>
                <c:pt idx="82">
                  <c:v>41.556897161641103</c:v>
                </c:pt>
                <c:pt idx="83">
                  <c:v>59.164431243312002</c:v>
                </c:pt>
                <c:pt idx="84">
                  <c:v>56.008452316598699</c:v>
                </c:pt>
                <c:pt idx="85">
                  <c:v>44.163139359274098</c:v>
                </c:pt>
                <c:pt idx="86">
                  <c:v>41.953259237189698</c:v>
                </c:pt>
                <c:pt idx="87">
                  <c:v>40.528014882408897</c:v>
                </c:pt>
                <c:pt idx="88">
                  <c:v>35.529732105963497</c:v>
                </c:pt>
                <c:pt idx="89">
                  <c:v>42.404185261799498</c:v>
                </c:pt>
                <c:pt idx="90">
                  <c:v>52.576625844025799</c:v>
                </c:pt>
                <c:pt idx="91">
                  <c:v>51.104169695579998</c:v>
                </c:pt>
                <c:pt idx="92">
                  <c:v>55.760705799723297</c:v>
                </c:pt>
                <c:pt idx="93">
                  <c:v>54.631439628722099</c:v>
                </c:pt>
                <c:pt idx="94">
                  <c:v>58.180254171333502</c:v>
                </c:pt>
                <c:pt idx="95">
                  <c:v>45.070798536212799</c:v>
                </c:pt>
                <c:pt idx="96">
                  <c:v>47.922707330841099</c:v>
                </c:pt>
                <c:pt idx="97">
                  <c:v>54.428116453079099</c:v>
                </c:pt>
                <c:pt idx="98">
                  <c:v>58.625309188636201</c:v>
                </c:pt>
                <c:pt idx="99">
                  <c:v>59.299487585082801</c:v>
                </c:pt>
                <c:pt idx="100">
                  <c:v>60.443382341604</c:v>
                </c:pt>
                <c:pt idx="101">
                  <c:v>47.891579937556301</c:v>
                </c:pt>
                <c:pt idx="102">
                  <c:v>64.870201651673696</c:v>
                </c:pt>
                <c:pt idx="103">
                  <c:v>53.223518046519999</c:v>
                </c:pt>
                <c:pt idx="104">
                  <c:v>58.926591542835297</c:v>
                </c:pt>
                <c:pt idx="105">
                  <c:v>48.721980122787798</c:v>
                </c:pt>
                <c:pt idx="106">
                  <c:v>59.578476197647198</c:v>
                </c:pt>
                <c:pt idx="107">
                  <c:v>58.823210911687397</c:v>
                </c:pt>
                <c:pt idx="108">
                  <c:v>56.118116021475402</c:v>
                </c:pt>
                <c:pt idx="109">
                  <c:v>61.316908802032501</c:v>
                </c:pt>
                <c:pt idx="110">
                  <c:v>58.807713792167696</c:v>
                </c:pt>
                <c:pt idx="111">
                  <c:v>49.9405798905712</c:v>
                </c:pt>
                <c:pt idx="112">
                  <c:v>48.235066642264101</c:v>
                </c:pt>
                <c:pt idx="113">
                  <c:v>61.0272653661861</c:v>
                </c:pt>
                <c:pt idx="114">
                  <c:v>45.281684756388103</c:v>
                </c:pt>
                <c:pt idx="115">
                  <c:v>67.459578250342005</c:v>
                </c:pt>
                <c:pt idx="116">
                  <c:v>59.086077576673397</c:v>
                </c:pt>
                <c:pt idx="117">
                  <c:v>43.254642058866999</c:v>
                </c:pt>
                <c:pt idx="118">
                  <c:v>53.600342353512502</c:v>
                </c:pt>
                <c:pt idx="119">
                  <c:v>43.791365948270297</c:v>
                </c:pt>
                <c:pt idx="120">
                  <c:v>58.663991372634399</c:v>
                </c:pt>
                <c:pt idx="121">
                  <c:v>46.274977903686903</c:v>
                </c:pt>
                <c:pt idx="122">
                  <c:v>48.8320315144001</c:v>
                </c:pt>
                <c:pt idx="123">
                  <c:v>70.647393984881703</c:v>
                </c:pt>
                <c:pt idx="124">
                  <c:v>58.8909029726642</c:v>
                </c:pt>
                <c:pt idx="125">
                  <c:v>51.267353876218799</c:v>
                </c:pt>
                <c:pt idx="126">
                  <c:v>63.742125779656497</c:v>
                </c:pt>
                <c:pt idx="127">
                  <c:v>67.928542553243503</c:v>
                </c:pt>
                <c:pt idx="128">
                  <c:v>71.563198014722801</c:v>
                </c:pt>
                <c:pt idx="129">
                  <c:v>59.757550948477999</c:v>
                </c:pt>
                <c:pt idx="130">
                  <c:v>64.022905187432698</c:v>
                </c:pt>
                <c:pt idx="131">
                  <c:v>60.165871537049298</c:v>
                </c:pt>
                <c:pt idx="132">
                  <c:v>51.3146924951781</c:v>
                </c:pt>
                <c:pt idx="133">
                  <c:v>48.590047888970197</c:v>
                </c:pt>
                <c:pt idx="134">
                  <c:v>58.565460347918403</c:v>
                </c:pt>
                <c:pt idx="135">
                  <c:v>64.668024867013898</c:v>
                </c:pt>
                <c:pt idx="136">
                  <c:v>50.876788832705003</c:v>
                </c:pt>
                <c:pt idx="137">
                  <c:v>63.8255387105796</c:v>
                </c:pt>
                <c:pt idx="138">
                  <c:v>43.244778023986598</c:v>
                </c:pt>
                <c:pt idx="139">
                  <c:v>53.201433081363099</c:v>
                </c:pt>
                <c:pt idx="140">
                  <c:v>56.090280126204803</c:v>
                </c:pt>
                <c:pt idx="141">
                  <c:v>49.327301478742903</c:v>
                </c:pt>
                <c:pt idx="142">
                  <c:v>45.867252173397702</c:v>
                </c:pt>
                <c:pt idx="143">
                  <c:v>60.428261133375401</c:v>
                </c:pt>
                <c:pt idx="144">
                  <c:v>67.807811681852698</c:v>
                </c:pt>
                <c:pt idx="145">
                  <c:v>60.341604093229101</c:v>
                </c:pt>
                <c:pt idx="146">
                  <c:v>59.637683669478598</c:v>
                </c:pt>
                <c:pt idx="147">
                  <c:v>61.627867827255599</c:v>
                </c:pt>
                <c:pt idx="148">
                  <c:v>59.646336852831503</c:v>
                </c:pt>
                <c:pt idx="149">
                  <c:v>54.526691443738599</c:v>
                </c:pt>
                <c:pt idx="150">
                  <c:v>75.192574075260097</c:v>
                </c:pt>
                <c:pt idx="151">
                  <c:v>56.211653337613498</c:v>
                </c:pt>
                <c:pt idx="152">
                  <c:v>70.755365941206904</c:v>
                </c:pt>
                <c:pt idx="153">
                  <c:v>38.263261949967102</c:v>
                </c:pt>
                <c:pt idx="154">
                  <c:v>48.285999914370201</c:v>
                </c:pt>
                <c:pt idx="155">
                  <c:v>52.756648017187402</c:v>
                </c:pt>
                <c:pt idx="156">
                  <c:v>42.940091936150701</c:v>
                </c:pt>
                <c:pt idx="157">
                  <c:v>48.846795373706797</c:v>
                </c:pt>
                <c:pt idx="158">
                  <c:v>68.432772068902096</c:v>
                </c:pt>
                <c:pt idx="159">
                  <c:v>56.331199751485201</c:v>
                </c:pt>
                <c:pt idx="160">
                  <c:v>71.093857241296703</c:v>
                </c:pt>
                <c:pt idx="161">
                  <c:v>47.748863438948298</c:v>
                </c:pt>
                <c:pt idx="162">
                  <c:v>63.590925967021498</c:v>
                </c:pt>
                <c:pt idx="163">
                  <c:v>76.906317291512295</c:v>
                </c:pt>
                <c:pt idx="164">
                  <c:v>68.764591385139994</c:v>
                </c:pt>
                <c:pt idx="165">
                  <c:v>62.580621989055103</c:v>
                </c:pt>
                <c:pt idx="166">
                  <c:v>52.228071213885002</c:v>
                </c:pt>
                <c:pt idx="167">
                  <c:v>37.058168369218301</c:v>
                </c:pt>
                <c:pt idx="168">
                  <c:v>67.903632284165994</c:v>
                </c:pt>
                <c:pt idx="169">
                  <c:v>52.162654764120902</c:v>
                </c:pt>
                <c:pt idx="170">
                  <c:v>52.260963102452898</c:v>
                </c:pt>
                <c:pt idx="171">
                  <c:v>51.999256572090097</c:v>
                </c:pt>
                <c:pt idx="172">
                  <c:v>51.488832163144302</c:v>
                </c:pt>
                <c:pt idx="173">
                  <c:v>49.009171785412299</c:v>
                </c:pt>
                <c:pt idx="174">
                  <c:v>67.635396416586602</c:v>
                </c:pt>
                <c:pt idx="175">
                  <c:v>52.979734934627999</c:v>
                </c:pt>
                <c:pt idx="176">
                  <c:v>43.989570135946799</c:v>
                </c:pt>
                <c:pt idx="177">
                  <c:v>70.651179203688301</c:v>
                </c:pt>
                <c:pt idx="178">
                  <c:v>53.847698009892</c:v>
                </c:pt>
                <c:pt idx="179">
                  <c:v>64.782492550404001</c:v>
                </c:pt>
                <c:pt idx="180">
                  <c:v>51.687388166452699</c:v>
                </c:pt>
                <c:pt idx="181">
                  <c:v>45.101457423431498</c:v>
                </c:pt>
                <c:pt idx="182">
                  <c:v>66.063912205334603</c:v>
                </c:pt>
                <c:pt idx="183">
                  <c:v>27.985881561136299</c:v>
                </c:pt>
                <c:pt idx="184">
                  <c:v>54.2592113810665</c:v>
                </c:pt>
                <c:pt idx="185">
                  <c:v>49.840392025159403</c:v>
                </c:pt>
                <c:pt idx="186">
                  <c:v>54.637563790980899</c:v>
                </c:pt>
                <c:pt idx="187">
                  <c:v>67.109259900192598</c:v>
                </c:pt>
                <c:pt idx="188">
                  <c:v>60.1512922151976</c:v>
                </c:pt>
                <c:pt idx="189">
                  <c:v>55.223437037876998</c:v>
                </c:pt>
                <c:pt idx="190">
                  <c:v>56.6625362807412</c:v>
                </c:pt>
                <c:pt idx="191">
                  <c:v>50.815543978080903</c:v>
                </c:pt>
                <c:pt idx="192">
                  <c:v>75.606846539182101</c:v>
                </c:pt>
                <c:pt idx="193">
                  <c:v>46.9869152627167</c:v>
                </c:pt>
                <c:pt idx="194">
                  <c:v>47.520139698214102</c:v>
                </c:pt>
                <c:pt idx="195">
                  <c:v>46.315987902472699</c:v>
                </c:pt>
                <c:pt idx="196">
                  <c:v>65.286724821380005</c:v>
                </c:pt>
                <c:pt idx="197">
                  <c:v>60.324440640246202</c:v>
                </c:pt>
                <c:pt idx="198">
                  <c:v>49.851426262169099</c:v>
                </c:pt>
                <c:pt idx="199">
                  <c:v>70.412289309144398</c:v>
                </c:pt>
                <c:pt idx="200">
                  <c:v>31.308167787830399</c:v>
                </c:pt>
                <c:pt idx="201">
                  <c:v>59.223889368471497</c:v>
                </c:pt>
                <c:pt idx="202">
                  <c:v>59.001077672024998</c:v>
                </c:pt>
                <c:pt idx="203">
                  <c:v>45.433091166193201</c:v>
                </c:pt>
                <c:pt idx="204">
                  <c:v>52.952952822794799</c:v>
                </c:pt>
                <c:pt idx="205">
                  <c:v>31.934683259602</c:v>
                </c:pt>
                <c:pt idx="206">
                  <c:v>66.971362683960507</c:v>
                </c:pt>
                <c:pt idx="207">
                  <c:v>36.096375649022903</c:v>
                </c:pt>
                <c:pt idx="208">
                  <c:v>59.6412817803471</c:v>
                </c:pt>
                <c:pt idx="209">
                  <c:v>54.790189522879302</c:v>
                </c:pt>
                <c:pt idx="210">
                  <c:v>60.826313233139203</c:v>
                </c:pt>
                <c:pt idx="211">
                  <c:v>51.9356854990369</c:v>
                </c:pt>
                <c:pt idx="212">
                  <c:v>59.065201713704496</c:v>
                </c:pt>
                <c:pt idx="213">
                  <c:v>42.242472159188097</c:v>
                </c:pt>
                <c:pt idx="214">
                  <c:v>54.472301503230803</c:v>
                </c:pt>
                <c:pt idx="215">
                  <c:v>60.259387955799703</c:v>
                </c:pt>
                <c:pt idx="216">
                  <c:v>30.868899475521101</c:v>
                </c:pt>
                <c:pt idx="217">
                  <c:v>36.894735270520798</c:v>
                </c:pt>
                <c:pt idx="218">
                  <c:v>45.606245925547803</c:v>
                </c:pt>
                <c:pt idx="219">
                  <c:v>55.843714523368703</c:v>
                </c:pt>
                <c:pt idx="220">
                  <c:v>31.155211776591798</c:v>
                </c:pt>
                <c:pt idx="221">
                  <c:v>50.748057305221799</c:v>
                </c:pt>
                <c:pt idx="222">
                  <c:v>58.0290247415492</c:v>
                </c:pt>
                <c:pt idx="223">
                  <c:v>41.000284984001802</c:v>
                </c:pt>
                <c:pt idx="224">
                  <c:v>54.068462339065903</c:v>
                </c:pt>
                <c:pt idx="225">
                  <c:v>69.137858767567394</c:v>
                </c:pt>
                <c:pt idx="226">
                  <c:v>42.990008479852499</c:v>
                </c:pt>
                <c:pt idx="227">
                  <c:v>33.499299100843501</c:v>
                </c:pt>
                <c:pt idx="228">
                  <c:v>59.083023540164099</c:v>
                </c:pt>
                <c:pt idx="229">
                  <c:v>54.401734980352202</c:v>
                </c:pt>
                <c:pt idx="230">
                  <c:v>70.983496962599801</c:v>
                </c:pt>
                <c:pt idx="231">
                  <c:v>42.280161391491198</c:v>
                </c:pt>
                <c:pt idx="232">
                  <c:v>56.883508068888702</c:v>
                </c:pt>
                <c:pt idx="233">
                  <c:v>57.0240135484378</c:v>
                </c:pt>
                <c:pt idx="234">
                  <c:v>57.955703235564201</c:v>
                </c:pt>
                <c:pt idx="235">
                  <c:v>43.5314750530246</c:v>
                </c:pt>
                <c:pt idx="236">
                  <c:v>50.664581374276104</c:v>
                </c:pt>
                <c:pt idx="237">
                  <c:v>36.603483778226597</c:v>
                </c:pt>
                <c:pt idx="238">
                  <c:v>54.4311322425566</c:v>
                </c:pt>
                <c:pt idx="239">
                  <c:v>40.939998979766997</c:v>
                </c:pt>
                <c:pt idx="240">
                  <c:v>49.660595598154899</c:v>
                </c:pt>
                <c:pt idx="241">
                  <c:v>49.263777346776102</c:v>
                </c:pt>
                <c:pt idx="242">
                  <c:v>51.011070271085302</c:v>
                </c:pt>
                <c:pt idx="243">
                  <c:v>66.610148000527403</c:v>
                </c:pt>
                <c:pt idx="244">
                  <c:v>47.972404582197399</c:v>
                </c:pt>
                <c:pt idx="245">
                  <c:v>61.1601612302223</c:v>
                </c:pt>
                <c:pt idx="246">
                  <c:v>60.026672189200603</c:v>
                </c:pt>
                <c:pt idx="247">
                  <c:v>21.7647749498853</c:v>
                </c:pt>
                <c:pt idx="248">
                  <c:v>58.572987816476598</c:v>
                </c:pt>
                <c:pt idx="249">
                  <c:v>52.5323875572468</c:v>
                </c:pt>
                <c:pt idx="250">
                  <c:v>52.998580150862303</c:v>
                </c:pt>
                <c:pt idx="251">
                  <c:v>54.4942167787001</c:v>
                </c:pt>
                <c:pt idx="252">
                  <c:v>49.855690965553698</c:v>
                </c:pt>
                <c:pt idx="253">
                  <c:v>58.956414858443502</c:v>
                </c:pt>
                <c:pt idx="254">
                  <c:v>76.731228560061794</c:v>
                </c:pt>
                <c:pt idx="255">
                  <c:v>27.240965868897799</c:v>
                </c:pt>
                <c:pt idx="256">
                  <c:v>50.909235898459002</c:v>
                </c:pt>
                <c:pt idx="257">
                  <c:v>68.736162365080204</c:v>
                </c:pt>
                <c:pt idx="258">
                  <c:v>73.733485074619594</c:v>
                </c:pt>
                <c:pt idx="259">
                  <c:v>46.551512182548699</c:v>
                </c:pt>
                <c:pt idx="260">
                  <c:v>53.482651487735303</c:v>
                </c:pt>
                <c:pt idx="261">
                  <c:v>39.100818098411203</c:v>
                </c:pt>
                <c:pt idx="262">
                  <c:v>51.214858763842997</c:v>
                </c:pt>
                <c:pt idx="263">
                  <c:v>46.053050275939199</c:v>
                </c:pt>
                <c:pt idx="264">
                  <c:v>35.825806557620197</c:v>
                </c:pt>
                <c:pt idx="265">
                  <c:v>62.783162679559901</c:v>
                </c:pt>
                <c:pt idx="266">
                  <c:v>46.514628516579599</c:v>
                </c:pt>
                <c:pt idx="267">
                  <c:v>53.995020481960999</c:v>
                </c:pt>
                <c:pt idx="268">
                  <c:v>43.071453824174398</c:v>
                </c:pt>
                <c:pt idx="269">
                  <c:v>49.074829233558397</c:v>
                </c:pt>
                <c:pt idx="270">
                  <c:v>49.765163778967398</c:v>
                </c:pt>
                <c:pt idx="271">
                  <c:v>61.623355253410502</c:v>
                </c:pt>
                <c:pt idx="272">
                  <c:v>32.918851551533301</c:v>
                </c:pt>
                <c:pt idx="273">
                  <c:v>43.388638800723101</c:v>
                </c:pt>
                <c:pt idx="274">
                  <c:v>60.609318615525503</c:v>
                </c:pt>
                <c:pt idx="275">
                  <c:v>63.064100310151197</c:v>
                </c:pt>
                <c:pt idx="276">
                  <c:v>32.4962147027219</c:v>
                </c:pt>
                <c:pt idx="277">
                  <c:v>58.957866142950202</c:v>
                </c:pt>
                <c:pt idx="278">
                  <c:v>41.316779690310597</c:v>
                </c:pt>
                <c:pt idx="279">
                  <c:v>52.326392150361897</c:v>
                </c:pt>
                <c:pt idx="280">
                  <c:v>62.787637125143704</c:v>
                </c:pt>
                <c:pt idx="281">
                  <c:v>64.568523738090605</c:v>
                </c:pt>
                <c:pt idx="282">
                  <c:v>58.071389846438898</c:v>
                </c:pt>
                <c:pt idx="283">
                  <c:v>51.754538072477203</c:v>
                </c:pt>
                <c:pt idx="284">
                  <c:v>55.174748251138801</c:v>
                </c:pt>
                <c:pt idx="285">
                  <c:v>53.095891989383297</c:v>
                </c:pt>
                <c:pt idx="286">
                  <c:v>44.844932333790403</c:v>
                </c:pt>
                <c:pt idx="287">
                  <c:v>69.430604336269397</c:v>
                </c:pt>
                <c:pt idx="288">
                  <c:v>58.472214987243703</c:v>
                </c:pt>
                <c:pt idx="289">
                  <c:v>59.932507698279501</c:v>
                </c:pt>
                <c:pt idx="290">
                  <c:v>59.966679205323103</c:v>
                </c:pt>
                <c:pt idx="291">
                  <c:v>49.6493396048718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4EA-4CB1-8BBB-6694B62914E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3350784"/>
        <c:axId val="33352320"/>
      </c:scatterChart>
      <c:valAx>
        <c:axId val="3335078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52320"/>
        <c:crosses val="autoZero"/>
        <c:crossBetween val="midCat"/>
      </c:valAx>
      <c:valAx>
        <c:axId val="3335232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5078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sz="1862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sz="2000" b="1" i="0" u="none" strike="noStrike" kern="1200" spc="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TS-GY</a:t>
            </a:r>
          </a:p>
        </c:rich>
      </c:tx>
      <c:layout>
        <c:manualLayout>
          <c:xMode val="edge"/>
          <c:yMode val="edge"/>
          <c:x val="0.42154435695538067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sz="1862" b="0" i="0" u="none" strike="noStrike" kern="1200" spc="0" baseline="0">
              <a:solidFill>
                <a:prstClr val="black">
                  <a:lumMod val="65000"/>
                  <a:lumOff val="35000"/>
                </a:prst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Sheet1!$H$1</c:f>
              <c:strCache>
                <c:ptCount val="1"/>
                <c:pt idx="0">
                  <c:v>GY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0.14617602799650042"/>
                  <c:y val="-0.2280426752211529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 algn="ctr" rtl="0">
                      <a:defRPr sz="1197" b="0" i="0" u="none" strike="noStrike" kern="1200" baseline="0">
                        <a:solidFill>
                          <a:prstClr val="black">
                            <a:lumMod val="65000"/>
                            <a:lumOff val="35000"/>
                          </a:prst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rPr>
                      <a:t>y = 0.0974x + 15.201</a:t>
                    </a:r>
                    <a:b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rPr>
                    </a:br>
                    <a: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rPr>
                      <a:t>R² = 0.7721</a:t>
                    </a: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 algn="ctr" rtl="0">
                    <a:defRPr sz="1197" b="0" i="0" u="none" strike="noStrike" kern="1200" baseline="0">
                      <a:solidFill>
                        <a:prstClr val="black">
                          <a:lumMod val="65000"/>
                          <a:lumOff val="35000"/>
                        </a:prst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Sheet1!$D$2:$D$293</c:f>
              <c:numCache>
                <c:formatCode>0.00</c:formatCode>
                <c:ptCount val="292"/>
                <c:pt idx="0">
                  <c:v>437.63811766235199</c:v>
                </c:pt>
                <c:pt idx="1">
                  <c:v>381.35673326581502</c:v>
                </c:pt>
                <c:pt idx="2">
                  <c:v>352.09166729931502</c:v>
                </c:pt>
                <c:pt idx="3">
                  <c:v>586.745007306454</c:v>
                </c:pt>
                <c:pt idx="4">
                  <c:v>426.15529736959297</c:v>
                </c:pt>
                <c:pt idx="5">
                  <c:v>519.07123314058595</c:v>
                </c:pt>
                <c:pt idx="6">
                  <c:v>438.519262725104</c:v>
                </c:pt>
                <c:pt idx="7">
                  <c:v>443.22951625859503</c:v>
                </c:pt>
                <c:pt idx="8">
                  <c:v>254.80000310288901</c:v>
                </c:pt>
                <c:pt idx="9">
                  <c:v>319.50981489697898</c:v>
                </c:pt>
                <c:pt idx="10">
                  <c:v>339.09764732088502</c:v>
                </c:pt>
                <c:pt idx="11">
                  <c:v>412.425270964802</c:v>
                </c:pt>
                <c:pt idx="12">
                  <c:v>413.05987008330601</c:v>
                </c:pt>
                <c:pt idx="13">
                  <c:v>390.65768434630701</c:v>
                </c:pt>
                <c:pt idx="14">
                  <c:v>279.16756799176301</c:v>
                </c:pt>
                <c:pt idx="15">
                  <c:v>373.70419330764099</c:v>
                </c:pt>
                <c:pt idx="16">
                  <c:v>300.36588748709403</c:v>
                </c:pt>
                <c:pt idx="17">
                  <c:v>460.11748227170102</c:v>
                </c:pt>
                <c:pt idx="18">
                  <c:v>398.12886041326499</c:v>
                </c:pt>
                <c:pt idx="19">
                  <c:v>477.62960326138602</c:v>
                </c:pt>
                <c:pt idx="20">
                  <c:v>293.41128933643301</c:v>
                </c:pt>
                <c:pt idx="21">
                  <c:v>277.73271644794301</c:v>
                </c:pt>
                <c:pt idx="22">
                  <c:v>430.346619775617</c:v>
                </c:pt>
                <c:pt idx="23">
                  <c:v>385.011023907099</c:v>
                </c:pt>
                <c:pt idx="24">
                  <c:v>375.63610271048998</c:v>
                </c:pt>
                <c:pt idx="25">
                  <c:v>54.846922281862703</c:v>
                </c:pt>
                <c:pt idx="26">
                  <c:v>371.17989287663698</c:v>
                </c:pt>
                <c:pt idx="27">
                  <c:v>348.46833937000901</c:v>
                </c:pt>
                <c:pt idx="28">
                  <c:v>373.16643427788603</c:v>
                </c:pt>
                <c:pt idx="29">
                  <c:v>300.343771650017</c:v>
                </c:pt>
                <c:pt idx="30">
                  <c:v>388.89389427901102</c:v>
                </c:pt>
                <c:pt idx="31">
                  <c:v>385.93646908509203</c:v>
                </c:pt>
                <c:pt idx="32">
                  <c:v>503.81707128614499</c:v>
                </c:pt>
                <c:pt idx="33">
                  <c:v>587.34659849618197</c:v>
                </c:pt>
                <c:pt idx="34">
                  <c:v>358.67167937168603</c:v>
                </c:pt>
                <c:pt idx="35">
                  <c:v>259.73770971077602</c:v>
                </c:pt>
                <c:pt idx="36">
                  <c:v>449.73207926524299</c:v>
                </c:pt>
                <c:pt idx="37">
                  <c:v>432.46936863726597</c:v>
                </c:pt>
                <c:pt idx="38">
                  <c:v>377.85321867151902</c:v>
                </c:pt>
                <c:pt idx="39">
                  <c:v>507.043702277254</c:v>
                </c:pt>
                <c:pt idx="40">
                  <c:v>438.37246997619098</c:v>
                </c:pt>
                <c:pt idx="41">
                  <c:v>452.62975267734998</c:v>
                </c:pt>
                <c:pt idx="42">
                  <c:v>226.760351898171</c:v>
                </c:pt>
                <c:pt idx="43">
                  <c:v>163.94571749723201</c:v>
                </c:pt>
                <c:pt idx="44">
                  <c:v>486.25899792572699</c:v>
                </c:pt>
                <c:pt idx="45">
                  <c:v>283.57220287454999</c:v>
                </c:pt>
                <c:pt idx="46">
                  <c:v>120.149202892185</c:v>
                </c:pt>
                <c:pt idx="47">
                  <c:v>389.01087943744102</c:v>
                </c:pt>
                <c:pt idx="48">
                  <c:v>567.77606423825</c:v>
                </c:pt>
                <c:pt idx="49">
                  <c:v>383.13851481738601</c:v>
                </c:pt>
                <c:pt idx="50">
                  <c:v>312.98354217766899</c:v>
                </c:pt>
                <c:pt idx="51">
                  <c:v>238.901909257932</c:v>
                </c:pt>
                <c:pt idx="52">
                  <c:v>604.79719835204696</c:v>
                </c:pt>
                <c:pt idx="53">
                  <c:v>395.18027647104998</c:v>
                </c:pt>
                <c:pt idx="54">
                  <c:v>434.16855737773102</c:v>
                </c:pt>
                <c:pt idx="55">
                  <c:v>392.98486751498001</c:v>
                </c:pt>
                <c:pt idx="56">
                  <c:v>395.00872686810101</c:v>
                </c:pt>
                <c:pt idx="57">
                  <c:v>339.18514257920901</c:v>
                </c:pt>
                <c:pt idx="58">
                  <c:v>357.51980041825101</c:v>
                </c:pt>
                <c:pt idx="59">
                  <c:v>197.84668202279801</c:v>
                </c:pt>
                <c:pt idx="60">
                  <c:v>541.80715562584896</c:v>
                </c:pt>
                <c:pt idx="61">
                  <c:v>413.71384197779503</c:v>
                </c:pt>
                <c:pt idx="62">
                  <c:v>380.49920989805298</c:v>
                </c:pt>
                <c:pt idx="63">
                  <c:v>174.82797642144899</c:v>
                </c:pt>
                <c:pt idx="64">
                  <c:v>478.90494655154401</c:v>
                </c:pt>
                <c:pt idx="65">
                  <c:v>369.88202275948697</c:v>
                </c:pt>
                <c:pt idx="66">
                  <c:v>334.18034903170502</c:v>
                </c:pt>
                <c:pt idx="67">
                  <c:v>332.68608448038998</c:v>
                </c:pt>
                <c:pt idx="68">
                  <c:v>303.77003752042202</c:v>
                </c:pt>
                <c:pt idx="69">
                  <c:v>417.57801680594099</c:v>
                </c:pt>
                <c:pt idx="70">
                  <c:v>162.36753184844099</c:v>
                </c:pt>
                <c:pt idx="71">
                  <c:v>177.876205216329</c:v>
                </c:pt>
                <c:pt idx="72">
                  <c:v>405.873014629686</c:v>
                </c:pt>
                <c:pt idx="73">
                  <c:v>323.89790571062599</c:v>
                </c:pt>
                <c:pt idx="74">
                  <c:v>605.93183683688903</c:v>
                </c:pt>
                <c:pt idx="75">
                  <c:v>412.598331904568</c:v>
                </c:pt>
                <c:pt idx="76">
                  <c:v>418.99315778448403</c:v>
                </c:pt>
                <c:pt idx="77">
                  <c:v>356.209317471487</c:v>
                </c:pt>
                <c:pt idx="78">
                  <c:v>412.67595221710599</c:v>
                </c:pt>
                <c:pt idx="79">
                  <c:v>233.396220031665</c:v>
                </c:pt>
                <c:pt idx="80">
                  <c:v>347.62685277826398</c:v>
                </c:pt>
                <c:pt idx="81">
                  <c:v>672.49675725772602</c:v>
                </c:pt>
                <c:pt idx="82">
                  <c:v>283.78654293798098</c:v>
                </c:pt>
                <c:pt idx="83">
                  <c:v>361.26050869559299</c:v>
                </c:pt>
                <c:pt idx="84">
                  <c:v>318.95294625204502</c:v>
                </c:pt>
                <c:pt idx="85">
                  <c:v>322.82657488387002</c:v>
                </c:pt>
                <c:pt idx="86">
                  <c:v>239.70356477366599</c:v>
                </c:pt>
                <c:pt idx="87">
                  <c:v>255.71617879673599</c:v>
                </c:pt>
                <c:pt idx="88">
                  <c:v>239.639089623221</c:v>
                </c:pt>
                <c:pt idx="89">
                  <c:v>301.36730752023601</c:v>
                </c:pt>
                <c:pt idx="90">
                  <c:v>383.76082646489698</c:v>
                </c:pt>
                <c:pt idx="91">
                  <c:v>310.493294136342</c:v>
                </c:pt>
                <c:pt idx="92">
                  <c:v>394.41271104548798</c:v>
                </c:pt>
                <c:pt idx="93">
                  <c:v>413.60742954473199</c:v>
                </c:pt>
                <c:pt idx="94">
                  <c:v>447.22591241931798</c:v>
                </c:pt>
                <c:pt idx="95">
                  <c:v>326.81842778531598</c:v>
                </c:pt>
                <c:pt idx="96">
                  <c:v>318.45161607911501</c:v>
                </c:pt>
                <c:pt idx="97">
                  <c:v>432.16889481115101</c:v>
                </c:pt>
                <c:pt idx="98">
                  <c:v>430.20248500213199</c:v>
                </c:pt>
                <c:pt idx="99">
                  <c:v>332.48147754464497</c:v>
                </c:pt>
                <c:pt idx="100">
                  <c:v>426.034367053854</c:v>
                </c:pt>
                <c:pt idx="101">
                  <c:v>386.88041015746802</c:v>
                </c:pt>
                <c:pt idx="102">
                  <c:v>451.61871148244302</c:v>
                </c:pt>
                <c:pt idx="103">
                  <c:v>377.01216814314898</c:v>
                </c:pt>
                <c:pt idx="104">
                  <c:v>366.10449264823097</c:v>
                </c:pt>
                <c:pt idx="105">
                  <c:v>391.49285976935403</c:v>
                </c:pt>
                <c:pt idx="106">
                  <c:v>455.27999584526202</c:v>
                </c:pt>
                <c:pt idx="107">
                  <c:v>475.19804959059701</c:v>
                </c:pt>
                <c:pt idx="108">
                  <c:v>397.24560676206499</c:v>
                </c:pt>
                <c:pt idx="109">
                  <c:v>449.051279505168</c:v>
                </c:pt>
                <c:pt idx="110">
                  <c:v>502.46161216590701</c:v>
                </c:pt>
                <c:pt idx="111">
                  <c:v>326.62344734631199</c:v>
                </c:pt>
                <c:pt idx="112">
                  <c:v>313.48321422242702</c:v>
                </c:pt>
                <c:pt idx="113">
                  <c:v>516.00979083368702</c:v>
                </c:pt>
                <c:pt idx="114">
                  <c:v>348.20672084770302</c:v>
                </c:pt>
                <c:pt idx="115">
                  <c:v>520.66112938553397</c:v>
                </c:pt>
                <c:pt idx="116">
                  <c:v>431.95786338273399</c:v>
                </c:pt>
                <c:pt idx="117">
                  <c:v>260.431462574607</c:v>
                </c:pt>
                <c:pt idx="118">
                  <c:v>439.05537274373501</c:v>
                </c:pt>
                <c:pt idx="119">
                  <c:v>273.98413682494902</c:v>
                </c:pt>
                <c:pt idx="120">
                  <c:v>346.39226831220498</c:v>
                </c:pt>
                <c:pt idx="121">
                  <c:v>356.73025010472901</c:v>
                </c:pt>
                <c:pt idx="122">
                  <c:v>411.82946779063298</c:v>
                </c:pt>
                <c:pt idx="123">
                  <c:v>535.26980943160402</c:v>
                </c:pt>
                <c:pt idx="124">
                  <c:v>528.09861191041796</c:v>
                </c:pt>
                <c:pt idx="125">
                  <c:v>378.45438087514702</c:v>
                </c:pt>
                <c:pt idx="126">
                  <c:v>502.20665723962401</c:v>
                </c:pt>
                <c:pt idx="127">
                  <c:v>436.66312694362398</c:v>
                </c:pt>
                <c:pt idx="128">
                  <c:v>470.14878074374298</c:v>
                </c:pt>
                <c:pt idx="129">
                  <c:v>387.469891927204</c:v>
                </c:pt>
                <c:pt idx="130">
                  <c:v>454.68392863389602</c:v>
                </c:pt>
                <c:pt idx="131">
                  <c:v>410.682602409911</c:v>
                </c:pt>
                <c:pt idx="132">
                  <c:v>342.681617006316</c:v>
                </c:pt>
                <c:pt idx="133">
                  <c:v>350.959877610251</c:v>
                </c:pt>
                <c:pt idx="134">
                  <c:v>394.881144929877</c:v>
                </c:pt>
                <c:pt idx="135">
                  <c:v>448.705698530549</c:v>
                </c:pt>
                <c:pt idx="136">
                  <c:v>337.99711456974001</c:v>
                </c:pt>
                <c:pt idx="137">
                  <c:v>542.81334455888805</c:v>
                </c:pt>
                <c:pt idx="138">
                  <c:v>280.80658006792999</c:v>
                </c:pt>
                <c:pt idx="139">
                  <c:v>399.77966105262402</c:v>
                </c:pt>
                <c:pt idx="140">
                  <c:v>443.80577329516598</c:v>
                </c:pt>
                <c:pt idx="141">
                  <c:v>379.54622960769302</c:v>
                </c:pt>
                <c:pt idx="142">
                  <c:v>314.34416503086698</c:v>
                </c:pt>
                <c:pt idx="143">
                  <c:v>394.715795483953</c:v>
                </c:pt>
                <c:pt idx="144">
                  <c:v>441.55631847001803</c:v>
                </c:pt>
                <c:pt idx="145">
                  <c:v>408.282473940805</c:v>
                </c:pt>
                <c:pt idx="146">
                  <c:v>412.441114831069</c:v>
                </c:pt>
                <c:pt idx="147">
                  <c:v>460.28038108573901</c:v>
                </c:pt>
                <c:pt idx="148">
                  <c:v>434.09569764896997</c:v>
                </c:pt>
                <c:pt idx="149">
                  <c:v>469.390668823456</c:v>
                </c:pt>
                <c:pt idx="150">
                  <c:v>512.48204676319904</c:v>
                </c:pt>
                <c:pt idx="151">
                  <c:v>426.373510623475</c:v>
                </c:pt>
                <c:pt idx="152">
                  <c:v>516.91781920344602</c:v>
                </c:pt>
                <c:pt idx="153">
                  <c:v>327.878742264648</c:v>
                </c:pt>
                <c:pt idx="154">
                  <c:v>322.863088580127</c:v>
                </c:pt>
                <c:pt idx="155">
                  <c:v>365.60787688389303</c:v>
                </c:pt>
                <c:pt idx="156">
                  <c:v>308.01002739997898</c:v>
                </c:pt>
                <c:pt idx="157">
                  <c:v>397.49810947019398</c:v>
                </c:pt>
                <c:pt idx="158">
                  <c:v>497.85941601518698</c:v>
                </c:pt>
                <c:pt idx="159">
                  <c:v>364.71872792910801</c:v>
                </c:pt>
                <c:pt idx="160">
                  <c:v>590.43726286604794</c:v>
                </c:pt>
                <c:pt idx="161">
                  <c:v>405.97170811416601</c:v>
                </c:pt>
                <c:pt idx="162">
                  <c:v>444.45240162589198</c:v>
                </c:pt>
                <c:pt idx="163">
                  <c:v>546.04735802338405</c:v>
                </c:pt>
                <c:pt idx="164">
                  <c:v>558.94326832809497</c:v>
                </c:pt>
                <c:pt idx="165">
                  <c:v>479.70240728406299</c:v>
                </c:pt>
                <c:pt idx="166">
                  <c:v>364.26382307935103</c:v>
                </c:pt>
                <c:pt idx="167">
                  <c:v>247.68709878561501</c:v>
                </c:pt>
                <c:pt idx="168">
                  <c:v>480.759724702852</c:v>
                </c:pt>
                <c:pt idx="169">
                  <c:v>398.68553118452002</c:v>
                </c:pt>
                <c:pt idx="170">
                  <c:v>410.39767726204298</c:v>
                </c:pt>
                <c:pt idx="171">
                  <c:v>451.74893808495102</c:v>
                </c:pt>
                <c:pt idx="172">
                  <c:v>424.51123738409802</c:v>
                </c:pt>
                <c:pt idx="173">
                  <c:v>376.19789585158298</c:v>
                </c:pt>
                <c:pt idx="174">
                  <c:v>431.38417408783403</c:v>
                </c:pt>
                <c:pt idx="175">
                  <c:v>434.51732307495001</c:v>
                </c:pt>
                <c:pt idx="176">
                  <c:v>337.89252153236799</c:v>
                </c:pt>
                <c:pt idx="177">
                  <c:v>578.20494258317603</c:v>
                </c:pt>
                <c:pt idx="178">
                  <c:v>384.23870296124397</c:v>
                </c:pt>
                <c:pt idx="179">
                  <c:v>447.79128211173202</c:v>
                </c:pt>
                <c:pt idx="180">
                  <c:v>420.40529165172899</c:v>
                </c:pt>
                <c:pt idx="181">
                  <c:v>260.36731079160802</c:v>
                </c:pt>
                <c:pt idx="182">
                  <c:v>550.953689102471</c:v>
                </c:pt>
                <c:pt idx="183">
                  <c:v>154.72658040837601</c:v>
                </c:pt>
                <c:pt idx="184">
                  <c:v>390.767322927924</c:v>
                </c:pt>
                <c:pt idx="185">
                  <c:v>388.92036461912198</c:v>
                </c:pt>
                <c:pt idx="186">
                  <c:v>390.94129678074302</c:v>
                </c:pt>
                <c:pt idx="187">
                  <c:v>429.91121259507401</c:v>
                </c:pt>
                <c:pt idx="188">
                  <c:v>492.91330403219803</c:v>
                </c:pt>
                <c:pt idx="189">
                  <c:v>491.36238716765598</c:v>
                </c:pt>
                <c:pt idx="190">
                  <c:v>431.62019855637902</c:v>
                </c:pt>
                <c:pt idx="191">
                  <c:v>422.35736084949298</c:v>
                </c:pt>
                <c:pt idx="192">
                  <c:v>487.60883826613502</c:v>
                </c:pt>
                <c:pt idx="193">
                  <c:v>277.55839453803901</c:v>
                </c:pt>
                <c:pt idx="194">
                  <c:v>324.25480759532797</c:v>
                </c:pt>
                <c:pt idx="195">
                  <c:v>366.58421032252897</c:v>
                </c:pt>
                <c:pt idx="196">
                  <c:v>502.74199359510197</c:v>
                </c:pt>
                <c:pt idx="197">
                  <c:v>400.24339488632103</c:v>
                </c:pt>
                <c:pt idx="198">
                  <c:v>382.46240626068101</c:v>
                </c:pt>
                <c:pt idx="199">
                  <c:v>525.69090584541198</c:v>
                </c:pt>
                <c:pt idx="200">
                  <c:v>213.12790253316899</c:v>
                </c:pt>
                <c:pt idx="201">
                  <c:v>364.33431164786998</c:v>
                </c:pt>
                <c:pt idx="202">
                  <c:v>414.72338105503599</c:v>
                </c:pt>
                <c:pt idx="203">
                  <c:v>318.60654456178298</c:v>
                </c:pt>
                <c:pt idx="204">
                  <c:v>496.04621666501998</c:v>
                </c:pt>
                <c:pt idx="205">
                  <c:v>205.520672394163</c:v>
                </c:pt>
                <c:pt idx="206">
                  <c:v>453.790548678888</c:v>
                </c:pt>
                <c:pt idx="207">
                  <c:v>250.850306279015</c:v>
                </c:pt>
                <c:pt idx="208">
                  <c:v>409.825457341586</c:v>
                </c:pt>
                <c:pt idx="209">
                  <c:v>396.67512505383701</c:v>
                </c:pt>
                <c:pt idx="210">
                  <c:v>452.76277169881399</c:v>
                </c:pt>
                <c:pt idx="211">
                  <c:v>481.05982797916403</c:v>
                </c:pt>
                <c:pt idx="212">
                  <c:v>432.10643854663601</c:v>
                </c:pt>
                <c:pt idx="213">
                  <c:v>317.64577624422901</c:v>
                </c:pt>
                <c:pt idx="214">
                  <c:v>411.37601364547697</c:v>
                </c:pt>
                <c:pt idx="215">
                  <c:v>406.114691364034</c:v>
                </c:pt>
                <c:pt idx="216">
                  <c:v>217.02130007649799</c:v>
                </c:pt>
                <c:pt idx="217">
                  <c:v>236.145753248912</c:v>
                </c:pt>
                <c:pt idx="218">
                  <c:v>275.36969371137297</c:v>
                </c:pt>
                <c:pt idx="219">
                  <c:v>471.54231688581302</c:v>
                </c:pt>
                <c:pt idx="220">
                  <c:v>213.87927778153701</c:v>
                </c:pt>
                <c:pt idx="221">
                  <c:v>418.32924116909697</c:v>
                </c:pt>
                <c:pt idx="222">
                  <c:v>465.97843346963799</c:v>
                </c:pt>
                <c:pt idx="223">
                  <c:v>275.40306814809998</c:v>
                </c:pt>
                <c:pt idx="224">
                  <c:v>352.87261588144202</c:v>
                </c:pt>
                <c:pt idx="225">
                  <c:v>492.61363321471498</c:v>
                </c:pt>
                <c:pt idx="226">
                  <c:v>265.624293687484</c:v>
                </c:pt>
                <c:pt idx="227">
                  <c:v>198.26502117706301</c:v>
                </c:pt>
                <c:pt idx="228">
                  <c:v>475.30868037426097</c:v>
                </c:pt>
                <c:pt idx="229">
                  <c:v>317.325109171073</c:v>
                </c:pt>
                <c:pt idx="230">
                  <c:v>490.35045423357502</c:v>
                </c:pt>
                <c:pt idx="231">
                  <c:v>315.14651454054001</c:v>
                </c:pt>
                <c:pt idx="232">
                  <c:v>351.15358065497998</c:v>
                </c:pt>
                <c:pt idx="233">
                  <c:v>359.219866265566</c:v>
                </c:pt>
                <c:pt idx="234">
                  <c:v>328.19648549983702</c:v>
                </c:pt>
                <c:pt idx="235">
                  <c:v>256.85854138289199</c:v>
                </c:pt>
                <c:pt idx="236">
                  <c:v>367.78512156524499</c:v>
                </c:pt>
                <c:pt idx="237">
                  <c:v>269.19178410666098</c:v>
                </c:pt>
                <c:pt idx="238">
                  <c:v>417.29398409888302</c:v>
                </c:pt>
                <c:pt idx="239">
                  <c:v>282.22576160165499</c:v>
                </c:pt>
                <c:pt idx="240">
                  <c:v>423.53632021684899</c:v>
                </c:pt>
                <c:pt idx="241">
                  <c:v>328.37741453562597</c:v>
                </c:pt>
                <c:pt idx="242">
                  <c:v>383.70579774133199</c:v>
                </c:pt>
                <c:pt idx="243">
                  <c:v>669.79241412063698</c:v>
                </c:pt>
                <c:pt idx="244">
                  <c:v>399.784603182436</c:v>
                </c:pt>
                <c:pt idx="245">
                  <c:v>508.55105022704902</c:v>
                </c:pt>
                <c:pt idx="246">
                  <c:v>399.27507332701902</c:v>
                </c:pt>
                <c:pt idx="247">
                  <c:v>129.229800261012</c:v>
                </c:pt>
                <c:pt idx="248">
                  <c:v>502.13195592955401</c:v>
                </c:pt>
                <c:pt idx="249">
                  <c:v>314.502347349839</c:v>
                </c:pt>
                <c:pt idx="250">
                  <c:v>476.391922051363</c:v>
                </c:pt>
                <c:pt idx="251">
                  <c:v>365.84523586323002</c:v>
                </c:pt>
                <c:pt idx="252">
                  <c:v>339.66649532041902</c:v>
                </c:pt>
                <c:pt idx="253">
                  <c:v>565.48355344859795</c:v>
                </c:pt>
                <c:pt idx="254">
                  <c:v>498.00593283296899</c:v>
                </c:pt>
                <c:pt idx="255">
                  <c:v>174.91106098356701</c:v>
                </c:pt>
                <c:pt idx="256">
                  <c:v>336.981974482547</c:v>
                </c:pt>
                <c:pt idx="257">
                  <c:v>480.60956528365</c:v>
                </c:pt>
                <c:pt idx="258">
                  <c:v>508.919564936732</c:v>
                </c:pt>
                <c:pt idx="259">
                  <c:v>284.707707782988</c:v>
                </c:pt>
                <c:pt idx="260">
                  <c:v>445.21422077862701</c:v>
                </c:pt>
                <c:pt idx="261">
                  <c:v>242.325984590801</c:v>
                </c:pt>
                <c:pt idx="262">
                  <c:v>408.68257045285799</c:v>
                </c:pt>
                <c:pt idx="263">
                  <c:v>401.32128015294501</c:v>
                </c:pt>
                <c:pt idx="264">
                  <c:v>248.64444973263599</c:v>
                </c:pt>
                <c:pt idx="265">
                  <c:v>457.189957924081</c:v>
                </c:pt>
                <c:pt idx="266">
                  <c:v>282.56974095972703</c:v>
                </c:pt>
                <c:pt idx="267">
                  <c:v>365.76960925049599</c:v>
                </c:pt>
                <c:pt idx="268">
                  <c:v>300.43332437077601</c:v>
                </c:pt>
                <c:pt idx="269">
                  <c:v>437.27278029829802</c:v>
                </c:pt>
                <c:pt idx="270">
                  <c:v>393.71683223451799</c:v>
                </c:pt>
                <c:pt idx="271">
                  <c:v>479.16057664458799</c:v>
                </c:pt>
                <c:pt idx="272">
                  <c:v>223.19868935532</c:v>
                </c:pt>
                <c:pt idx="273">
                  <c:v>288.21536444134802</c:v>
                </c:pt>
                <c:pt idx="274">
                  <c:v>573.35264078836099</c:v>
                </c:pt>
                <c:pt idx="275">
                  <c:v>452.86592148215601</c:v>
                </c:pt>
                <c:pt idx="276">
                  <c:v>206.73410740500699</c:v>
                </c:pt>
                <c:pt idx="277">
                  <c:v>491.325111556541</c:v>
                </c:pt>
                <c:pt idx="278">
                  <c:v>315.16131204464102</c:v>
                </c:pt>
                <c:pt idx="279">
                  <c:v>412.23879755725898</c:v>
                </c:pt>
                <c:pt idx="280">
                  <c:v>367.84479906993602</c:v>
                </c:pt>
                <c:pt idx="281">
                  <c:v>519.59347121473695</c:v>
                </c:pt>
                <c:pt idx="282">
                  <c:v>514.08448557752399</c:v>
                </c:pt>
                <c:pt idx="283">
                  <c:v>450.86785513632998</c:v>
                </c:pt>
                <c:pt idx="284">
                  <c:v>409.21871043376598</c:v>
                </c:pt>
                <c:pt idx="285">
                  <c:v>348.215764790538</c:v>
                </c:pt>
                <c:pt idx="286">
                  <c:v>368.362105460691</c:v>
                </c:pt>
                <c:pt idx="287">
                  <c:v>467.85424937014102</c:v>
                </c:pt>
                <c:pt idx="288">
                  <c:v>507.204931716018</c:v>
                </c:pt>
                <c:pt idx="289">
                  <c:v>475.35748097202401</c:v>
                </c:pt>
                <c:pt idx="290">
                  <c:v>443.660161636711</c:v>
                </c:pt>
                <c:pt idx="291">
                  <c:v>368.683018709377</c:v>
                </c:pt>
              </c:numCache>
            </c:numRef>
          </c:xVal>
          <c:yVal>
            <c:numRef>
              <c:f>Sheet1!$H$2:$H$293</c:f>
              <c:numCache>
                <c:formatCode>0.00</c:formatCode>
                <c:ptCount val="292"/>
                <c:pt idx="0">
                  <c:v>56.972077100385398</c:v>
                </c:pt>
                <c:pt idx="1">
                  <c:v>50.274495062583703</c:v>
                </c:pt>
                <c:pt idx="2">
                  <c:v>51.893962270069103</c:v>
                </c:pt>
                <c:pt idx="3">
                  <c:v>71.713090752602795</c:v>
                </c:pt>
                <c:pt idx="4">
                  <c:v>50.053466729707203</c:v>
                </c:pt>
                <c:pt idx="5">
                  <c:v>57.995876173584897</c:v>
                </c:pt>
                <c:pt idx="6">
                  <c:v>61.7723183678198</c:v>
                </c:pt>
                <c:pt idx="7">
                  <c:v>61.180472178970199</c:v>
                </c:pt>
                <c:pt idx="8">
                  <c:v>44.037192089527601</c:v>
                </c:pt>
                <c:pt idx="9">
                  <c:v>50.879199692966601</c:v>
                </c:pt>
                <c:pt idx="10">
                  <c:v>50.302686169060799</c:v>
                </c:pt>
                <c:pt idx="11">
                  <c:v>54.101407795382499</c:v>
                </c:pt>
                <c:pt idx="12">
                  <c:v>56.347289590662399</c:v>
                </c:pt>
                <c:pt idx="13">
                  <c:v>56.779356748393703</c:v>
                </c:pt>
                <c:pt idx="14">
                  <c:v>47.872790316589096</c:v>
                </c:pt>
                <c:pt idx="15">
                  <c:v>46.936973608139702</c:v>
                </c:pt>
                <c:pt idx="16">
                  <c:v>42.991609451018903</c:v>
                </c:pt>
                <c:pt idx="17">
                  <c:v>53.781982524356799</c:v>
                </c:pt>
                <c:pt idx="18">
                  <c:v>56.869674615574503</c:v>
                </c:pt>
                <c:pt idx="19">
                  <c:v>53.646277321138598</c:v>
                </c:pt>
                <c:pt idx="20">
                  <c:v>48.098484237270803</c:v>
                </c:pt>
                <c:pt idx="21">
                  <c:v>40.027290026322</c:v>
                </c:pt>
                <c:pt idx="22">
                  <c:v>54.007265579851101</c:v>
                </c:pt>
                <c:pt idx="23">
                  <c:v>44.144985457485802</c:v>
                </c:pt>
                <c:pt idx="24">
                  <c:v>53.762647668883702</c:v>
                </c:pt>
                <c:pt idx="25">
                  <c:v>9.0131931736008006</c:v>
                </c:pt>
                <c:pt idx="26">
                  <c:v>52.398549481149097</c:v>
                </c:pt>
                <c:pt idx="27">
                  <c:v>57.434719609964901</c:v>
                </c:pt>
                <c:pt idx="28">
                  <c:v>47.967287803390398</c:v>
                </c:pt>
                <c:pt idx="29">
                  <c:v>36.310119942835698</c:v>
                </c:pt>
                <c:pt idx="30">
                  <c:v>55.676408319631101</c:v>
                </c:pt>
                <c:pt idx="31">
                  <c:v>48.581742345490099</c:v>
                </c:pt>
                <c:pt idx="32">
                  <c:v>62.594002300875502</c:v>
                </c:pt>
                <c:pt idx="33">
                  <c:v>59.854779654009597</c:v>
                </c:pt>
                <c:pt idx="34">
                  <c:v>54.451483677633703</c:v>
                </c:pt>
                <c:pt idx="35">
                  <c:v>38.007132229040202</c:v>
                </c:pt>
                <c:pt idx="36">
                  <c:v>62.626498851359003</c:v>
                </c:pt>
                <c:pt idx="37">
                  <c:v>57.662376091029998</c:v>
                </c:pt>
                <c:pt idx="38">
                  <c:v>53.879139369179299</c:v>
                </c:pt>
                <c:pt idx="39">
                  <c:v>55.809472138745598</c:v>
                </c:pt>
                <c:pt idx="40">
                  <c:v>58.794624656558298</c:v>
                </c:pt>
                <c:pt idx="41">
                  <c:v>60.375381862704003</c:v>
                </c:pt>
                <c:pt idx="42">
                  <c:v>41.696600406779197</c:v>
                </c:pt>
                <c:pt idx="43">
                  <c:v>26.2433277633552</c:v>
                </c:pt>
                <c:pt idx="44">
                  <c:v>58.641955807548101</c:v>
                </c:pt>
                <c:pt idx="45">
                  <c:v>36.4543313130388</c:v>
                </c:pt>
                <c:pt idx="46">
                  <c:v>21.785192929797201</c:v>
                </c:pt>
                <c:pt idx="47">
                  <c:v>64.993278644278902</c:v>
                </c:pt>
                <c:pt idx="48">
                  <c:v>61.614071168195402</c:v>
                </c:pt>
                <c:pt idx="49">
                  <c:v>49.677969121519403</c:v>
                </c:pt>
                <c:pt idx="50">
                  <c:v>47.505857965697899</c:v>
                </c:pt>
                <c:pt idx="51">
                  <c:v>38.737598262460899</c:v>
                </c:pt>
                <c:pt idx="52">
                  <c:v>70.781531285897103</c:v>
                </c:pt>
                <c:pt idx="53">
                  <c:v>62.907709950822202</c:v>
                </c:pt>
                <c:pt idx="54">
                  <c:v>61.335014178162801</c:v>
                </c:pt>
                <c:pt idx="55">
                  <c:v>56.919721777076802</c:v>
                </c:pt>
                <c:pt idx="56">
                  <c:v>52.448920107840401</c:v>
                </c:pt>
                <c:pt idx="57">
                  <c:v>49.935286212189098</c:v>
                </c:pt>
                <c:pt idx="58">
                  <c:v>52.909163062357997</c:v>
                </c:pt>
                <c:pt idx="59">
                  <c:v>28.537327549817299</c:v>
                </c:pt>
                <c:pt idx="60">
                  <c:v>72.2613551862256</c:v>
                </c:pt>
                <c:pt idx="61">
                  <c:v>55.991890964098801</c:v>
                </c:pt>
                <c:pt idx="62">
                  <c:v>56.114212597211299</c:v>
                </c:pt>
                <c:pt idx="63">
                  <c:v>27.575735701159999</c:v>
                </c:pt>
                <c:pt idx="64">
                  <c:v>55.569873870355202</c:v>
                </c:pt>
                <c:pt idx="65">
                  <c:v>53.895857340886302</c:v>
                </c:pt>
                <c:pt idx="66">
                  <c:v>49.875933443380902</c:v>
                </c:pt>
                <c:pt idx="67">
                  <c:v>46.410331813190403</c:v>
                </c:pt>
                <c:pt idx="68">
                  <c:v>38.706625116673301</c:v>
                </c:pt>
                <c:pt idx="69">
                  <c:v>49.195967025716698</c:v>
                </c:pt>
                <c:pt idx="70">
                  <c:v>26.5962564349357</c:v>
                </c:pt>
                <c:pt idx="71">
                  <c:v>29.163189362389101</c:v>
                </c:pt>
                <c:pt idx="72">
                  <c:v>49.660122124788501</c:v>
                </c:pt>
                <c:pt idx="73">
                  <c:v>42.178618792316598</c:v>
                </c:pt>
                <c:pt idx="74">
                  <c:v>82.350829867282002</c:v>
                </c:pt>
                <c:pt idx="75">
                  <c:v>60.671912046148798</c:v>
                </c:pt>
                <c:pt idx="76">
                  <c:v>60.504169400802198</c:v>
                </c:pt>
                <c:pt idx="77">
                  <c:v>48.896858626788699</c:v>
                </c:pt>
                <c:pt idx="78">
                  <c:v>63.628476899675597</c:v>
                </c:pt>
                <c:pt idx="79">
                  <c:v>34.696388549660398</c:v>
                </c:pt>
                <c:pt idx="80">
                  <c:v>42.325771435721897</c:v>
                </c:pt>
                <c:pt idx="81">
                  <c:v>77.710995594919694</c:v>
                </c:pt>
                <c:pt idx="82">
                  <c:v>41.556897161641103</c:v>
                </c:pt>
                <c:pt idx="83">
                  <c:v>59.164431243312002</c:v>
                </c:pt>
                <c:pt idx="84">
                  <c:v>56.008452316598699</c:v>
                </c:pt>
                <c:pt idx="85">
                  <c:v>44.163139359274098</c:v>
                </c:pt>
                <c:pt idx="86">
                  <c:v>41.953259237189698</c:v>
                </c:pt>
                <c:pt idx="87">
                  <c:v>40.528014882408897</c:v>
                </c:pt>
                <c:pt idx="88">
                  <c:v>35.529732105963497</c:v>
                </c:pt>
                <c:pt idx="89">
                  <c:v>42.404185261799498</c:v>
                </c:pt>
                <c:pt idx="90">
                  <c:v>52.576625844025799</c:v>
                </c:pt>
                <c:pt idx="91">
                  <c:v>51.104169695579998</c:v>
                </c:pt>
                <c:pt idx="92">
                  <c:v>55.760705799723297</c:v>
                </c:pt>
                <c:pt idx="93">
                  <c:v>54.631439628722099</c:v>
                </c:pt>
                <c:pt idx="94">
                  <c:v>58.180254171333502</c:v>
                </c:pt>
                <c:pt idx="95">
                  <c:v>45.070798536212799</c:v>
                </c:pt>
                <c:pt idx="96">
                  <c:v>47.922707330841099</c:v>
                </c:pt>
                <c:pt idx="97">
                  <c:v>54.428116453079099</c:v>
                </c:pt>
                <c:pt idx="98">
                  <c:v>58.625309188636201</c:v>
                </c:pt>
                <c:pt idx="99">
                  <c:v>59.299487585082801</c:v>
                </c:pt>
                <c:pt idx="100">
                  <c:v>60.443382341604</c:v>
                </c:pt>
                <c:pt idx="101">
                  <c:v>47.891579937556301</c:v>
                </c:pt>
                <c:pt idx="102">
                  <c:v>64.870201651673696</c:v>
                </c:pt>
                <c:pt idx="103">
                  <c:v>53.223518046519999</c:v>
                </c:pt>
                <c:pt idx="104">
                  <c:v>58.926591542835297</c:v>
                </c:pt>
                <c:pt idx="105">
                  <c:v>48.721980122787798</c:v>
                </c:pt>
                <c:pt idx="106">
                  <c:v>59.578476197647198</c:v>
                </c:pt>
                <c:pt idx="107">
                  <c:v>58.823210911687397</c:v>
                </c:pt>
                <c:pt idx="108">
                  <c:v>56.118116021475402</c:v>
                </c:pt>
                <c:pt idx="109">
                  <c:v>61.316908802032501</c:v>
                </c:pt>
                <c:pt idx="110">
                  <c:v>58.807713792167696</c:v>
                </c:pt>
                <c:pt idx="111">
                  <c:v>49.9405798905712</c:v>
                </c:pt>
                <c:pt idx="112">
                  <c:v>48.235066642264101</c:v>
                </c:pt>
                <c:pt idx="113">
                  <c:v>61.0272653661861</c:v>
                </c:pt>
                <c:pt idx="114">
                  <c:v>45.281684756388103</c:v>
                </c:pt>
                <c:pt idx="115">
                  <c:v>67.459578250342005</c:v>
                </c:pt>
                <c:pt idx="116">
                  <c:v>59.086077576673397</c:v>
                </c:pt>
                <c:pt idx="117">
                  <c:v>43.254642058866999</c:v>
                </c:pt>
                <c:pt idx="118">
                  <c:v>53.600342353512502</c:v>
                </c:pt>
                <c:pt idx="119">
                  <c:v>43.791365948270297</c:v>
                </c:pt>
                <c:pt idx="120">
                  <c:v>58.663991372634399</c:v>
                </c:pt>
                <c:pt idx="121">
                  <c:v>46.274977903686903</c:v>
                </c:pt>
                <c:pt idx="122">
                  <c:v>48.8320315144001</c:v>
                </c:pt>
                <c:pt idx="123">
                  <c:v>70.647393984881703</c:v>
                </c:pt>
                <c:pt idx="124">
                  <c:v>58.8909029726642</c:v>
                </c:pt>
                <c:pt idx="125">
                  <c:v>51.267353876218799</c:v>
                </c:pt>
                <c:pt idx="126">
                  <c:v>63.742125779656497</c:v>
                </c:pt>
                <c:pt idx="127">
                  <c:v>67.928542553243503</c:v>
                </c:pt>
                <c:pt idx="128">
                  <c:v>71.563198014722801</c:v>
                </c:pt>
                <c:pt idx="129">
                  <c:v>59.757550948477999</c:v>
                </c:pt>
                <c:pt idx="130">
                  <c:v>64.022905187432698</c:v>
                </c:pt>
                <c:pt idx="131">
                  <c:v>60.165871537049298</c:v>
                </c:pt>
                <c:pt idx="132">
                  <c:v>51.3146924951781</c:v>
                </c:pt>
                <c:pt idx="133">
                  <c:v>48.590047888970197</c:v>
                </c:pt>
                <c:pt idx="134">
                  <c:v>58.565460347918403</c:v>
                </c:pt>
                <c:pt idx="135">
                  <c:v>64.668024867013898</c:v>
                </c:pt>
                <c:pt idx="136">
                  <c:v>50.876788832705003</c:v>
                </c:pt>
                <c:pt idx="137">
                  <c:v>63.8255387105796</c:v>
                </c:pt>
                <c:pt idx="138">
                  <c:v>43.244778023986598</c:v>
                </c:pt>
                <c:pt idx="139">
                  <c:v>53.201433081363099</c:v>
                </c:pt>
                <c:pt idx="140">
                  <c:v>56.090280126204803</c:v>
                </c:pt>
                <c:pt idx="141">
                  <c:v>49.327301478742903</c:v>
                </c:pt>
                <c:pt idx="142">
                  <c:v>45.867252173397702</c:v>
                </c:pt>
                <c:pt idx="143">
                  <c:v>60.428261133375401</c:v>
                </c:pt>
                <c:pt idx="144">
                  <c:v>67.807811681852698</c:v>
                </c:pt>
                <c:pt idx="145">
                  <c:v>60.341604093229101</c:v>
                </c:pt>
                <c:pt idx="146">
                  <c:v>59.637683669478598</c:v>
                </c:pt>
                <c:pt idx="147">
                  <c:v>61.627867827255599</c:v>
                </c:pt>
                <c:pt idx="148">
                  <c:v>59.646336852831503</c:v>
                </c:pt>
                <c:pt idx="149">
                  <c:v>54.526691443738599</c:v>
                </c:pt>
                <c:pt idx="150">
                  <c:v>75.192574075260097</c:v>
                </c:pt>
                <c:pt idx="151">
                  <c:v>56.211653337613498</c:v>
                </c:pt>
                <c:pt idx="152">
                  <c:v>70.755365941206904</c:v>
                </c:pt>
                <c:pt idx="153">
                  <c:v>38.263261949967102</c:v>
                </c:pt>
                <c:pt idx="154">
                  <c:v>48.285999914370201</c:v>
                </c:pt>
                <c:pt idx="155">
                  <c:v>52.756648017187402</c:v>
                </c:pt>
                <c:pt idx="156">
                  <c:v>42.940091936150701</c:v>
                </c:pt>
                <c:pt idx="157">
                  <c:v>48.846795373706797</c:v>
                </c:pt>
                <c:pt idx="158">
                  <c:v>68.432772068902096</c:v>
                </c:pt>
                <c:pt idx="159">
                  <c:v>56.331199751485201</c:v>
                </c:pt>
                <c:pt idx="160">
                  <c:v>71.093857241296703</c:v>
                </c:pt>
                <c:pt idx="161">
                  <c:v>47.748863438948298</c:v>
                </c:pt>
                <c:pt idx="162">
                  <c:v>63.590925967021498</c:v>
                </c:pt>
                <c:pt idx="163">
                  <c:v>76.906317291512295</c:v>
                </c:pt>
                <c:pt idx="164">
                  <c:v>68.764591385139994</c:v>
                </c:pt>
                <c:pt idx="165">
                  <c:v>62.580621989055103</c:v>
                </c:pt>
                <c:pt idx="166">
                  <c:v>52.228071213885002</c:v>
                </c:pt>
                <c:pt idx="167">
                  <c:v>37.058168369218301</c:v>
                </c:pt>
                <c:pt idx="168">
                  <c:v>67.903632284165994</c:v>
                </c:pt>
                <c:pt idx="169">
                  <c:v>52.162654764120902</c:v>
                </c:pt>
                <c:pt idx="170">
                  <c:v>52.260963102452898</c:v>
                </c:pt>
                <c:pt idx="171">
                  <c:v>51.999256572090097</c:v>
                </c:pt>
                <c:pt idx="172">
                  <c:v>51.488832163144302</c:v>
                </c:pt>
                <c:pt idx="173">
                  <c:v>49.009171785412299</c:v>
                </c:pt>
                <c:pt idx="174">
                  <c:v>67.635396416586602</c:v>
                </c:pt>
                <c:pt idx="175">
                  <c:v>52.979734934627999</c:v>
                </c:pt>
                <c:pt idx="176">
                  <c:v>43.989570135946799</c:v>
                </c:pt>
                <c:pt idx="177">
                  <c:v>70.651179203688301</c:v>
                </c:pt>
                <c:pt idx="178">
                  <c:v>53.847698009892</c:v>
                </c:pt>
                <c:pt idx="179">
                  <c:v>64.782492550404001</c:v>
                </c:pt>
                <c:pt idx="180">
                  <c:v>51.687388166452699</c:v>
                </c:pt>
                <c:pt idx="181">
                  <c:v>45.101457423431498</c:v>
                </c:pt>
                <c:pt idx="182">
                  <c:v>66.063912205334603</c:v>
                </c:pt>
                <c:pt idx="183">
                  <c:v>27.985881561136299</c:v>
                </c:pt>
                <c:pt idx="184">
                  <c:v>54.2592113810665</c:v>
                </c:pt>
                <c:pt idx="185">
                  <c:v>49.840392025159403</c:v>
                </c:pt>
                <c:pt idx="186">
                  <c:v>54.637563790980899</c:v>
                </c:pt>
                <c:pt idx="187">
                  <c:v>67.109259900192598</c:v>
                </c:pt>
                <c:pt idx="188">
                  <c:v>60.1512922151976</c:v>
                </c:pt>
                <c:pt idx="189">
                  <c:v>55.223437037876998</c:v>
                </c:pt>
                <c:pt idx="190">
                  <c:v>56.6625362807412</c:v>
                </c:pt>
                <c:pt idx="191">
                  <c:v>50.815543978080903</c:v>
                </c:pt>
                <c:pt idx="192">
                  <c:v>75.606846539182101</c:v>
                </c:pt>
                <c:pt idx="193">
                  <c:v>46.9869152627167</c:v>
                </c:pt>
                <c:pt idx="194">
                  <c:v>47.520139698214102</c:v>
                </c:pt>
                <c:pt idx="195">
                  <c:v>46.315987902472699</c:v>
                </c:pt>
                <c:pt idx="196">
                  <c:v>65.286724821380005</c:v>
                </c:pt>
                <c:pt idx="197">
                  <c:v>60.324440640246202</c:v>
                </c:pt>
                <c:pt idx="198">
                  <c:v>49.851426262169099</c:v>
                </c:pt>
                <c:pt idx="199">
                  <c:v>70.412289309144398</c:v>
                </c:pt>
                <c:pt idx="200">
                  <c:v>31.308167787830399</c:v>
                </c:pt>
                <c:pt idx="201">
                  <c:v>59.223889368471497</c:v>
                </c:pt>
                <c:pt idx="202">
                  <c:v>59.001077672024998</c:v>
                </c:pt>
                <c:pt idx="203">
                  <c:v>45.433091166193201</c:v>
                </c:pt>
                <c:pt idx="204">
                  <c:v>52.952952822794799</c:v>
                </c:pt>
                <c:pt idx="205">
                  <c:v>31.934683259602</c:v>
                </c:pt>
                <c:pt idx="206">
                  <c:v>66.971362683960507</c:v>
                </c:pt>
                <c:pt idx="207">
                  <c:v>36.096375649022903</c:v>
                </c:pt>
                <c:pt idx="208">
                  <c:v>59.6412817803471</c:v>
                </c:pt>
                <c:pt idx="209">
                  <c:v>54.790189522879302</c:v>
                </c:pt>
                <c:pt idx="210">
                  <c:v>60.826313233139203</c:v>
                </c:pt>
                <c:pt idx="211">
                  <c:v>51.9356854990369</c:v>
                </c:pt>
                <c:pt idx="212">
                  <c:v>59.065201713704496</c:v>
                </c:pt>
                <c:pt idx="213">
                  <c:v>42.242472159188097</c:v>
                </c:pt>
                <c:pt idx="214">
                  <c:v>54.472301503230803</c:v>
                </c:pt>
                <c:pt idx="215">
                  <c:v>60.259387955799703</c:v>
                </c:pt>
                <c:pt idx="216">
                  <c:v>30.868899475521101</c:v>
                </c:pt>
                <c:pt idx="217">
                  <c:v>36.894735270520798</c:v>
                </c:pt>
                <c:pt idx="218">
                  <c:v>45.606245925547803</c:v>
                </c:pt>
                <c:pt idx="219">
                  <c:v>55.843714523368703</c:v>
                </c:pt>
                <c:pt idx="220">
                  <c:v>31.155211776591798</c:v>
                </c:pt>
                <c:pt idx="221">
                  <c:v>50.748057305221799</c:v>
                </c:pt>
                <c:pt idx="222">
                  <c:v>58.0290247415492</c:v>
                </c:pt>
                <c:pt idx="223">
                  <c:v>41.000284984001802</c:v>
                </c:pt>
                <c:pt idx="224">
                  <c:v>54.068462339065903</c:v>
                </c:pt>
                <c:pt idx="225">
                  <c:v>69.137858767567394</c:v>
                </c:pt>
                <c:pt idx="226">
                  <c:v>42.990008479852499</c:v>
                </c:pt>
                <c:pt idx="227">
                  <c:v>33.499299100843501</c:v>
                </c:pt>
                <c:pt idx="228">
                  <c:v>59.083023540164099</c:v>
                </c:pt>
                <c:pt idx="229">
                  <c:v>54.401734980352202</c:v>
                </c:pt>
                <c:pt idx="230">
                  <c:v>70.983496962599801</c:v>
                </c:pt>
                <c:pt idx="231">
                  <c:v>42.280161391491198</c:v>
                </c:pt>
                <c:pt idx="232">
                  <c:v>56.883508068888702</c:v>
                </c:pt>
                <c:pt idx="233">
                  <c:v>57.0240135484378</c:v>
                </c:pt>
                <c:pt idx="234">
                  <c:v>57.955703235564201</c:v>
                </c:pt>
                <c:pt idx="235">
                  <c:v>43.5314750530246</c:v>
                </c:pt>
                <c:pt idx="236">
                  <c:v>50.664581374276104</c:v>
                </c:pt>
                <c:pt idx="237">
                  <c:v>36.603483778226597</c:v>
                </c:pt>
                <c:pt idx="238">
                  <c:v>54.4311322425566</c:v>
                </c:pt>
                <c:pt idx="239">
                  <c:v>40.939998979766997</c:v>
                </c:pt>
                <c:pt idx="240">
                  <c:v>49.660595598154899</c:v>
                </c:pt>
                <c:pt idx="241">
                  <c:v>49.263777346776102</c:v>
                </c:pt>
                <c:pt idx="242">
                  <c:v>51.011070271085302</c:v>
                </c:pt>
                <c:pt idx="243">
                  <c:v>66.610148000527403</c:v>
                </c:pt>
                <c:pt idx="244">
                  <c:v>47.972404582197399</c:v>
                </c:pt>
                <c:pt idx="245">
                  <c:v>61.1601612302223</c:v>
                </c:pt>
                <c:pt idx="246">
                  <c:v>60.026672189200603</c:v>
                </c:pt>
                <c:pt idx="247">
                  <c:v>21.7647749498853</c:v>
                </c:pt>
                <c:pt idx="248">
                  <c:v>58.572987816476598</c:v>
                </c:pt>
                <c:pt idx="249">
                  <c:v>52.5323875572468</c:v>
                </c:pt>
                <c:pt idx="250">
                  <c:v>52.998580150862303</c:v>
                </c:pt>
                <c:pt idx="251">
                  <c:v>54.4942167787001</c:v>
                </c:pt>
                <c:pt idx="252">
                  <c:v>49.855690965553698</c:v>
                </c:pt>
                <c:pt idx="253">
                  <c:v>58.956414858443502</c:v>
                </c:pt>
                <c:pt idx="254">
                  <c:v>76.731228560061794</c:v>
                </c:pt>
                <c:pt idx="255">
                  <c:v>27.240965868897799</c:v>
                </c:pt>
                <c:pt idx="256">
                  <c:v>50.909235898459002</c:v>
                </c:pt>
                <c:pt idx="257">
                  <c:v>68.736162365080204</c:v>
                </c:pt>
                <c:pt idx="258">
                  <c:v>73.733485074619594</c:v>
                </c:pt>
                <c:pt idx="259">
                  <c:v>46.551512182548699</c:v>
                </c:pt>
                <c:pt idx="260">
                  <c:v>53.482651487735303</c:v>
                </c:pt>
                <c:pt idx="261">
                  <c:v>39.100818098411203</c:v>
                </c:pt>
                <c:pt idx="262">
                  <c:v>51.214858763842997</c:v>
                </c:pt>
                <c:pt idx="263">
                  <c:v>46.053050275939199</c:v>
                </c:pt>
                <c:pt idx="264">
                  <c:v>35.825806557620197</c:v>
                </c:pt>
                <c:pt idx="265">
                  <c:v>62.783162679559901</c:v>
                </c:pt>
                <c:pt idx="266">
                  <c:v>46.514628516579599</c:v>
                </c:pt>
                <c:pt idx="267">
                  <c:v>53.995020481960999</c:v>
                </c:pt>
                <c:pt idx="268">
                  <c:v>43.071453824174398</c:v>
                </c:pt>
                <c:pt idx="269">
                  <c:v>49.074829233558397</c:v>
                </c:pt>
                <c:pt idx="270">
                  <c:v>49.765163778967398</c:v>
                </c:pt>
                <c:pt idx="271">
                  <c:v>61.623355253410502</c:v>
                </c:pt>
                <c:pt idx="272">
                  <c:v>32.918851551533301</c:v>
                </c:pt>
                <c:pt idx="273">
                  <c:v>43.388638800723101</c:v>
                </c:pt>
                <c:pt idx="274">
                  <c:v>60.609318615525503</c:v>
                </c:pt>
                <c:pt idx="275">
                  <c:v>63.064100310151197</c:v>
                </c:pt>
                <c:pt idx="276">
                  <c:v>32.4962147027219</c:v>
                </c:pt>
                <c:pt idx="277">
                  <c:v>58.957866142950202</c:v>
                </c:pt>
                <c:pt idx="278">
                  <c:v>41.316779690310597</c:v>
                </c:pt>
                <c:pt idx="279">
                  <c:v>52.326392150361897</c:v>
                </c:pt>
                <c:pt idx="280">
                  <c:v>62.787637125143704</c:v>
                </c:pt>
                <c:pt idx="281">
                  <c:v>64.568523738090605</c:v>
                </c:pt>
                <c:pt idx="282">
                  <c:v>58.071389846438898</c:v>
                </c:pt>
                <c:pt idx="283">
                  <c:v>51.754538072477203</c:v>
                </c:pt>
                <c:pt idx="284">
                  <c:v>55.174748251138801</c:v>
                </c:pt>
                <c:pt idx="285">
                  <c:v>53.095891989383297</c:v>
                </c:pt>
                <c:pt idx="286">
                  <c:v>44.844932333790403</c:v>
                </c:pt>
                <c:pt idx="287">
                  <c:v>69.430604336269397</c:v>
                </c:pt>
                <c:pt idx="288">
                  <c:v>58.472214987243703</c:v>
                </c:pt>
                <c:pt idx="289">
                  <c:v>59.932507698279501</c:v>
                </c:pt>
                <c:pt idx="290">
                  <c:v>59.966679205323103</c:v>
                </c:pt>
                <c:pt idx="291">
                  <c:v>49.6493396048718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79C-4A47-89F4-556A651080C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2816128"/>
        <c:axId val="33096448"/>
      </c:scatterChart>
      <c:valAx>
        <c:axId val="3281612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096448"/>
        <c:crosses val="autoZero"/>
        <c:crossBetween val="midCat"/>
      </c:valAx>
      <c:valAx>
        <c:axId val="3309644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281612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sz="1862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sz="2000" b="1" i="0" u="none" strike="noStrike" kern="1200" spc="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BM-GY</a:t>
            </a:r>
          </a:p>
        </c:rich>
      </c:tx>
      <c:layout>
        <c:manualLayout>
          <c:xMode val="edge"/>
          <c:yMode val="edge"/>
          <c:x val="0.41660542432195974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sz="1862" b="0" i="0" u="none" strike="noStrike" kern="1200" spc="0" baseline="0">
              <a:solidFill>
                <a:prstClr val="black">
                  <a:lumMod val="65000"/>
                  <a:lumOff val="35000"/>
                </a:prst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Sheet1!$H$1</c:f>
              <c:strCache>
                <c:ptCount val="1"/>
                <c:pt idx="0">
                  <c:v>GY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0.11882309711286089"/>
                  <c:y val="-0.2280426752211529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 algn="ctr" rtl="0">
                      <a:defRPr sz="1197" b="0" i="0" u="none" strike="noStrike" kern="1200" baseline="0">
                        <a:solidFill>
                          <a:prstClr val="black">
                            <a:lumMod val="65000"/>
                            <a:lumOff val="35000"/>
                          </a:prst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rPr>
                      <a:t>y = 0.6059x - 17.97</a:t>
                    </a:r>
                    <a:b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rPr>
                    </a:br>
                    <a: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rPr>
                      <a:t>R² = 0.6156</a:t>
                    </a: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 algn="ctr" rtl="0">
                    <a:defRPr sz="1197" b="0" i="0" u="none" strike="noStrike" kern="1200" baseline="0">
                      <a:solidFill>
                        <a:prstClr val="black">
                          <a:lumMod val="65000"/>
                          <a:lumOff val="35000"/>
                        </a:prst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Sheet1!$E$2:$E$293</c:f>
              <c:numCache>
                <c:formatCode>0.00</c:formatCode>
                <c:ptCount val="292"/>
                <c:pt idx="0">
                  <c:v>131.78636537333901</c:v>
                </c:pt>
                <c:pt idx="1">
                  <c:v>105.75099531441199</c:v>
                </c:pt>
                <c:pt idx="2">
                  <c:v>102.66468808141801</c:v>
                </c:pt>
                <c:pt idx="3">
                  <c:v>141.39775625913501</c:v>
                </c:pt>
                <c:pt idx="4">
                  <c:v>106.51053288725601</c:v>
                </c:pt>
                <c:pt idx="5">
                  <c:v>114.90060212169701</c:v>
                </c:pt>
                <c:pt idx="6">
                  <c:v>128.64112512567101</c:v>
                </c:pt>
                <c:pt idx="7">
                  <c:v>125.786105583671</c:v>
                </c:pt>
                <c:pt idx="8">
                  <c:v>101.38150440689699</c:v>
                </c:pt>
                <c:pt idx="9">
                  <c:v>111.24629232698901</c:v>
                </c:pt>
                <c:pt idx="10">
                  <c:v>123.909710238404</c:v>
                </c:pt>
                <c:pt idx="11">
                  <c:v>116.325546199549</c:v>
                </c:pt>
                <c:pt idx="12">
                  <c:v>117.36496975404199</c:v>
                </c:pt>
                <c:pt idx="13">
                  <c:v>125.126366771646</c:v>
                </c:pt>
                <c:pt idx="14">
                  <c:v>110.894248078606</c:v>
                </c:pt>
                <c:pt idx="15">
                  <c:v>102.826241755917</c:v>
                </c:pt>
                <c:pt idx="16">
                  <c:v>108.763193839474</c:v>
                </c:pt>
                <c:pt idx="17">
                  <c:v>124.670055022338</c:v>
                </c:pt>
                <c:pt idx="18">
                  <c:v>127.239452714264</c:v>
                </c:pt>
                <c:pt idx="19">
                  <c:v>108.69996233507401</c:v>
                </c:pt>
                <c:pt idx="20">
                  <c:v>111.171887360489</c:v>
                </c:pt>
                <c:pt idx="21">
                  <c:v>99.361557954852799</c:v>
                </c:pt>
                <c:pt idx="22">
                  <c:v>130.668650528265</c:v>
                </c:pt>
                <c:pt idx="23">
                  <c:v>95.754328403281903</c:v>
                </c:pt>
                <c:pt idx="24">
                  <c:v>110.81008403077099</c:v>
                </c:pt>
                <c:pt idx="25">
                  <c:v>37.135672922070498</c:v>
                </c:pt>
                <c:pt idx="26">
                  <c:v>133.45281762322699</c:v>
                </c:pt>
                <c:pt idx="27">
                  <c:v>118.718799448322</c:v>
                </c:pt>
                <c:pt idx="28">
                  <c:v>116.775783228988</c:v>
                </c:pt>
                <c:pt idx="29">
                  <c:v>96.666037277899903</c:v>
                </c:pt>
                <c:pt idx="30">
                  <c:v>112.04539624172099</c:v>
                </c:pt>
                <c:pt idx="31">
                  <c:v>112.09669882308999</c:v>
                </c:pt>
                <c:pt idx="32">
                  <c:v>124.83428422348101</c:v>
                </c:pt>
                <c:pt idx="33">
                  <c:v>114.38471630446401</c:v>
                </c:pt>
                <c:pt idx="34">
                  <c:v>118.07205957072701</c:v>
                </c:pt>
                <c:pt idx="35">
                  <c:v>110.029831163548</c:v>
                </c:pt>
                <c:pt idx="36">
                  <c:v>124.218037135914</c:v>
                </c:pt>
                <c:pt idx="37">
                  <c:v>134.470434431353</c:v>
                </c:pt>
                <c:pt idx="38">
                  <c:v>114.433394577782</c:v>
                </c:pt>
                <c:pt idx="39">
                  <c:v>114.37872727313901</c:v>
                </c:pt>
                <c:pt idx="40">
                  <c:v>141.354178113367</c:v>
                </c:pt>
                <c:pt idx="41">
                  <c:v>124.935056873633</c:v>
                </c:pt>
                <c:pt idx="42">
                  <c:v>107.856486565168</c:v>
                </c:pt>
                <c:pt idx="43">
                  <c:v>92.420034920307003</c:v>
                </c:pt>
                <c:pt idx="44">
                  <c:v>122.954323693315</c:v>
                </c:pt>
                <c:pt idx="45">
                  <c:v>103.130512030247</c:v>
                </c:pt>
                <c:pt idx="46">
                  <c:v>84.112544597038706</c:v>
                </c:pt>
                <c:pt idx="47">
                  <c:v>135.64477077741799</c:v>
                </c:pt>
                <c:pt idx="48">
                  <c:v>132.30871655040301</c:v>
                </c:pt>
                <c:pt idx="49">
                  <c:v>109.94811186420399</c:v>
                </c:pt>
                <c:pt idx="50">
                  <c:v>115.83420241091601</c:v>
                </c:pt>
                <c:pt idx="51">
                  <c:v>101.476289553928</c:v>
                </c:pt>
                <c:pt idx="52">
                  <c:v>134.141490297708</c:v>
                </c:pt>
                <c:pt idx="53">
                  <c:v>136.719094641786</c:v>
                </c:pt>
                <c:pt idx="54">
                  <c:v>119.515549597597</c:v>
                </c:pt>
                <c:pt idx="55">
                  <c:v>133.904702473192</c:v>
                </c:pt>
                <c:pt idx="56">
                  <c:v>123.001965944554</c:v>
                </c:pt>
                <c:pt idx="57">
                  <c:v>118.39841380136799</c:v>
                </c:pt>
                <c:pt idx="58">
                  <c:v>125.550910320809</c:v>
                </c:pt>
                <c:pt idx="59">
                  <c:v>78.946904020685807</c:v>
                </c:pt>
                <c:pt idx="60">
                  <c:v>134.85262415999199</c:v>
                </c:pt>
                <c:pt idx="61">
                  <c:v>118.78713998708</c:v>
                </c:pt>
                <c:pt idx="62">
                  <c:v>110.748638720843</c:v>
                </c:pt>
                <c:pt idx="63">
                  <c:v>105.97162064399301</c:v>
                </c:pt>
                <c:pt idx="64">
                  <c:v>128.88205854245399</c:v>
                </c:pt>
                <c:pt idx="65">
                  <c:v>123.68075742308901</c:v>
                </c:pt>
                <c:pt idx="66">
                  <c:v>108.01699702451999</c:v>
                </c:pt>
                <c:pt idx="67">
                  <c:v>115.961438339355</c:v>
                </c:pt>
                <c:pt idx="68">
                  <c:v>116.005153077052</c:v>
                </c:pt>
                <c:pt idx="69">
                  <c:v>106.643849136661</c:v>
                </c:pt>
                <c:pt idx="70">
                  <c:v>87.003069486027101</c:v>
                </c:pt>
                <c:pt idx="71">
                  <c:v>94.484490372116895</c:v>
                </c:pt>
                <c:pt idx="72">
                  <c:v>119.18977182967799</c:v>
                </c:pt>
                <c:pt idx="73">
                  <c:v>112.36463910853</c:v>
                </c:pt>
                <c:pt idx="74">
                  <c:v>134.05408309239701</c:v>
                </c:pt>
                <c:pt idx="75">
                  <c:v>118.699248276679</c:v>
                </c:pt>
                <c:pt idx="76">
                  <c:v>129.46630946668299</c:v>
                </c:pt>
                <c:pt idx="77">
                  <c:v>116.374260289709</c:v>
                </c:pt>
                <c:pt idx="78">
                  <c:v>136.73643560212199</c:v>
                </c:pt>
                <c:pt idx="79">
                  <c:v>96.967805059115094</c:v>
                </c:pt>
                <c:pt idx="80">
                  <c:v>89.450192473218806</c:v>
                </c:pt>
                <c:pt idx="81">
                  <c:v>129.95148712540799</c:v>
                </c:pt>
                <c:pt idx="82">
                  <c:v>99.483557487011595</c:v>
                </c:pt>
                <c:pt idx="83">
                  <c:v>142.990874414621</c:v>
                </c:pt>
                <c:pt idx="84">
                  <c:v>123.590364129771</c:v>
                </c:pt>
                <c:pt idx="85">
                  <c:v>111.99220979565099</c:v>
                </c:pt>
                <c:pt idx="86">
                  <c:v>98.553144492782806</c:v>
                </c:pt>
                <c:pt idx="87">
                  <c:v>125.24530859133201</c:v>
                </c:pt>
                <c:pt idx="88">
                  <c:v>94.225536059193203</c:v>
                </c:pt>
                <c:pt idx="89">
                  <c:v>96.618690606154203</c:v>
                </c:pt>
                <c:pt idx="90">
                  <c:v>131.255029235622</c:v>
                </c:pt>
                <c:pt idx="91">
                  <c:v>118.70051179761499</c:v>
                </c:pt>
                <c:pt idx="92">
                  <c:v>131.65939563855801</c:v>
                </c:pt>
                <c:pt idx="93">
                  <c:v>114.612676016724</c:v>
                </c:pt>
                <c:pt idx="94">
                  <c:v>123.107370448737</c:v>
                </c:pt>
                <c:pt idx="95">
                  <c:v>109.047029629683</c:v>
                </c:pt>
                <c:pt idx="96">
                  <c:v>118.583641052698</c:v>
                </c:pt>
                <c:pt idx="97">
                  <c:v>121.11597457763899</c:v>
                </c:pt>
                <c:pt idx="98">
                  <c:v>118.17525861905899</c:v>
                </c:pt>
                <c:pt idx="99">
                  <c:v>108.49235039123</c:v>
                </c:pt>
                <c:pt idx="100">
                  <c:v>130.558711796594</c:v>
                </c:pt>
                <c:pt idx="101">
                  <c:v>114.83160429082599</c:v>
                </c:pt>
                <c:pt idx="102">
                  <c:v>121.294291353406</c:v>
                </c:pt>
                <c:pt idx="103">
                  <c:v>126.630719494228</c:v>
                </c:pt>
                <c:pt idx="104">
                  <c:v>121.109556195902</c:v>
                </c:pt>
                <c:pt idx="105">
                  <c:v>109.584314918876</c:v>
                </c:pt>
                <c:pt idx="106">
                  <c:v>138.73342119664201</c:v>
                </c:pt>
                <c:pt idx="107">
                  <c:v>126.81784283349999</c:v>
                </c:pt>
                <c:pt idx="108">
                  <c:v>122.20682880292</c:v>
                </c:pt>
                <c:pt idx="109">
                  <c:v>157.48692523571401</c:v>
                </c:pt>
                <c:pt idx="110">
                  <c:v>127.63227670928499</c:v>
                </c:pt>
                <c:pt idx="111">
                  <c:v>122.071606150104</c:v>
                </c:pt>
                <c:pt idx="112">
                  <c:v>133.672809666635</c:v>
                </c:pt>
                <c:pt idx="113">
                  <c:v>120.13717046747099</c:v>
                </c:pt>
                <c:pt idx="114">
                  <c:v>102.257261049495</c:v>
                </c:pt>
                <c:pt idx="115">
                  <c:v>124.71541998572501</c:v>
                </c:pt>
                <c:pt idx="116">
                  <c:v>117.77125416713901</c:v>
                </c:pt>
                <c:pt idx="117">
                  <c:v>104.393508127863</c:v>
                </c:pt>
                <c:pt idx="118">
                  <c:v>110.73802732590499</c:v>
                </c:pt>
                <c:pt idx="119">
                  <c:v>107.362485220065</c:v>
                </c:pt>
                <c:pt idx="120">
                  <c:v>129.17856170146001</c:v>
                </c:pt>
                <c:pt idx="121">
                  <c:v>104.51135729200701</c:v>
                </c:pt>
                <c:pt idx="122">
                  <c:v>106.605392083</c:v>
                </c:pt>
                <c:pt idx="123">
                  <c:v>123.59144741670799</c:v>
                </c:pt>
                <c:pt idx="124">
                  <c:v>127.81888040866799</c:v>
                </c:pt>
                <c:pt idx="125">
                  <c:v>118.284774419879</c:v>
                </c:pt>
                <c:pt idx="126">
                  <c:v>128.00044889249199</c:v>
                </c:pt>
                <c:pt idx="127">
                  <c:v>135.23708747555099</c:v>
                </c:pt>
                <c:pt idx="128">
                  <c:v>124.520264186623</c:v>
                </c:pt>
                <c:pt idx="129">
                  <c:v>118.48486671333001</c:v>
                </c:pt>
                <c:pt idx="130">
                  <c:v>124.47056181018699</c:v>
                </c:pt>
                <c:pt idx="131">
                  <c:v>122.452426660798</c:v>
                </c:pt>
                <c:pt idx="132">
                  <c:v>119.830525283783</c:v>
                </c:pt>
                <c:pt idx="133">
                  <c:v>122.45597463094001</c:v>
                </c:pt>
                <c:pt idx="134">
                  <c:v>137.24685683975301</c:v>
                </c:pt>
                <c:pt idx="135">
                  <c:v>119.75036306979</c:v>
                </c:pt>
                <c:pt idx="136">
                  <c:v>137.17133628562101</c:v>
                </c:pt>
                <c:pt idx="137">
                  <c:v>136.180449217839</c:v>
                </c:pt>
                <c:pt idx="138">
                  <c:v>105.64056443879601</c:v>
                </c:pt>
                <c:pt idx="139">
                  <c:v>135.12507306661399</c:v>
                </c:pt>
                <c:pt idx="140">
                  <c:v>118.747247472962</c:v>
                </c:pt>
                <c:pt idx="141">
                  <c:v>118.677869276522</c:v>
                </c:pt>
                <c:pt idx="142">
                  <c:v>111.504366967151</c:v>
                </c:pt>
                <c:pt idx="143">
                  <c:v>124.95166183837399</c:v>
                </c:pt>
                <c:pt idx="144">
                  <c:v>121.477920631795</c:v>
                </c:pt>
                <c:pt idx="145">
                  <c:v>129.036683903138</c:v>
                </c:pt>
                <c:pt idx="146">
                  <c:v>111.56246055264199</c:v>
                </c:pt>
                <c:pt idx="147">
                  <c:v>119.774302619525</c:v>
                </c:pt>
                <c:pt idx="148">
                  <c:v>120.28305517293499</c:v>
                </c:pt>
                <c:pt idx="149">
                  <c:v>115.68182671183401</c:v>
                </c:pt>
                <c:pt idx="150">
                  <c:v>136.66410948813001</c:v>
                </c:pt>
                <c:pt idx="151">
                  <c:v>134.56476371811101</c:v>
                </c:pt>
                <c:pt idx="152">
                  <c:v>138.96251574299299</c:v>
                </c:pt>
                <c:pt idx="153">
                  <c:v>109.907965952616</c:v>
                </c:pt>
                <c:pt idx="154">
                  <c:v>106.721877805261</c:v>
                </c:pt>
                <c:pt idx="155">
                  <c:v>103.96900745531001</c:v>
                </c:pt>
                <c:pt idx="156">
                  <c:v>110.62582295335601</c:v>
                </c:pt>
                <c:pt idx="157">
                  <c:v>112.059714296175</c:v>
                </c:pt>
                <c:pt idx="158">
                  <c:v>123.657674352074</c:v>
                </c:pt>
                <c:pt idx="159">
                  <c:v>118.28998729188601</c:v>
                </c:pt>
                <c:pt idx="160">
                  <c:v>136.797884398543</c:v>
                </c:pt>
                <c:pt idx="161">
                  <c:v>111.632590219544</c:v>
                </c:pt>
                <c:pt idx="162">
                  <c:v>119.82040341502</c:v>
                </c:pt>
                <c:pt idx="163">
                  <c:v>146.07798376778001</c:v>
                </c:pt>
                <c:pt idx="164">
                  <c:v>120.70857498941901</c:v>
                </c:pt>
                <c:pt idx="165">
                  <c:v>133.62131194810399</c:v>
                </c:pt>
                <c:pt idx="166">
                  <c:v>120.490121629787</c:v>
                </c:pt>
                <c:pt idx="167">
                  <c:v>94.749140580863497</c:v>
                </c:pt>
                <c:pt idx="168">
                  <c:v>135.29057065117499</c:v>
                </c:pt>
                <c:pt idx="169">
                  <c:v>114.68424223452099</c:v>
                </c:pt>
                <c:pt idx="170">
                  <c:v>118.197909612603</c:v>
                </c:pt>
                <c:pt idx="171">
                  <c:v>121.62540198812199</c:v>
                </c:pt>
                <c:pt idx="172">
                  <c:v>119.413655793681</c:v>
                </c:pt>
                <c:pt idx="173">
                  <c:v>110.548204075051</c:v>
                </c:pt>
                <c:pt idx="174">
                  <c:v>146.18154745949801</c:v>
                </c:pt>
                <c:pt idx="175">
                  <c:v>117.29142667628901</c:v>
                </c:pt>
                <c:pt idx="176">
                  <c:v>111.877630157146</c:v>
                </c:pt>
                <c:pt idx="177">
                  <c:v>136.72294302375599</c:v>
                </c:pt>
                <c:pt idx="178">
                  <c:v>120.407681298504</c:v>
                </c:pt>
                <c:pt idx="179">
                  <c:v>126.04543514427399</c:v>
                </c:pt>
                <c:pt idx="180">
                  <c:v>122.26773446697</c:v>
                </c:pt>
                <c:pt idx="181">
                  <c:v>105.46340561</c:v>
                </c:pt>
                <c:pt idx="182">
                  <c:v>115.70770739226199</c:v>
                </c:pt>
                <c:pt idx="183">
                  <c:v>82.351376833488203</c:v>
                </c:pt>
                <c:pt idx="184">
                  <c:v>130.712896968146</c:v>
                </c:pt>
                <c:pt idx="185">
                  <c:v>116.399286808241</c:v>
                </c:pt>
                <c:pt idx="186">
                  <c:v>108.291696743831</c:v>
                </c:pt>
                <c:pt idx="187">
                  <c:v>135.265803833566</c:v>
                </c:pt>
                <c:pt idx="188">
                  <c:v>114.029881283736</c:v>
                </c:pt>
                <c:pt idx="189">
                  <c:v>108.38136109700601</c:v>
                </c:pt>
                <c:pt idx="190">
                  <c:v>122.755799480985</c:v>
                </c:pt>
                <c:pt idx="191">
                  <c:v>109.13065416375299</c:v>
                </c:pt>
                <c:pt idx="192">
                  <c:v>130.231423196956</c:v>
                </c:pt>
                <c:pt idx="193">
                  <c:v>119.228424876788</c:v>
                </c:pt>
                <c:pt idx="194">
                  <c:v>113.95568075572299</c:v>
                </c:pt>
                <c:pt idx="195">
                  <c:v>115.643371028546</c:v>
                </c:pt>
                <c:pt idx="196">
                  <c:v>116.101797845223</c:v>
                </c:pt>
                <c:pt idx="197">
                  <c:v>117.478307034026</c:v>
                </c:pt>
                <c:pt idx="198">
                  <c:v>136.739622683672</c:v>
                </c:pt>
                <c:pt idx="199">
                  <c:v>125.865101470957</c:v>
                </c:pt>
                <c:pt idx="200">
                  <c:v>108.690851017809</c:v>
                </c:pt>
                <c:pt idx="201">
                  <c:v>132.475283248956</c:v>
                </c:pt>
                <c:pt idx="202">
                  <c:v>122.20625643300799</c:v>
                </c:pt>
                <c:pt idx="203">
                  <c:v>114.70110252019199</c:v>
                </c:pt>
                <c:pt idx="204">
                  <c:v>110.215149608876</c:v>
                </c:pt>
                <c:pt idx="205">
                  <c:v>103.439566407562</c:v>
                </c:pt>
                <c:pt idx="206">
                  <c:v>130.59631167556199</c:v>
                </c:pt>
                <c:pt idx="207">
                  <c:v>100.965694148471</c:v>
                </c:pt>
                <c:pt idx="208">
                  <c:v>126.68795961898699</c:v>
                </c:pt>
                <c:pt idx="209">
                  <c:v>117.754118904093</c:v>
                </c:pt>
                <c:pt idx="210">
                  <c:v>127.06074387633601</c:v>
                </c:pt>
                <c:pt idx="211">
                  <c:v>117.664618738044</c:v>
                </c:pt>
                <c:pt idx="212">
                  <c:v>144.754338577184</c:v>
                </c:pt>
                <c:pt idx="213">
                  <c:v>95.615730142758693</c:v>
                </c:pt>
                <c:pt idx="214">
                  <c:v>126.06599402599601</c:v>
                </c:pt>
                <c:pt idx="215">
                  <c:v>131.084089532924</c:v>
                </c:pt>
                <c:pt idx="216">
                  <c:v>88.746687471106299</c:v>
                </c:pt>
                <c:pt idx="217">
                  <c:v>91.708028298856405</c:v>
                </c:pt>
                <c:pt idx="218">
                  <c:v>112.73433297296999</c:v>
                </c:pt>
                <c:pt idx="219">
                  <c:v>127.716470373672</c:v>
                </c:pt>
                <c:pt idx="220">
                  <c:v>102.164741573993</c:v>
                </c:pt>
                <c:pt idx="221">
                  <c:v>113.461481384465</c:v>
                </c:pt>
                <c:pt idx="222">
                  <c:v>107.33461720739101</c:v>
                </c:pt>
                <c:pt idx="223">
                  <c:v>102.87947622886099</c:v>
                </c:pt>
                <c:pt idx="224">
                  <c:v>112.882773526053</c:v>
                </c:pt>
                <c:pt idx="225">
                  <c:v>142.80970276122099</c:v>
                </c:pt>
                <c:pt idx="226">
                  <c:v>93.409925948397998</c:v>
                </c:pt>
                <c:pt idx="227">
                  <c:v>92.229640446074598</c:v>
                </c:pt>
                <c:pt idx="228">
                  <c:v>130.58883224474599</c:v>
                </c:pt>
                <c:pt idx="229">
                  <c:v>132.902578264059</c:v>
                </c:pt>
                <c:pt idx="230">
                  <c:v>137.895121314307</c:v>
                </c:pt>
                <c:pt idx="231">
                  <c:v>104.05408430725601</c:v>
                </c:pt>
                <c:pt idx="232">
                  <c:v>114.88355253511899</c:v>
                </c:pt>
                <c:pt idx="233">
                  <c:v>126.484789216983</c:v>
                </c:pt>
                <c:pt idx="234">
                  <c:v>118.469191724425</c:v>
                </c:pt>
                <c:pt idx="235">
                  <c:v>123.974949521613</c:v>
                </c:pt>
                <c:pt idx="236">
                  <c:v>115.85954652096601</c:v>
                </c:pt>
                <c:pt idx="237">
                  <c:v>99.280437579676004</c:v>
                </c:pt>
                <c:pt idx="238">
                  <c:v>137.71839706403799</c:v>
                </c:pt>
                <c:pt idx="239">
                  <c:v>109.26823576957899</c:v>
                </c:pt>
                <c:pt idx="240">
                  <c:v>101.700551795642</c:v>
                </c:pt>
                <c:pt idx="241">
                  <c:v>127.915434749646</c:v>
                </c:pt>
                <c:pt idx="242">
                  <c:v>113.56057982508899</c:v>
                </c:pt>
                <c:pt idx="243">
                  <c:v>129.74178057742901</c:v>
                </c:pt>
                <c:pt idx="244">
                  <c:v>95.304265797238898</c:v>
                </c:pt>
                <c:pt idx="245">
                  <c:v>107.85649391778399</c:v>
                </c:pt>
                <c:pt idx="246">
                  <c:v>131.04547697435299</c:v>
                </c:pt>
                <c:pt idx="247">
                  <c:v>81.542446491821593</c:v>
                </c:pt>
                <c:pt idx="248">
                  <c:v>134.57061674776301</c:v>
                </c:pt>
                <c:pt idx="249">
                  <c:v>128.878620958526</c:v>
                </c:pt>
                <c:pt idx="250">
                  <c:v>103.77898971109499</c:v>
                </c:pt>
                <c:pt idx="251">
                  <c:v>104.368399979594</c:v>
                </c:pt>
                <c:pt idx="252">
                  <c:v>115.998708151457</c:v>
                </c:pt>
                <c:pt idx="253">
                  <c:v>104.163075823893</c:v>
                </c:pt>
                <c:pt idx="254">
                  <c:v>143.913948822522</c:v>
                </c:pt>
                <c:pt idx="255">
                  <c:v>87.846766591164197</c:v>
                </c:pt>
                <c:pt idx="256">
                  <c:v>107.943510372041</c:v>
                </c:pt>
                <c:pt idx="257">
                  <c:v>120.003870642735</c:v>
                </c:pt>
                <c:pt idx="258">
                  <c:v>123.793364838648</c:v>
                </c:pt>
                <c:pt idx="259">
                  <c:v>100.084486358551</c:v>
                </c:pt>
                <c:pt idx="260">
                  <c:v>112.285232826081</c:v>
                </c:pt>
                <c:pt idx="261">
                  <c:v>101.632444938096</c:v>
                </c:pt>
                <c:pt idx="262">
                  <c:v>109.76236614343399</c:v>
                </c:pt>
                <c:pt idx="263">
                  <c:v>106.164860194196</c:v>
                </c:pt>
                <c:pt idx="264">
                  <c:v>97.162451808183107</c:v>
                </c:pt>
                <c:pt idx="265">
                  <c:v>134.81186621233999</c:v>
                </c:pt>
                <c:pt idx="266">
                  <c:v>118.65356834047</c:v>
                </c:pt>
                <c:pt idx="267">
                  <c:v>106.38486652130401</c:v>
                </c:pt>
                <c:pt idx="268">
                  <c:v>98.525586629546197</c:v>
                </c:pt>
                <c:pt idx="269">
                  <c:v>108.493960633158</c:v>
                </c:pt>
                <c:pt idx="270">
                  <c:v>107.058900065835</c:v>
                </c:pt>
                <c:pt idx="271">
                  <c:v>118.08548747121</c:v>
                </c:pt>
                <c:pt idx="272">
                  <c:v>92.840279066036999</c:v>
                </c:pt>
                <c:pt idx="273">
                  <c:v>120.968392909527</c:v>
                </c:pt>
                <c:pt idx="274">
                  <c:v>122.68466943758899</c:v>
                </c:pt>
                <c:pt idx="275">
                  <c:v>115.669450265715</c:v>
                </c:pt>
                <c:pt idx="276">
                  <c:v>102.307476408486</c:v>
                </c:pt>
                <c:pt idx="277">
                  <c:v>123.78256027409699</c:v>
                </c:pt>
                <c:pt idx="278">
                  <c:v>109.912511129352</c:v>
                </c:pt>
                <c:pt idx="279">
                  <c:v>104.061417713105</c:v>
                </c:pt>
                <c:pt idx="280">
                  <c:v>119.021064175966</c:v>
                </c:pt>
                <c:pt idx="281">
                  <c:v>128.255560928839</c:v>
                </c:pt>
                <c:pt idx="282">
                  <c:v>125.179391966331</c:v>
                </c:pt>
                <c:pt idx="283">
                  <c:v>112.861956063902</c:v>
                </c:pt>
                <c:pt idx="284">
                  <c:v>122.741568607262</c:v>
                </c:pt>
                <c:pt idx="285">
                  <c:v>125.775377263431</c:v>
                </c:pt>
                <c:pt idx="286">
                  <c:v>100.197483818668</c:v>
                </c:pt>
                <c:pt idx="287">
                  <c:v>136.93989231059999</c:v>
                </c:pt>
                <c:pt idx="288">
                  <c:v>110.20898381106799</c:v>
                </c:pt>
                <c:pt idx="289">
                  <c:v>133.43598492543799</c:v>
                </c:pt>
                <c:pt idx="290">
                  <c:v>133.84033492647899</c:v>
                </c:pt>
                <c:pt idx="291">
                  <c:v>111.545272727887</c:v>
                </c:pt>
              </c:numCache>
            </c:numRef>
          </c:xVal>
          <c:yVal>
            <c:numRef>
              <c:f>Sheet1!$H$2:$H$293</c:f>
              <c:numCache>
                <c:formatCode>0.00</c:formatCode>
                <c:ptCount val="292"/>
                <c:pt idx="0">
                  <c:v>56.972077100385398</c:v>
                </c:pt>
                <c:pt idx="1">
                  <c:v>50.274495062583703</c:v>
                </c:pt>
                <c:pt idx="2">
                  <c:v>51.893962270069103</c:v>
                </c:pt>
                <c:pt idx="3">
                  <c:v>71.713090752602795</c:v>
                </c:pt>
                <c:pt idx="4">
                  <c:v>50.053466729707203</c:v>
                </c:pt>
                <c:pt idx="5">
                  <c:v>57.995876173584897</c:v>
                </c:pt>
                <c:pt idx="6">
                  <c:v>61.7723183678198</c:v>
                </c:pt>
                <c:pt idx="7">
                  <c:v>61.180472178970199</c:v>
                </c:pt>
                <c:pt idx="8">
                  <c:v>44.037192089527601</c:v>
                </c:pt>
                <c:pt idx="9">
                  <c:v>50.879199692966601</c:v>
                </c:pt>
                <c:pt idx="10">
                  <c:v>50.302686169060799</c:v>
                </c:pt>
                <c:pt idx="11">
                  <c:v>54.101407795382499</c:v>
                </c:pt>
                <c:pt idx="12">
                  <c:v>56.347289590662399</c:v>
                </c:pt>
                <c:pt idx="13">
                  <c:v>56.779356748393703</c:v>
                </c:pt>
                <c:pt idx="14">
                  <c:v>47.872790316589096</c:v>
                </c:pt>
                <c:pt idx="15">
                  <c:v>46.936973608139702</c:v>
                </c:pt>
                <c:pt idx="16">
                  <c:v>42.991609451018903</c:v>
                </c:pt>
                <c:pt idx="17">
                  <c:v>53.781982524356799</c:v>
                </c:pt>
                <c:pt idx="18">
                  <c:v>56.869674615574503</c:v>
                </c:pt>
                <c:pt idx="19">
                  <c:v>53.646277321138598</c:v>
                </c:pt>
                <c:pt idx="20">
                  <c:v>48.098484237270803</c:v>
                </c:pt>
                <c:pt idx="21">
                  <c:v>40.027290026322</c:v>
                </c:pt>
                <c:pt idx="22">
                  <c:v>54.007265579851101</c:v>
                </c:pt>
                <c:pt idx="23">
                  <c:v>44.144985457485802</c:v>
                </c:pt>
                <c:pt idx="24">
                  <c:v>53.762647668883702</c:v>
                </c:pt>
                <c:pt idx="25">
                  <c:v>9.0131931736008006</c:v>
                </c:pt>
                <c:pt idx="26">
                  <c:v>52.398549481149097</c:v>
                </c:pt>
                <c:pt idx="27">
                  <c:v>57.434719609964901</c:v>
                </c:pt>
                <c:pt idx="28">
                  <c:v>47.967287803390398</c:v>
                </c:pt>
                <c:pt idx="29">
                  <c:v>36.310119942835698</c:v>
                </c:pt>
                <c:pt idx="30">
                  <c:v>55.676408319631101</c:v>
                </c:pt>
                <c:pt idx="31">
                  <c:v>48.581742345490099</c:v>
                </c:pt>
                <c:pt idx="32">
                  <c:v>62.594002300875502</c:v>
                </c:pt>
                <c:pt idx="33">
                  <c:v>59.854779654009597</c:v>
                </c:pt>
                <c:pt idx="34">
                  <c:v>54.451483677633703</c:v>
                </c:pt>
                <c:pt idx="35">
                  <c:v>38.007132229040202</c:v>
                </c:pt>
                <c:pt idx="36">
                  <c:v>62.626498851359003</c:v>
                </c:pt>
                <c:pt idx="37">
                  <c:v>57.662376091029998</c:v>
                </c:pt>
                <c:pt idx="38">
                  <c:v>53.879139369179299</c:v>
                </c:pt>
                <c:pt idx="39">
                  <c:v>55.809472138745598</c:v>
                </c:pt>
                <c:pt idx="40">
                  <c:v>58.794624656558298</c:v>
                </c:pt>
                <c:pt idx="41">
                  <c:v>60.375381862704003</c:v>
                </c:pt>
                <c:pt idx="42">
                  <c:v>41.696600406779197</c:v>
                </c:pt>
                <c:pt idx="43">
                  <c:v>26.2433277633552</c:v>
                </c:pt>
                <c:pt idx="44">
                  <c:v>58.641955807548101</c:v>
                </c:pt>
                <c:pt idx="45">
                  <c:v>36.4543313130388</c:v>
                </c:pt>
                <c:pt idx="46">
                  <c:v>21.785192929797201</c:v>
                </c:pt>
                <c:pt idx="47">
                  <c:v>64.993278644278902</c:v>
                </c:pt>
                <c:pt idx="48">
                  <c:v>61.614071168195402</c:v>
                </c:pt>
                <c:pt idx="49">
                  <c:v>49.677969121519403</c:v>
                </c:pt>
                <c:pt idx="50">
                  <c:v>47.505857965697899</c:v>
                </c:pt>
                <c:pt idx="51">
                  <c:v>38.737598262460899</c:v>
                </c:pt>
                <c:pt idx="52">
                  <c:v>70.781531285897103</c:v>
                </c:pt>
                <c:pt idx="53">
                  <c:v>62.907709950822202</c:v>
                </c:pt>
                <c:pt idx="54">
                  <c:v>61.335014178162801</c:v>
                </c:pt>
                <c:pt idx="55">
                  <c:v>56.919721777076802</c:v>
                </c:pt>
                <c:pt idx="56">
                  <c:v>52.448920107840401</c:v>
                </c:pt>
                <c:pt idx="57">
                  <c:v>49.935286212189098</c:v>
                </c:pt>
                <c:pt idx="58">
                  <c:v>52.909163062357997</c:v>
                </c:pt>
                <c:pt idx="59">
                  <c:v>28.537327549817299</c:v>
                </c:pt>
                <c:pt idx="60">
                  <c:v>72.2613551862256</c:v>
                </c:pt>
                <c:pt idx="61">
                  <c:v>55.991890964098801</c:v>
                </c:pt>
                <c:pt idx="62">
                  <c:v>56.114212597211299</c:v>
                </c:pt>
                <c:pt idx="63">
                  <c:v>27.575735701159999</c:v>
                </c:pt>
                <c:pt idx="64">
                  <c:v>55.569873870355202</c:v>
                </c:pt>
                <c:pt idx="65">
                  <c:v>53.895857340886302</c:v>
                </c:pt>
                <c:pt idx="66">
                  <c:v>49.875933443380902</c:v>
                </c:pt>
                <c:pt idx="67">
                  <c:v>46.410331813190403</c:v>
                </c:pt>
                <c:pt idx="68">
                  <c:v>38.706625116673301</c:v>
                </c:pt>
                <c:pt idx="69">
                  <c:v>49.195967025716698</c:v>
                </c:pt>
                <c:pt idx="70">
                  <c:v>26.5962564349357</c:v>
                </c:pt>
                <c:pt idx="71">
                  <c:v>29.163189362389101</c:v>
                </c:pt>
                <c:pt idx="72">
                  <c:v>49.660122124788501</c:v>
                </c:pt>
                <c:pt idx="73">
                  <c:v>42.178618792316598</c:v>
                </c:pt>
                <c:pt idx="74">
                  <c:v>82.350829867282002</c:v>
                </c:pt>
                <c:pt idx="75">
                  <c:v>60.671912046148798</c:v>
                </c:pt>
                <c:pt idx="76">
                  <c:v>60.504169400802198</c:v>
                </c:pt>
                <c:pt idx="77">
                  <c:v>48.896858626788699</c:v>
                </c:pt>
                <c:pt idx="78">
                  <c:v>63.628476899675597</c:v>
                </c:pt>
                <c:pt idx="79">
                  <c:v>34.696388549660398</c:v>
                </c:pt>
                <c:pt idx="80">
                  <c:v>42.325771435721897</c:v>
                </c:pt>
                <c:pt idx="81">
                  <c:v>77.710995594919694</c:v>
                </c:pt>
                <c:pt idx="82">
                  <c:v>41.556897161641103</c:v>
                </c:pt>
                <c:pt idx="83">
                  <c:v>59.164431243312002</c:v>
                </c:pt>
                <c:pt idx="84">
                  <c:v>56.008452316598699</c:v>
                </c:pt>
                <c:pt idx="85">
                  <c:v>44.163139359274098</c:v>
                </c:pt>
                <c:pt idx="86">
                  <c:v>41.953259237189698</c:v>
                </c:pt>
                <c:pt idx="87">
                  <c:v>40.528014882408897</c:v>
                </c:pt>
                <c:pt idx="88">
                  <c:v>35.529732105963497</c:v>
                </c:pt>
                <c:pt idx="89">
                  <c:v>42.404185261799498</c:v>
                </c:pt>
                <c:pt idx="90">
                  <c:v>52.576625844025799</c:v>
                </c:pt>
                <c:pt idx="91">
                  <c:v>51.104169695579998</c:v>
                </c:pt>
                <c:pt idx="92">
                  <c:v>55.760705799723297</c:v>
                </c:pt>
                <c:pt idx="93">
                  <c:v>54.631439628722099</c:v>
                </c:pt>
                <c:pt idx="94">
                  <c:v>58.180254171333502</c:v>
                </c:pt>
                <c:pt idx="95">
                  <c:v>45.070798536212799</c:v>
                </c:pt>
                <c:pt idx="96">
                  <c:v>47.922707330841099</c:v>
                </c:pt>
                <c:pt idx="97">
                  <c:v>54.428116453079099</c:v>
                </c:pt>
                <c:pt idx="98">
                  <c:v>58.625309188636201</c:v>
                </c:pt>
                <c:pt idx="99">
                  <c:v>59.299487585082801</c:v>
                </c:pt>
                <c:pt idx="100">
                  <c:v>60.443382341604</c:v>
                </c:pt>
                <c:pt idx="101">
                  <c:v>47.891579937556301</c:v>
                </c:pt>
                <c:pt idx="102">
                  <c:v>64.870201651673696</c:v>
                </c:pt>
                <c:pt idx="103">
                  <c:v>53.223518046519999</c:v>
                </c:pt>
                <c:pt idx="104">
                  <c:v>58.926591542835297</c:v>
                </c:pt>
                <c:pt idx="105">
                  <c:v>48.721980122787798</c:v>
                </c:pt>
                <c:pt idx="106">
                  <c:v>59.578476197647198</c:v>
                </c:pt>
                <c:pt idx="107">
                  <c:v>58.823210911687397</c:v>
                </c:pt>
                <c:pt idx="108">
                  <c:v>56.118116021475402</c:v>
                </c:pt>
                <c:pt idx="109">
                  <c:v>61.316908802032501</c:v>
                </c:pt>
                <c:pt idx="110">
                  <c:v>58.807713792167696</c:v>
                </c:pt>
                <c:pt idx="111">
                  <c:v>49.9405798905712</c:v>
                </c:pt>
                <c:pt idx="112">
                  <c:v>48.235066642264101</c:v>
                </c:pt>
                <c:pt idx="113">
                  <c:v>61.0272653661861</c:v>
                </c:pt>
                <c:pt idx="114">
                  <c:v>45.281684756388103</c:v>
                </c:pt>
                <c:pt idx="115">
                  <c:v>67.459578250342005</c:v>
                </c:pt>
                <c:pt idx="116">
                  <c:v>59.086077576673397</c:v>
                </c:pt>
                <c:pt idx="117">
                  <c:v>43.254642058866999</c:v>
                </c:pt>
                <c:pt idx="118">
                  <c:v>53.600342353512502</c:v>
                </c:pt>
                <c:pt idx="119">
                  <c:v>43.791365948270297</c:v>
                </c:pt>
                <c:pt idx="120">
                  <c:v>58.663991372634399</c:v>
                </c:pt>
                <c:pt idx="121">
                  <c:v>46.274977903686903</c:v>
                </c:pt>
                <c:pt idx="122">
                  <c:v>48.8320315144001</c:v>
                </c:pt>
                <c:pt idx="123">
                  <c:v>70.647393984881703</c:v>
                </c:pt>
                <c:pt idx="124">
                  <c:v>58.8909029726642</c:v>
                </c:pt>
                <c:pt idx="125">
                  <c:v>51.267353876218799</c:v>
                </c:pt>
                <c:pt idx="126">
                  <c:v>63.742125779656497</c:v>
                </c:pt>
                <c:pt idx="127">
                  <c:v>67.928542553243503</c:v>
                </c:pt>
                <c:pt idx="128">
                  <c:v>71.563198014722801</c:v>
                </c:pt>
                <c:pt idx="129">
                  <c:v>59.757550948477999</c:v>
                </c:pt>
                <c:pt idx="130">
                  <c:v>64.022905187432698</c:v>
                </c:pt>
                <c:pt idx="131">
                  <c:v>60.165871537049298</c:v>
                </c:pt>
                <c:pt idx="132">
                  <c:v>51.3146924951781</c:v>
                </c:pt>
                <c:pt idx="133">
                  <c:v>48.590047888970197</c:v>
                </c:pt>
                <c:pt idx="134">
                  <c:v>58.565460347918403</c:v>
                </c:pt>
                <c:pt idx="135">
                  <c:v>64.668024867013898</c:v>
                </c:pt>
                <c:pt idx="136">
                  <c:v>50.876788832705003</c:v>
                </c:pt>
                <c:pt idx="137">
                  <c:v>63.8255387105796</c:v>
                </c:pt>
                <c:pt idx="138">
                  <c:v>43.244778023986598</c:v>
                </c:pt>
                <c:pt idx="139">
                  <c:v>53.201433081363099</c:v>
                </c:pt>
                <c:pt idx="140">
                  <c:v>56.090280126204803</c:v>
                </c:pt>
                <c:pt idx="141">
                  <c:v>49.327301478742903</c:v>
                </c:pt>
                <c:pt idx="142">
                  <c:v>45.867252173397702</c:v>
                </c:pt>
                <c:pt idx="143">
                  <c:v>60.428261133375401</c:v>
                </c:pt>
                <c:pt idx="144">
                  <c:v>67.807811681852698</c:v>
                </c:pt>
                <c:pt idx="145">
                  <c:v>60.341604093229101</c:v>
                </c:pt>
                <c:pt idx="146">
                  <c:v>59.637683669478598</c:v>
                </c:pt>
                <c:pt idx="147">
                  <c:v>61.627867827255599</c:v>
                </c:pt>
                <c:pt idx="148">
                  <c:v>59.646336852831503</c:v>
                </c:pt>
                <c:pt idx="149">
                  <c:v>54.526691443738599</c:v>
                </c:pt>
                <c:pt idx="150">
                  <c:v>75.192574075260097</c:v>
                </c:pt>
                <c:pt idx="151">
                  <c:v>56.211653337613498</c:v>
                </c:pt>
                <c:pt idx="152">
                  <c:v>70.755365941206904</c:v>
                </c:pt>
                <c:pt idx="153">
                  <c:v>38.263261949967102</c:v>
                </c:pt>
                <c:pt idx="154">
                  <c:v>48.285999914370201</c:v>
                </c:pt>
                <c:pt idx="155">
                  <c:v>52.756648017187402</c:v>
                </c:pt>
                <c:pt idx="156">
                  <c:v>42.940091936150701</c:v>
                </c:pt>
                <c:pt idx="157">
                  <c:v>48.846795373706797</c:v>
                </c:pt>
                <c:pt idx="158">
                  <c:v>68.432772068902096</c:v>
                </c:pt>
                <c:pt idx="159">
                  <c:v>56.331199751485201</c:v>
                </c:pt>
                <c:pt idx="160">
                  <c:v>71.093857241296703</c:v>
                </c:pt>
                <c:pt idx="161">
                  <c:v>47.748863438948298</c:v>
                </c:pt>
                <c:pt idx="162">
                  <c:v>63.590925967021498</c:v>
                </c:pt>
                <c:pt idx="163">
                  <c:v>76.906317291512295</c:v>
                </c:pt>
                <c:pt idx="164">
                  <c:v>68.764591385139994</c:v>
                </c:pt>
                <c:pt idx="165">
                  <c:v>62.580621989055103</c:v>
                </c:pt>
                <c:pt idx="166">
                  <c:v>52.228071213885002</c:v>
                </c:pt>
                <c:pt idx="167">
                  <c:v>37.058168369218301</c:v>
                </c:pt>
                <c:pt idx="168">
                  <c:v>67.903632284165994</c:v>
                </c:pt>
                <c:pt idx="169">
                  <c:v>52.162654764120902</c:v>
                </c:pt>
                <c:pt idx="170">
                  <c:v>52.260963102452898</c:v>
                </c:pt>
                <c:pt idx="171">
                  <c:v>51.999256572090097</c:v>
                </c:pt>
                <c:pt idx="172">
                  <c:v>51.488832163144302</c:v>
                </c:pt>
                <c:pt idx="173">
                  <c:v>49.009171785412299</c:v>
                </c:pt>
                <c:pt idx="174">
                  <c:v>67.635396416586602</c:v>
                </c:pt>
                <c:pt idx="175">
                  <c:v>52.979734934627999</c:v>
                </c:pt>
                <c:pt idx="176">
                  <c:v>43.989570135946799</c:v>
                </c:pt>
                <c:pt idx="177">
                  <c:v>70.651179203688301</c:v>
                </c:pt>
                <c:pt idx="178">
                  <c:v>53.847698009892</c:v>
                </c:pt>
                <c:pt idx="179">
                  <c:v>64.782492550404001</c:v>
                </c:pt>
                <c:pt idx="180">
                  <c:v>51.687388166452699</c:v>
                </c:pt>
                <c:pt idx="181">
                  <c:v>45.101457423431498</c:v>
                </c:pt>
                <c:pt idx="182">
                  <c:v>66.063912205334603</c:v>
                </c:pt>
                <c:pt idx="183">
                  <c:v>27.985881561136299</c:v>
                </c:pt>
                <c:pt idx="184">
                  <c:v>54.2592113810665</c:v>
                </c:pt>
                <c:pt idx="185">
                  <c:v>49.840392025159403</c:v>
                </c:pt>
                <c:pt idx="186">
                  <c:v>54.637563790980899</c:v>
                </c:pt>
                <c:pt idx="187">
                  <c:v>67.109259900192598</c:v>
                </c:pt>
                <c:pt idx="188">
                  <c:v>60.1512922151976</c:v>
                </c:pt>
                <c:pt idx="189">
                  <c:v>55.223437037876998</c:v>
                </c:pt>
                <c:pt idx="190">
                  <c:v>56.6625362807412</c:v>
                </c:pt>
                <c:pt idx="191">
                  <c:v>50.815543978080903</c:v>
                </c:pt>
                <c:pt idx="192">
                  <c:v>75.606846539182101</c:v>
                </c:pt>
                <c:pt idx="193">
                  <c:v>46.9869152627167</c:v>
                </c:pt>
                <c:pt idx="194">
                  <c:v>47.520139698214102</c:v>
                </c:pt>
                <c:pt idx="195">
                  <c:v>46.315987902472699</c:v>
                </c:pt>
                <c:pt idx="196">
                  <c:v>65.286724821380005</c:v>
                </c:pt>
                <c:pt idx="197">
                  <c:v>60.324440640246202</c:v>
                </c:pt>
                <c:pt idx="198">
                  <c:v>49.851426262169099</c:v>
                </c:pt>
                <c:pt idx="199">
                  <c:v>70.412289309144398</c:v>
                </c:pt>
                <c:pt idx="200">
                  <c:v>31.308167787830399</c:v>
                </c:pt>
                <c:pt idx="201">
                  <c:v>59.223889368471497</c:v>
                </c:pt>
                <c:pt idx="202">
                  <c:v>59.001077672024998</c:v>
                </c:pt>
                <c:pt idx="203">
                  <c:v>45.433091166193201</c:v>
                </c:pt>
                <c:pt idx="204">
                  <c:v>52.952952822794799</c:v>
                </c:pt>
                <c:pt idx="205">
                  <c:v>31.934683259602</c:v>
                </c:pt>
                <c:pt idx="206">
                  <c:v>66.971362683960507</c:v>
                </c:pt>
                <c:pt idx="207">
                  <c:v>36.096375649022903</c:v>
                </c:pt>
                <c:pt idx="208">
                  <c:v>59.6412817803471</c:v>
                </c:pt>
                <c:pt idx="209">
                  <c:v>54.790189522879302</c:v>
                </c:pt>
                <c:pt idx="210">
                  <c:v>60.826313233139203</c:v>
                </c:pt>
                <c:pt idx="211">
                  <c:v>51.9356854990369</c:v>
                </c:pt>
                <c:pt idx="212">
                  <c:v>59.065201713704496</c:v>
                </c:pt>
                <c:pt idx="213">
                  <c:v>42.242472159188097</c:v>
                </c:pt>
                <c:pt idx="214">
                  <c:v>54.472301503230803</c:v>
                </c:pt>
                <c:pt idx="215">
                  <c:v>60.259387955799703</c:v>
                </c:pt>
                <c:pt idx="216">
                  <c:v>30.868899475521101</c:v>
                </c:pt>
                <c:pt idx="217">
                  <c:v>36.894735270520798</c:v>
                </c:pt>
                <c:pt idx="218">
                  <c:v>45.606245925547803</c:v>
                </c:pt>
                <c:pt idx="219">
                  <c:v>55.843714523368703</c:v>
                </c:pt>
                <c:pt idx="220">
                  <c:v>31.155211776591798</c:v>
                </c:pt>
                <c:pt idx="221">
                  <c:v>50.748057305221799</c:v>
                </c:pt>
                <c:pt idx="222">
                  <c:v>58.0290247415492</c:v>
                </c:pt>
                <c:pt idx="223">
                  <c:v>41.000284984001802</c:v>
                </c:pt>
                <c:pt idx="224">
                  <c:v>54.068462339065903</c:v>
                </c:pt>
                <c:pt idx="225">
                  <c:v>69.137858767567394</c:v>
                </c:pt>
                <c:pt idx="226">
                  <c:v>42.990008479852499</c:v>
                </c:pt>
                <c:pt idx="227">
                  <c:v>33.499299100843501</c:v>
                </c:pt>
                <c:pt idx="228">
                  <c:v>59.083023540164099</c:v>
                </c:pt>
                <c:pt idx="229">
                  <c:v>54.401734980352202</c:v>
                </c:pt>
                <c:pt idx="230">
                  <c:v>70.983496962599801</c:v>
                </c:pt>
                <c:pt idx="231">
                  <c:v>42.280161391491198</c:v>
                </c:pt>
                <c:pt idx="232">
                  <c:v>56.883508068888702</c:v>
                </c:pt>
                <c:pt idx="233">
                  <c:v>57.0240135484378</c:v>
                </c:pt>
                <c:pt idx="234">
                  <c:v>57.955703235564201</c:v>
                </c:pt>
                <c:pt idx="235">
                  <c:v>43.5314750530246</c:v>
                </c:pt>
                <c:pt idx="236">
                  <c:v>50.664581374276104</c:v>
                </c:pt>
                <c:pt idx="237">
                  <c:v>36.603483778226597</c:v>
                </c:pt>
                <c:pt idx="238">
                  <c:v>54.4311322425566</c:v>
                </c:pt>
                <c:pt idx="239">
                  <c:v>40.939998979766997</c:v>
                </c:pt>
                <c:pt idx="240">
                  <c:v>49.660595598154899</c:v>
                </c:pt>
                <c:pt idx="241">
                  <c:v>49.263777346776102</c:v>
                </c:pt>
                <c:pt idx="242">
                  <c:v>51.011070271085302</c:v>
                </c:pt>
                <c:pt idx="243">
                  <c:v>66.610148000527403</c:v>
                </c:pt>
                <c:pt idx="244">
                  <c:v>47.972404582197399</c:v>
                </c:pt>
                <c:pt idx="245">
                  <c:v>61.1601612302223</c:v>
                </c:pt>
                <c:pt idx="246">
                  <c:v>60.026672189200603</c:v>
                </c:pt>
                <c:pt idx="247">
                  <c:v>21.7647749498853</c:v>
                </c:pt>
                <c:pt idx="248">
                  <c:v>58.572987816476598</c:v>
                </c:pt>
                <c:pt idx="249">
                  <c:v>52.5323875572468</c:v>
                </c:pt>
                <c:pt idx="250">
                  <c:v>52.998580150862303</c:v>
                </c:pt>
                <c:pt idx="251">
                  <c:v>54.4942167787001</c:v>
                </c:pt>
                <c:pt idx="252">
                  <c:v>49.855690965553698</c:v>
                </c:pt>
                <c:pt idx="253">
                  <c:v>58.956414858443502</c:v>
                </c:pt>
                <c:pt idx="254">
                  <c:v>76.731228560061794</c:v>
                </c:pt>
                <c:pt idx="255">
                  <c:v>27.240965868897799</c:v>
                </c:pt>
                <c:pt idx="256">
                  <c:v>50.909235898459002</c:v>
                </c:pt>
                <c:pt idx="257">
                  <c:v>68.736162365080204</c:v>
                </c:pt>
                <c:pt idx="258">
                  <c:v>73.733485074619594</c:v>
                </c:pt>
                <c:pt idx="259">
                  <c:v>46.551512182548699</c:v>
                </c:pt>
                <c:pt idx="260">
                  <c:v>53.482651487735303</c:v>
                </c:pt>
                <c:pt idx="261">
                  <c:v>39.100818098411203</c:v>
                </c:pt>
                <c:pt idx="262">
                  <c:v>51.214858763842997</c:v>
                </c:pt>
                <c:pt idx="263">
                  <c:v>46.053050275939199</c:v>
                </c:pt>
                <c:pt idx="264">
                  <c:v>35.825806557620197</c:v>
                </c:pt>
                <c:pt idx="265">
                  <c:v>62.783162679559901</c:v>
                </c:pt>
                <c:pt idx="266">
                  <c:v>46.514628516579599</c:v>
                </c:pt>
                <c:pt idx="267">
                  <c:v>53.995020481960999</c:v>
                </c:pt>
                <c:pt idx="268">
                  <c:v>43.071453824174398</c:v>
                </c:pt>
                <c:pt idx="269">
                  <c:v>49.074829233558397</c:v>
                </c:pt>
                <c:pt idx="270">
                  <c:v>49.765163778967398</c:v>
                </c:pt>
                <c:pt idx="271">
                  <c:v>61.623355253410502</c:v>
                </c:pt>
                <c:pt idx="272">
                  <c:v>32.918851551533301</c:v>
                </c:pt>
                <c:pt idx="273">
                  <c:v>43.388638800723101</c:v>
                </c:pt>
                <c:pt idx="274">
                  <c:v>60.609318615525503</c:v>
                </c:pt>
                <c:pt idx="275">
                  <c:v>63.064100310151197</c:v>
                </c:pt>
                <c:pt idx="276">
                  <c:v>32.4962147027219</c:v>
                </c:pt>
                <c:pt idx="277">
                  <c:v>58.957866142950202</c:v>
                </c:pt>
                <c:pt idx="278">
                  <c:v>41.316779690310597</c:v>
                </c:pt>
                <c:pt idx="279">
                  <c:v>52.326392150361897</c:v>
                </c:pt>
                <c:pt idx="280">
                  <c:v>62.787637125143704</c:v>
                </c:pt>
                <c:pt idx="281">
                  <c:v>64.568523738090605</c:v>
                </c:pt>
                <c:pt idx="282">
                  <c:v>58.071389846438898</c:v>
                </c:pt>
                <c:pt idx="283">
                  <c:v>51.754538072477203</c:v>
                </c:pt>
                <c:pt idx="284">
                  <c:v>55.174748251138801</c:v>
                </c:pt>
                <c:pt idx="285">
                  <c:v>53.095891989383297</c:v>
                </c:pt>
                <c:pt idx="286">
                  <c:v>44.844932333790403</c:v>
                </c:pt>
                <c:pt idx="287">
                  <c:v>69.430604336269397</c:v>
                </c:pt>
                <c:pt idx="288">
                  <c:v>58.472214987243703</c:v>
                </c:pt>
                <c:pt idx="289">
                  <c:v>59.932507698279501</c:v>
                </c:pt>
                <c:pt idx="290">
                  <c:v>59.966679205323103</c:v>
                </c:pt>
                <c:pt idx="291">
                  <c:v>49.6493396048718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2AC-4CEB-A28B-72AE6EF443E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2794880"/>
        <c:axId val="32808960"/>
      </c:scatterChart>
      <c:valAx>
        <c:axId val="3279488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2808960"/>
        <c:crosses val="autoZero"/>
        <c:crossBetween val="midCat"/>
      </c:valAx>
      <c:valAx>
        <c:axId val="3280896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279488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sz="1862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sz="2000" b="1" i="0" u="none" strike="noStrike" kern="1200" spc="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HI-GY</a:t>
            </a:r>
          </a:p>
        </c:rich>
      </c:tx>
      <c:layout>
        <c:manualLayout>
          <c:xMode val="edge"/>
          <c:yMode val="edge"/>
          <c:x val="0.41038897637795274"/>
          <c:y val="3.3068783068783067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sz="1862" b="0" i="0" u="none" strike="noStrike" kern="1200" spc="0" baseline="0">
              <a:solidFill>
                <a:prstClr val="black">
                  <a:lumMod val="65000"/>
                  <a:lumOff val="35000"/>
                </a:prst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Sheet1!$H$1</c:f>
              <c:strCache>
                <c:ptCount val="1"/>
                <c:pt idx="0">
                  <c:v>GY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0.14982327209098856"/>
                  <c:y val="-0.25540383840908776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 algn="ctr" rtl="0">
                      <a:defRPr sz="1197" b="0" i="0" u="none" strike="noStrike" kern="1200" baseline="0">
                        <a:solidFill>
                          <a:prstClr val="black">
                            <a:lumMod val="65000"/>
                            <a:lumOff val="35000"/>
                          </a:prst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rPr>
                      <a:t>y = 1.5573x - 18.224</a:t>
                    </a:r>
                    <a:b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rPr>
                    </a:br>
                    <a: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rPr>
                      <a:t>R² = 0.577</a:t>
                    </a: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 algn="ctr" rtl="0">
                    <a:defRPr sz="1197" b="0" i="0" u="none" strike="noStrike" kern="1200" baseline="0">
                      <a:solidFill>
                        <a:prstClr val="black">
                          <a:lumMod val="65000"/>
                          <a:lumOff val="35000"/>
                        </a:prst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Sheet1!$F$2:$F$293</c:f>
              <c:numCache>
                <c:formatCode>0.00</c:formatCode>
                <c:ptCount val="292"/>
                <c:pt idx="0">
                  <c:v>43.108115758851199</c:v>
                </c:pt>
                <c:pt idx="1">
                  <c:v>48.6581625146083</c:v>
                </c:pt>
                <c:pt idx="2">
                  <c:v>50.242933345376301</c:v>
                </c:pt>
                <c:pt idx="3">
                  <c:v>49.763954695163498</c:v>
                </c:pt>
                <c:pt idx="4">
                  <c:v>47.586939054786697</c:v>
                </c:pt>
                <c:pt idx="5">
                  <c:v>51.450895854163299</c:v>
                </c:pt>
                <c:pt idx="6">
                  <c:v>47.948828583721799</c:v>
                </c:pt>
                <c:pt idx="7">
                  <c:v>47.503369242118801</c:v>
                </c:pt>
                <c:pt idx="8">
                  <c:v>45.5074987851713</c:v>
                </c:pt>
                <c:pt idx="9">
                  <c:v>45.267474305075602</c:v>
                </c:pt>
                <c:pt idx="10">
                  <c:v>41.206121858147299</c:v>
                </c:pt>
                <c:pt idx="11">
                  <c:v>47.051209930342999</c:v>
                </c:pt>
                <c:pt idx="12">
                  <c:v>48.289502150707101</c:v>
                </c:pt>
                <c:pt idx="13">
                  <c:v>45.045683866374603</c:v>
                </c:pt>
                <c:pt idx="14">
                  <c:v>43.993608311543902</c:v>
                </c:pt>
                <c:pt idx="15">
                  <c:v>47.390006893569499</c:v>
                </c:pt>
                <c:pt idx="16">
                  <c:v>40.4755311843291</c:v>
                </c:pt>
                <c:pt idx="17">
                  <c:v>43.991358221523797</c:v>
                </c:pt>
                <c:pt idx="18">
                  <c:v>43.963161159791397</c:v>
                </c:pt>
                <c:pt idx="19">
                  <c:v>49.7956246287428</c:v>
                </c:pt>
                <c:pt idx="20">
                  <c:v>44.604393726966897</c:v>
                </c:pt>
                <c:pt idx="21">
                  <c:v>42.086489902443603</c:v>
                </c:pt>
                <c:pt idx="22">
                  <c:v>41.137931125172102</c:v>
                </c:pt>
                <c:pt idx="23">
                  <c:v>48.158803822324998</c:v>
                </c:pt>
                <c:pt idx="24">
                  <c:v>49.235091267023101</c:v>
                </c:pt>
                <c:pt idx="25">
                  <c:v>24.129684200680298</c:v>
                </c:pt>
                <c:pt idx="26">
                  <c:v>39.465025266235997</c:v>
                </c:pt>
                <c:pt idx="27">
                  <c:v>48.525328530150396</c:v>
                </c:pt>
                <c:pt idx="28">
                  <c:v>41.112387245295601</c:v>
                </c:pt>
                <c:pt idx="29">
                  <c:v>41.189763047321101</c:v>
                </c:pt>
                <c:pt idx="30">
                  <c:v>49.576706070122398</c:v>
                </c:pt>
                <c:pt idx="31">
                  <c:v>43.388376901352402</c:v>
                </c:pt>
                <c:pt idx="32">
                  <c:v>48.104002026444</c:v>
                </c:pt>
                <c:pt idx="33">
                  <c:v>52.8798541221459</c:v>
                </c:pt>
                <c:pt idx="34">
                  <c:v>46.536160003809002</c:v>
                </c:pt>
                <c:pt idx="35">
                  <c:v>37.405502442982403</c:v>
                </c:pt>
                <c:pt idx="36">
                  <c:v>50.234719456796</c:v>
                </c:pt>
                <c:pt idx="37">
                  <c:v>43.631269580974397</c:v>
                </c:pt>
                <c:pt idx="38">
                  <c:v>47.937228651746601</c:v>
                </c:pt>
                <c:pt idx="39">
                  <c:v>48.531993040388301</c:v>
                </c:pt>
                <c:pt idx="40">
                  <c:v>40.886340277768099</c:v>
                </c:pt>
                <c:pt idx="41">
                  <c:v>47.788613782763498</c:v>
                </c:pt>
                <c:pt idx="42">
                  <c:v>40.150581661129898</c:v>
                </c:pt>
                <c:pt idx="43">
                  <c:v>34.877960223420096</c:v>
                </c:pt>
                <c:pt idx="44">
                  <c:v>48.0918005201857</c:v>
                </c:pt>
                <c:pt idx="45">
                  <c:v>38.122604324640903</c:v>
                </c:pt>
                <c:pt idx="46">
                  <c:v>34.449622802251902</c:v>
                </c:pt>
                <c:pt idx="47">
                  <c:v>46.8053480916777</c:v>
                </c:pt>
                <c:pt idx="48">
                  <c:v>46.1469613744258</c:v>
                </c:pt>
                <c:pt idx="49">
                  <c:v>45.827685943184299</c:v>
                </c:pt>
                <c:pt idx="50">
                  <c:v>40.169820622726299</c:v>
                </c:pt>
                <c:pt idx="51">
                  <c:v>41.235039368490597</c:v>
                </c:pt>
                <c:pt idx="52">
                  <c:v>54.1298429775713</c:v>
                </c:pt>
                <c:pt idx="53">
                  <c:v>47.0524355665287</c:v>
                </c:pt>
                <c:pt idx="54">
                  <c:v>50.746576590368697</c:v>
                </c:pt>
                <c:pt idx="55">
                  <c:v>42.4390210778162</c:v>
                </c:pt>
                <c:pt idx="56">
                  <c:v>43.345350721474603</c:v>
                </c:pt>
                <c:pt idx="57">
                  <c:v>44.766148335363297</c:v>
                </c:pt>
                <c:pt idx="58">
                  <c:v>39.394937192668998</c:v>
                </c:pt>
                <c:pt idx="59">
                  <c:v>40.529512587383401</c:v>
                </c:pt>
                <c:pt idx="60">
                  <c:v>53.383383029131103</c:v>
                </c:pt>
                <c:pt idx="61">
                  <c:v>46.897194348896299</c:v>
                </c:pt>
                <c:pt idx="62">
                  <c:v>50.329514637376299</c:v>
                </c:pt>
                <c:pt idx="63">
                  <c:v>29.352510268052701</c:v>
                </c:pt>
                <c:pt idx="64">
                  <c:v>45.5248346519611</c:v>
                </c:pt>
                <c:pt idx="65">
                  <c:v>44.193929673021202</c:v>
                </c:pt>
                <c:pt idx="66">
                  <c:v>45.428686610197097</c:v>
                </c:pt>
                <c:pt idx="67">
                  <c:v>39.720390568356002</c:v>
                </c:pt>
                <c:pt idx="68">
                  <c:v>34.4196375048382</c:v>
                </c:pt>
                <c:pt idx="69">
                  <c:v>47.087587320826003</c:v>
                </c:pt>
                <c:pt idx="70">
                  <c:v>40.498267076624401</c:v>
                </c:pt>
                <c:pt idx="71">
                  <c:v>39.309474109274902</c:v>
                </c:pt>
                <c:pt idx="72">
                  <c:v>41.981976788127199</c:v>
                </c:pt>
                <c:pt idx="73">
                  <c:v>38.217601917481701</c:v>
                </c:pt>
                <c:pt idx="74">
                  <c:v>58.702612540175402</c:v>
                </c:pt>
                <c:pt idx="75">
                  <c:v>50.3519565927743</c:v>
                </c:pt>
                <c:pt idx="76">
                  <c:v>47.979917066737698</c:v>
                </c:pt>
                <c:pt idx="77">
                  <c:v>42.309444844192697</c:v>
                </c:pt>
                <c:pt idx="78">
                  <c:v>46.2833765132225</c:v>
                </c:pt>
                <c:pt idx="79">
                  <c:v>38.228942116881903</c:v>
                </c:pt>
                <c:pt idx="80">
                  <c:v>49.281892214922799</c:v>
                </c:pt>
                <c:pt idx="81">
                  <c:v>56.4480745556125</c:v>
                </c:pt>
                <c:pt idx="82">
                  <c:v>43.889314270891603</c:v>
                </c:pt>
                <c:pt idx="83">
                  <c:v>41.427413526570803</c:v>
                </c:pt>
                <c:pt idx="84">
                  <c:v>45.217771765919402</c:v>
                </c:pt>
                <c:pt idx="85">
                  <c:v>42.490989317175298</c:v>
                </c:pt>
                <c:pt idx="86">
                  <c:v>44.727706938311798</c:v>
                </c:pt>
                <c:pt idx="87">
                  <c:v>33.385408192516003</c:v>
                </c:pt>
                <c:pt idx="88">
                  <c:v>45.746122062132002</c:v>
                </c:pt>
                <c:pt idx="89">
                  <c:v>46.311834087056397</c:v>
                </c:pt>
                <c:pt idx="90">
                  <c:v>40.504264848484198</c:v>
                </c:pt>
                <c:pt idx="91">
                  <c:v>42.740869927637497</c:v>
                </c:pt>
                <c:pt idx="92">
                  <c:v>42.247193391619</c:v>
                </c:pt>
                <c:pt idx="93">
                  <c:v>47.520608270986102</c:v>
                </c:pt>
                <c:pt idx="94">
                  <c:v>47.863678468692697</c:v>
                </c:pt>
                <c:pt idx="95">
                  <c:v>44.887767549601399</c:v>
                </c:pt>
                <c:pt idx="96">
                  <c:v>41.596533400837998</c:v>
                </c:pt>
                <c:pt idx="97">
                  <c:v>45.999286454229299</c:v>
                </c:pt>
                <c:pt idx="98">
                  <c:v>49.505415024462998</c:v>
                </c:pt>
                <c:pt idx="99">
                  <c:v>55.244898883723501</c:v>
                </c:pt>
                <c:pt idx="100">
                  <c:v>46.473289417348603</c:v>
                </c:pt>
                <c:pt idx="101">
                  <c:v>42.983467464469598</c:v>
                </c:pt>
                <c:pt idx="102">
                  <c:v>52.3672337483519</c:v>
                </c:pt>
                <c:pt idx="103">
                  <c:v>42.349766523545497</c:v>
                </c:pt>
                <c:pt idx="104">
                  <c:v>48.052564778273798</c:v>
                </c:pt>
                <c:pt idx="105">
                  <c:v>45.339951106280203</c:v>
                </c:pt>
                <c:pt idx="106">
                  <c:v>42.315619782833899</c:v>
                </c:pt>
                <c:pt idx="107">
                  <c:v>48.038255851024303</c:v>
                </c:pt>
                <c:pt idx="108">
                  <c:v>46.941282038152302</c:v>
                </c:pt>
                <c:pt idx="109">
                  <c:v>40.593449839008201</c:v>
                </c:pt>
                <c:pt idx="110">
                  <c:v>47.292443676699897</c:v>
                </c:pt>
                <c:pt idx="111">
                  <c:v>42.075193015354898</c:v>
                </c:pt>
                <c:pt idx="112">
                  <c:v>36.413541669995098</c:v>
                </c:pt>
                <c:pt idx="113">
                  <c:v>50.272159010945202</c:v>
                </c:pt>
                <c:pt idx="114">
                  <c:v>44.884901269034302</c:v>
                </c:pt>
                <c:pt idx="115">
                  <c:v>53.308808021931597</c:v>
                </c:pt>
                <c:pt idx="116">
                  <c:v>50.458711599513897</c:v>
                </c:pt>
                <c:pt idx="117">
                  <c:v>45.879509336021897</c:v>
                </c:pt>
                <c:pt idx="118">
                  <c:v>48.095146297896903</c:v>
                </c:pt>
                <c:pt idx="119">
                  <c:v>42.363125291365897</c:v>
                </c:pt>
                <c:pt idx="120">
                  <c:v>44.749679304956203</c:v>
                </c:pt>
                <c:pt idx="121">
                  <c:v>42.534156852018903</c:v>
                </c:pt>
                <c:pt idx="122">
                  <c:v>46.495056305406301</c:v>
                </c:pt>
                <c:pt idx="123">
                  <c:v>57.455383328709502</c:v>
                </c:pt>
                <c:pt idx="124">
                  <c:v>46.9703931566698</c:v>
                </c:pt>
                <c:pt idx="125">
                  <c:v>43.289350104497203</c:v>
                </c:pt>
                <c:pt idx="126">
                  <c:v>49.076955576920099</c:v>
                </c:pt>
                <c:pt idx="127">
                  <c:v>49.892948060754598</c:v>
                </c:pt>
                <c:pt idx="128">
                  <c:v>55.9737180045705</c:v>
                </c:pt>
                <c:pt idx="129">
                  <c:v>51.978881158227701</c:v>
                </c:pt>
                <c:pt idx="130">
                  <c:v>50.564191803994703</c:v>
                </c:pt>
                <c:pt idx="131">
                  <c:v>48.830432622678202</c:v>
                </c:pt>
                <c:pt idx="132">
                  <c:v>42.640178957218197</c:v>
                </c:pt>
                <c:pt idx="133">
                  <c:v>40.170614630729602</c:v>
                </c:pt>
                <c:pt idx="134">
                  <c:v>43.459823244143301</c:v>
                </c:pt>
                <c:pt idx="135">
                  <c:v>52.850607185317799</c:v>
                </c:pt>
                <c:pt idx="136">
                  <c:v>37.765315084682001</c:v>
                </c:pt>
                <c:pt idx="137">
                  <c:v>46.367798453952098</c:v>
                </c:pt>
                <c:pt idx="138">
                  <c:v>41.861469143320797</c:v>
                </c:pt>
                <c:pt idx="139">
                  <c:v>41.300539708567101</c:v>
                </c:pt>
                <c:pt idx="140">
                  <c:v>47.457325414499202</c:v>
                </c:pt>
                <c:pt idx="141">
                  <c:v>42.800406256876201</c:v>
                </c:pt>
                <c:pt idx="142">
                  <c:v>43.629947095027902</c:v>
                </c:pt>
                <c:pt idx="143">
                  <c:v>47.787832318322799</c:v>
                </c:pt>
                <c:pt idx="144">
                  <c:v>54.383276704007798</c:v>
                </c:pt>
                <c:pt idx="145">
                  <c:v>45.878377577383397</c:v>
                </c:pt>
                <c:pt idx="146">
                  <c:v>53.578393954624303</c:v>
                </c:pt>
                <c:pt idx="147">
                  <c:v>51.467756376549097</c:v>
                </c:pt>
                <c:pt idx="148">
                  <c:v>48.245778460667097</c:v>
                </c:pt>
                <c:pt idx="149">
                  <c:v>49.657389350083101</c:v>
                </c:pt>
                <c:pt idx="150">
                  <c:v>52.947616751876097</c:v>
                </c:pt>
                <c:pt idx="151">
                  <c:v>42.184066280262201</c:v>
                </c:pt>
                <c:pt idx="152">
                  <c:v>52.004751514212501</c:v>
                </c:pt>
                <c:pt idx="153">
                  <c:v>38.029220133948897</c:v>
                </c:pt>
                <c:pt idx="154">
                  <c:v>46.893479040973901</c:v>
                </c:pt>
                <c:pt idx="155">
                  <c:v>51.7709880394831</c:v>
                </c:pt>
                <c:pt idx="156">
                  <c:v>42.352296285374898</c:v>
                </c:pt>
                <c:pt idx="157">
                  <c:v>43.971622993074703</c:v>
                </c:pt>
                <c:pt idx="158">
                  <c:v>49.755252811716801</c:v>
                </c:pt>
                <c:pt idx="159">
                  <c:v>47.467033773094599</c:v>
                </c:pt>
                <c:pt idx="160">
                  <c:v>51.191717253128402</c:v>
                </c:pt>
                <c:pt idx="161">
                  <c:v>43.717553749724701</c:v>
                </c:pt>
                <c:pt idx="162">
                  <c:v>52.403894905266803</c:v>
                </c:pt>
                <c:pt idx="163">
                  <c:v>52.397861001692299</c:v>
                </c:pt>
                <c:pt idx="164">
                  <c:v>56.823908403682097</c:v>
                </c:pt>
                <c:pt idx="165">
                  <c:v>46.142459512377499</c:v>
                </c:pt>
                <c:pt idx="166">
                  <c:v>43.208138351196503</c:v>
                </c:pt>
                <c:pt idx="167">
                  <c:v>44.734139254423603</c:v>
                </c:pt>
                <c:pt idx="168">
                  <c:v>49.323652935355298</c:v>
                </c:pt>
                <c:pt idx="169">
                  <c:v>46.608527189331397</c:v>
                </c:pt>
                <c:pt idx="170">
                  <c:v>44.132992544890399</c:v>
                </c:pt>
                <c:pt idx="171">
                  <c:v>43.737637075301699</c:v>
                </c:pt>
                <c:pt idx="172">
                  <c:v>44.616658216755503</c:v>
                </c:pt>
                <c:pt idx="173">
                  <c:v>44.902210260222802</c:v>
                </c:pt>
                <c:pt idx="174">
                  <c:v>46.657196823447002</c:v>
                </c:pt>
                <c:pt idx="175">
                  <c:v>45.546445363903601</c:v>
                </c:pt>
                <c:pt idx="176">
                  <c:v>39.613500936997902</c:v>
                </c:pt>
                <c:pt idx="177">
                  <c:v>50.098060144478097</c:v>
                </c:pt>
                <c:pt idx="178">
                  <c:v>46.820723247768598</c:v>
                </c:pt>
                <c:pt idx="179">
                  <c:v>50.042623537162299</c:v>
                </c:pt>
                <c:pt idx="180">
                  <c:v>42.476997708315302</c:v>
                </c:pt>
                <c:pt idx="181">
                  <c:v>44.076076245806902</c:v>
                </c:pt>
                <c:pt idx="182">
                  <c:v>53.5073979859921</c:v>
                </c:pt>
                <c:pt idx="183">
                  <c:v>42.105392238489401</c:v>
                </c:pt>
                <c:pt idx="184">
                  <c:v>41.028417123011202</c:v>
                </c:pt>
                <c:pt idx="185">
                  <c:v>43.428137879589102</c:v>
                </c:pt>
                <c:pt idx="186">
                  <c:v>53.521155691807898</c:v>
                </c:pt>
                <c:pt idx="187">
                  <c:v>49.077450085971897</c:v>
                </c:pt>
                <c:pt idx="188">
                  <c:v>54.158267695379799</c:v>
                </c:pt>
                <c:pt idx="189">
                  <c:v>50.882465004131497</c:v>
                </c:pt>
                <c:pt idx="190">
                  <c:v>46.309162370403797</c:v>
                </c:pt>
                <c:pt idx="191">
                  <c:v>46.890104160084803</c:v>
                </c:pt>
                <c:pt idx="192">
                  <c:v>56.9197993683186</c:v>
                </c:pt>
                <c:pt idx="193">
                  <c:v>42.428439351683899</c:v>
                </c:pt>
                <c:pt idx="194">
                  <c:v>43.257147445811299</c:v>
                </c:pt>
                <c:pt idx="195">
                  <c:v>40.640765806051199</c:v>
                </c:pt>
                <c:pt idx="196">
                  <c:v>49.324017611592701</c:v>
                </c:pt>
                <c:pt idx="197">
                  <c:v>52.321579123299401</c:v>
                </c:pt>
                <c:pt idx="198">
                  <c:v>39.329413402121297</c:v>
                </c:pt>
                <c:pt idx="199">
                  <c:v>55.087835785649197</c:v>
                </c:pt>
                <c:pt idx="200">
                  <c:v>30.638378434952099</c:v>
                </c:pt>
                <c:pt idx="201">
                  <c:v>44.974624728980203</c:v>
                </c:pt>
                <c:pt idx="202">
                  <c:v>48.718303650285897</c:v>
                </c:pt>
                <c:pt idx="203">
                  <c:v>43.303348135039201</c:v>
                </c:pt>
                <c:pt idx="204">
                  <c:v>50.227345678678702</c:v>
                </c:pt>
                <c:pt idx="205">
                  <c:v>34.396073510674299</c:v>
                </c:pt>
                <c:pt idx="206">
                  <c:v>44.9022104692909</c:v>
                </c:pt>
                <c:pt idx="207">
                  <c:v>40.0525007472705</c:v>
                </c:pt>
                <c:pt idx="208">
                  <c:v>47.294972500016897</c:v>
                </c:pt>
                <c:pt idx="209">
                  <c:v>46.3467404422546</c:v>
                </c:pt>
                <c:pt idx="210">
                  <c:v>47.244262845317998</c:v>
                </c:pt>
                <c:pt idx="211">
                  <c:v>44.267186957855401</c:v>
                </c:pt>
                <c:pt idx="212">
                  <c:v>40.970006899466497</c:v>
                </c:pt>
                <c:pt idx="213">
                  <c:v>46.0204257339335</c:v>
                </c:pt>
                <c:pt idx="214">
                  <c:v>43.132775162084201</c:v>
                </c:pt>
                <c:pt idx="215">
                  <c:v>45.642243361330301</c:v>
                </c:pt>
                <c:pt idx="216">
                  <c:v>39.4574090507408</c:v>
                </c:pt>
                <c:pt idx="217">
                  <c:v>43.317237715370702</c:v>
                </c:pt>
                <c:pt idx="218">
                  <c:v>42.226730259724803</c:v>
                </c:pt>
                <c:pt idx="219">
                  <c:v>43.993967419374897</c:v>
                </c:pt>
                <c:pt idx="220">
                  <c:v>33.1070857357753</c:v>
                </c:pt>
                <c:pt idx="221">
                  <c:v>46.462471232724702</c:v>
                </c:pt>
                <c:pt idx="222">
                  <c:v>54.948394779752597</c:v>
                </c:pt>
                <c:pt idx="223">
                  <c:v>42.936299605002702</c:v>
                </c:pt>
                <c:pt idx="224">
                  <c:v>48.865558694120999</c:v>
                </c:pt>
                <c:pt idx="225">
                  <c:v>48.417194400411503</c:v>
                </c:pt>
                <c:pt idx="226">
                  <c:v>49.554229585178099</c:v>
                </c:pt>
                <c:pt idx="227">
                  <c:v>46.6440313580447</c:v>
                </c:pt>
                <c:pt idx="228">
                  <c:v>46.077458635408398</c:v>
                </c:pt>
                <c:pt idx="229">
                  <c:v>40.881555965285301</c:v>
                </c:pt>
                <c:pt idx="230">
                  <c:v>48.956521337077703</c:v>
                </c:pt>
                <c:pt idx="231">
                  <c:v>42.740387584265498</c:v>
                </c:pt>
                <c:pt idx="232">
                  <c:v>49.282802840024999</c:v>
                </c:pt>
                <c:pt idx="233">
                  <c:v>45.834866423976102</c:v>
                </c:pt>
                <c:pt idx="234">
                  <c:v>49.551370321057099</c:v>
                </c:pt>
                <c:pt idx="235">
                  <c:v>37.768821248941599</c:v>
                </c:pt>
                <c:pt idx="236">
                  <c:v>42.896047288755497</c:v>
                </c:pt>
                <c:pt idx="237">
                  <c:v>37.923922699706203</c:v>
                </c:pt>
                <c:pt idx="238">
                  <c:v>39.250966852239401</c:v>
                </c:pt>
                <c:pt idx="239">
                  <c:v>41.612027732998399</c:v>
                </c:pt>
                <c:pt idx="240">
                  <c:v>49.633292786885498</c:v>
                </c:pt>
                <c:pt idx="241">
                  <c:v>38.228089655031098</c:v>
                </c:pt>
                <c:pt idx="242">
                  <c:v>46.309080256702899</c:v>
                </c:pt>
                <c:pt idx="243">
                  <c:v>49.910904370893803</c:v>
                </c:pt>
                <c:pt idx="244">
                  <c:v>51.511509570779197</c:v>
                </c:pt>
                <c:pt idx="245">
                  <c:v>57.690769270724999</c:v>
                </c:pt>
                <c:pt idx="246">
                  <c:v>46.057989558795903</c:v>
                </c:pt>
                <c:pt idx="247">
                  <c:v>31.1613063199854</c:v>
                </c:pt>
                <c:pt idx="248">
                  <c:v>44.953753705884097</c:v>
                </c:pt>
                <c:pt idx="249">
                  <c:v>40.017734226228498</c:v>
                </c:pt>
                <c:pt idx="250">
                  <c:v>52.695731298066796</c:v>
                </c:pt>
                <c:pt idx="251">
                  <c:v>52.115368687552298</c:v>
                </c:pt>
                <c:pt idx="252">
                  <c:v>45.0203278418957</c:v>
                </c:pt>
                <c:pt idx="253">
                  <c:v>57.221164079549602</c:v>
                </c:pt>
                <c:pt idx="254">
                  <c:v>51.772286890265597</c:v>
                </c:pt>
                <c:pt idx="255">
                  <c:v>33.706653109827997</c:v>
                </c:pt>
                <c:pt idx="256">
                  <c:v>42.380978282755798</c:v>
                </c:pt>
                <c:pt idx="257">
                  <c:v>56.119292120150597</c:v>
                </c:pt>
                <c:pt idx="258">
                  <c:v>58.754146859676602</c:v>
                </c:pt>
                <c:pt idx="259">
                  <c:v>47.593396544354199</c:v>
                </c:pt>
                <c:pt idx="260">
                  <c:v>49.4051633623653</c:v>
                </c:pt>
                <c:pt idx="261">
                  <c:v>40.566976228266199</c:v>
                </c:pt>
                <c:pt idx="262">
                  <c:v>46.353246476713302</c:v>
                </c:pt>
                <c:pt idx="263">
                  <c:v>45.214809139750301</c:v>
                </c:pt>
                <c:pt idx="264">
                  <c:v>41.923551461437398</c:v>
                </c:pt>
                <c:pt idx="265">
                  <c:v>45.540945323435103</c:v>
                </c:pt>
                <c:pt idx="266">
                  <c:v>42.406329065013999</c:v>
                </c:pt>
                <c:pt idx="267">
                  <c:v>51.488111955918797</c:v>
                </c:pt>
                <c:pt idx="268">
                  <c:v>48.6386469027643</c:v>
                </c:pt>
                <c:pt idx="269">
                  <c:v>47.030789479623202</c:v>
                </c:pt>
                <c:pt idx="270">
                  <c:v>47.195163930728</c:v>
                </c:pt>
                <c:pt idx="271">
                  <c:v>52.052215688489603</c:v>
                </c:pt>
                <c:pt idx="272">
                  <c:v>38.233462777151502</c:v>
                </c:pt>
                <c:pt idx="273">
                  <c:v>37.795199538354098</c:v>
                </c:pt>
                <c:pt idx="274">
                  <c:v>49.468091446546502</c:v>
                </c:pt>
                <c:pt idx="275">
                  <c:v>54.1724235752326</c:v>
                </c:pt>
                <c:pt idx="276">
                  <c:v>37.505793917173698</c:v>
                </c:pt>
                <c:pt idx="277">
                  <c:v>47.513298916271097</c:v>
                </c:pt>
                <c:pt idx="278">
                  <c:v>40.296838202214801</c:v>
                </c:pt>
                <c:pt idx="279">
                  <c:v>51.137990437891801</c:v>
                </c:pt>
                <c:pt idx="280">
                  <c:v>51.409882647253802</c:v>
                </c:pt>
                <c:pt idx="281">
                  <c:v>49.371064216582198</c:v>
                </c:pt>
                <c:pt idx="282">
                  <c:v>46.2855168285624</c:v>
                </c:pt>
                <c:pt idx="283">
                  <c:v>47.053715370838198</c:v>
                </c:pt>
                <c:pt idx="284">
                  <c:v>48.069178895823001</c:v>
                </c:pt>
                <c:pt idx="285">
                  <c:v>42.901688396429499</c:v>
                </c:pt>
                <c:pt idx="286">
                  <c:v>45.557151053490699</c:v>
                </c:pt>
                <c:pt idx="287">
                  <c:v>51.6638715727807</c:v>
                </c:pt>
                <c:pt idx="288">
                  <c:v>54.801269771153201</c:v>
                </c:pt>
                <c:pt idx="289">
                  <c:v>44.621932389283103</c:v>
                </c:pt>
                <c:pt idx="290">
                  <c:v>44.5967257903704</c:v>
                </c:pt>
                <c:pt idx="291">
                  <c:v>46.222490118209997</c:v>
                </c:pt>
              </c:numCache>
            </c:numRef>
          </c:xVal>
          <c:yVal>
            <c:numRef>
              <c:f>Sheet1!$H$2:$H$293</c:f>
              <c:numCache>
                <c:formatCode>0.00</c:formatCode>
                <c:ptCount val="292"/>
                <c:pt idx="0">
                  <c:v>56.972077100385398</c:v>
                </c:pt>
                <c:pt idx="1">
                  <c:v>50.274495062583703</c:v>
                </c:pt>
                <c:pt idx="2">
                  <c:v>51.893962270069103</c:v>
                </c:pt>
                <c:pt idx="3">
                  <c:v>71.713090752602795</c:v>
                </c:pt>
                <c:pt idx="4">
                  <c:v>50.053466729707203</c:v>
                </c:pt>
                <c:pt idx="5">
                  <c:v>57.995876173584897</c:v>
                </c:pt>
                <c:pt idx="6">
                  <c:v>61.7723183678198</c:v>
                </c:pt>
                <c:pt idx="7">
                  <c:v>61.180472178970199</c:v>
                </c:pt>
                <c:pt idx="8">
                  <c:v>44.037192089527601</c:v>
                </c:pt>
                <c:pt idx="9">
                  <c:v>50.879199692966601</c:v>
                </c:pt>
                <c:pt idx="10">
                  <c:v>50.302686169060799</c:v>
                </c:pt>
                <c:pt idx="11">
                  <c:v>54.101407795382499</c:v>
                </c:pt>
                <c:pt idx="12">
                  <c:v>56.347289590662399</c:v>
                </c:pt>
                <c:pt idx="13">
                  <c:v>56.779356748393703</c:v>
                </c:pt>
                <c:pt idx="14">
                  <c:v>47.872790316589096</c:v>
                </c:pt>
                <c:pt idx="15">
                  <c:v>46.936973608139702</c:v>
                </c:pt>
                <c:pt idx="16">
                  <c:v>42.991609451018903</c:v>
                </c:pt>
                <c:pt idx="17">
                  <c:v>53.781982524356799</c:v>
                </c:pt>
                <c:pt idx="18">
                  <c:v>56.869674615574503</c:v>
                </c:pt>
                <c:pt idx="19">
                  <c:v>53.646277321138598</c:v>
                </c:pt>
                <c:pt idx="20">
                  <c:v>48.098484237270803</c:v>
                </c:pt>
                <c:pt idx="21">
                  <c:v>40.027290026322</c:v>
                </c:pt>
                <c:pt idx="22">
                  <c:v>54.007265579851101</c:v>
                </c:pt>
                <c:pt idx="23">
                  <c:v>44.144985457485802</c:v>
                </c:pt>
                <c:pt idx="24">
                  <c:v>53.762647668883702</c:v>
                </c:pt>
                <c:pt idx="25">
                  <c:v>9.0131931736008006</c:v>
                </c:pt>
                <c:pt idx="26">
                  <c:v>52.398549481149097</c:v>
                </c:pt>
                <c:pt idx="27">
                  <c:v>57.434719609964901</c:v>
                </c:pt>
                <c:pt idx="28">
                  <c:v>47.967287803390398</c:v>
                </c:pt>
                <c:pt idx="29">
                  <c:v>36.310119942835698</c:v>
                </c:pt>
                <c:pt idx="30">
                  <c:v>55.676408319631101</c:v>
                </c:pt>
                <c:pt idx="31">
                  <c:v>48.581742345490099</c:v>
                </c:pt>
                <c:pt idx="32">
                  <c:v>62.594002300875502</c:v>
                </c:pt>
                <c:pt idx="33">
                  <c:v>59.854779654009597</c:v>
                </c:pt>
                <c:pt idx="34">
                  <c:v>54.451483677633703</c:v>
                </c:pt>
                <c:pt idx="35">
                  <c:v>38.007132229040202</c:v>
                </c:pt>
                <c:pt idx="36">
                  <c:v>62.626498851359003</c:v>
                </c:pt>
                <c:pt idx="37">
                  <c:v>57.662376091029998</c:v>
                </c:pt>
                <c:pt idx="38">
                  <c:v>53.879139369179299</c:v>
                </c:pt>
                <c:pt idx="39">
                  <c:v>55.809472138745598</c:v>
                </c:pt>
                <c:pt idx="40">
                  <c:v>58.794624656558298</c:v>
                </c:pt>
                <c:pt idx="41">
                  <c:v>60.375381862704003</c:v>
                </c:pt>
                <c:pt idx="42">
                  <c:v>41.696600406779197</c:v>
                </c:pt>
                <c:pt idx="43">
                  <c:v>26.2433277633552</c:v>
                </c:pt>
                <c:pt idx="44">
                  <c:v>58.641955807548101</c:v>
                </c:pt>
                <c:pt idx="45">
                  <c:v>36.4543313130388</c:v>
                </c:pt>
                <c:pt idx="46">
                  <c:v>21.785192929797201</c:v>
                </c:pt>
                <c:pt idx="47">
                  <c:v>64.993278644278902</c:v>
                </c:pt>
                <c:pt idx="48">
                  <c:v>61.614071168195402</c:v>
                </c:pt>
                <c:pt idx="49">
                  <c:v>49.677969121519403</c:v>
                </c:pt>
                <c:pt idx="50">
                  <c:v>47.505857965697899</c:v>
                </c:pt>
                <c:pt idx="51">
                  <c:v>38.737598262460899</c:v>
                </c:pt>
                <c:pt idx="52">
                  <c:v>70.781531285897103</c:v>
                </c:pt>
                <c:pt idx="53">
                  <c:v>62.907709950822202</c:v>
                </c:pt>
                <c:pt idx="54">
                  <c:v>61.335014178162801</c:v>
                </c:pt>
                <c:pt idx="55">
                  <c:v>56.919721777076802</c:v>
                </c:pt>
                <c:pt idx="56">
                  <c:v>52.448920107840401</c:v>
                </c:pt>
                <c:pt idx="57">
                  <c:v>49.935286212189098</c:v>
                </c:pt>
                <c:pt idx="58">
                  <c:v>52.909163062357997</c:v>
                </c:pt>
                <c:pt idx="59">
                  <c:v>28.537327549817299</c:v>
                </c:pt>
                <c:pt idx="60">
                  <c:v>72.2613551862256</c:v>
                </c:pt>
                <c:pt idx="61">
                  <c:v>55.991890964098801</c:v>
                </c:pt>
                <c:pt idx="62">
                  <c:v>56.114212597211299</c:v>
                </c:pt>
                <c:pt idx="63">
                  <c:v>27.575735701159999</c:v>
                </c:pt>
                <c:pt idx="64">
                  <c:v>55.569873870355202</c:v>
                </c:pt>
                <c:pt idx="65">
                  <c:v>53.895857340886302</c:v>
                </c:pt>
                <c:pt idx="66">
                  <c:v>49.875933443380902</c:v>
                </c:pt>
                <c:pt idx="67">
                  <c:v>46.410331813190403</c:v>
                </c:pt>
                <c:pt idx="68">
                  <c:v>38.706625116673301</c:v>
                </c:pt>
                <c:pt idx="69">
                  <c:v>49.195967025716698</c:v>
                </c:pt>
                <c:pt idx="70">
                  <c:v>26.5962564349357</c:v>
                </c:pt>
                <c:pt idx="71">
                  <c:v>29.163189362389101</c:v>
                </c:pt>
                <c:pt idx="72">
                  <c:v>49.660122124788501</c:v>
                </c:pt>
                <c:pt idx="73">
                  <c:v>42.178618792316598</c:v>
                </c:pt>
                <c:pt idx="74">
                  <c:v>82.350829867282002</c:v>
                </c:pt>
                <c:pt idx="75">
                  <c:v>60.671912046148798</c:v>
                </c:pt>
                <c:pt idx="76">
                  <c:v>60.504169400802198</c:v>
                </c:pt>
                <c:pt idx="77">
                  <c:v>48.896858626788699</c:v>
                </c:pt>
                <c:pt idx="78">
                  <c:v>63.628476899675597</c:v>
                </c:pt>
                <c:pt idx="79">
                  <c:v>34.696388549660398</c:v>
                </c:pt>
                <c:pt idx="80">
                  <c:v>42.325771435721897</c:v>
                </c:pt>
                <c:pt idx="81">
                  <c:v>77.710995594919694</c:v>
                </c:pt>
                <c:pt idx="82">
                  <c:v>41.556897161641103</c:v>
                </c:pt>
                <c:pt idx="83">
                  <c:v>59.164431243312002</c:v>
                </c:pt>
                <c:pt idx="84">
                  <c:v>56.008452316598699</c:v>
                </c:pt>
                <c:pt idx="85">
                  <c:v>44.163139359274098</c:v>
                </c:pt>
                <c:pt idx="86">
                  <c:v>41.953259237189698</c:v>
                </c:pt>
                <c:pt idx="87">
                  <c:v>40.528014882408897</c:v>
                </c:pt>
                <c:pt idx="88">
                  <c:v>35.529732105963497</c:v>
                </c:pt>
                <c:pt idx="89">
                  <c:v>42.404185261799498</c:v>
                </c:pt>
                <c:pt idx="90">
                  <c:v>52.576625844025799</c:v>
                </c:pt>
                <c:pt idx="91">
                  <c:v>51.104169695579998</c:v>
                </c:pt>
                <c:pt idx="92">
                  <c:v>55.760705799723297</c:v>
                </c:pt>
                <c:pt idx="93">
                  <c:v>54.631439628722099</c:v>
                </c:pt>
                <c:pt idx="94">
                  <c:v>58.180254171333502</c:v>
                </c:pt>
                <c:pt idx="95">
                  <c:v>45.070798536212799</c:v>
                </c:pt>
                <c:pt idx="96">
                  <c:v>47.922707330841099</c:v>
                </c:pt>
                <c:pt idx="97">
                  <c:v>54.428116453079099</c:v>
                </c:pt>
                <c:pt idx="98">
                  <c:v>58.625309188636201</c:v>
                </c:pt>
                <c:pt idx="99">
                  <c:v>59.299487585082801</c:v>
                </c:pt>
                <c:pt idx="100">
                  <c:v>60.443382341604</c:v>
                </c:pt>
                <c:pt idx="101">
                  <c:v>47.891579937556301</c:v>
                </c:pt>
                <c:pt idx="102">
                  <c:v>64.870201651673696</c:v>
                </c:pt>
                <c:pt idx="103">
                  <c:v>53.223518046519999</c:v>
                </c:pt>
                <c:pt idx="104">
                  <c:v>58.926591542835297</c:v>
                </c:pt>
                <c:pt idx="105">
                  <c:v>48.721980122787798</c:v>
                </c:pt>
                <c:pt idx="106">
                  <c:v>59.578476197647198</c:v>
                </c:pt>
                <c:pt idx="107">
                  <c:v>58.823210911687397</c:v>
                </c:pt>
                <c:pt idx="108">
                  <c:v>56.118116021475402</c:v>
                </c:pt>
                <c:pt idx="109">
                  <c:v>61.316908802032501</c:v>
                </c:pt>
                <c:pt idx="110">
                  <c:v>58.807713792167696</c:v>
                </c:pt>
                <c:pt idx="111">
                  <c:v>49.9405798905712</c:v>
                </c:pt>
                <c:pt idx="112">
                  <c:v>48.235066642264101</c:v>
                </c:pt>
                <c:pt idx="113">
                  <c:v>61.0272653661861</c:v>
                </c:pt>
                <c:pt idx="114">
                  <c:v>45.281684756388103</c:v>
                </c:pt>
                <c:pt idx="115">
                  <c:v>67.459578250342005</c:v>
                </c:pt>
                <c:pt idx="116">
                  <c:v>59.086077576673397</c:v>
                </c:pt>
                <c:pt idx="117">
                  <c:v>43.254642058866999</c:v>
                </c:pt>
                <c:pt idx="118">
                  <c:v>53.600342353512502</c:v>
                </c:pt>
                <c:pt idx="119">
                  <c:v>43.791365948270297</c:v>
                </c:pt>
                <c:pt idx="120">
                  <c:v>58.663991372634399</c:v>
                </c:pt>
                <c:pt idx="121">
                  <c:v>46.274977903686903</c:v>
                </c:pt>
                <c:pt idx="122">
                  <c:v>48.8320315144001</c:v>
                </c:pt>
                <c:pt idx="123">
                  <c:v>70.647393984881703</c:v>
                </c:pt>
                <c:pt idx="124">
                  <c:v>58.8909029726642</c:v>
                </c:pt>
                <c:pt idx="125">
                  <c:v>51.267353876218799</c:v>
                </c:pt>
                <c:pt idx="126">
                  <c:v>63.742125779656497</c:v>
                </c:pt>
                <c:pt idx="127">
                  <c:v>67.928542553243503</c:v>
                </c:pt>
                <c:pt idx="128">
                  <c:v>71.563198014722801</c:v>
                </c:pt>
                <c:pt idx="129">
                  <c:v>59.757550948477999</c:v>
                </c:pt>
                <c:pt idx="130">
                  <c:v>64.022905187432698</c:v>
                </c:pt>
                <c:pt idx="131">
                  <c:v>60.165871537049298</c:v>
                </c:pt>
                <c:pt idx="132">
                  <c:v>51.3146924951781</c:v>
                </c:pt>
                <c:pt idx="133">
                  <c:v>48.590047888970197</c:v>
                </c:pt>
                <c:pt idx="134">
                  <c:v>58.565460347918403</c:v>
                </c:pt>
                <c:pt idx="135">
                  <c:v>64.668024867013898</c:v>
                </c:pt>
                <c:pt idx="136">
                  <c:v>50.876788832705003</c:v>
                </c:pt>
                <c:pt idx="137">
                  <c:v>63.8255387105796</c:v>
                </c:pt>
                <c:pt idx="138">
                  <c:v>43.244778023986598</c:v>
                </c:pt>
                <c:pt idx="139">
                  <c:v>53.201433081363099</c:v>
                </c:pt>
                <c:pt idx="140">
                  <c:v>56.090280126204803</c:v>
                </c:pt>
                <c:pt idx="141">
                  <c:v>49.327301478742903</c:v>
                </c:pt>
                <c:pt idx="142">
                  <c:v>45.867252173397702</c:v>
                </c:pt>
                <c:pt idx="143">
                  <c:v>60.428261133375401</c:v>
                </c:pt>
                <c:pt idx="144">
                  <c:v>67.807811681852698</c:v>
                </c:pt>
                <c:pt idx="145">
                  <c:v>60.341604093229101</c:v>
                </c:pt>
                <c:pt idx="146">
                  <c:v>59.637683669478598</c:v>
                </c:pt>
                <c:pt idx="147">
                  <c:v>61.627867827255599</c:v>
                </c:pt>
                <c:pt idx="148">
                  <c:v>59.646336852831503</c:v>
                </c:pt>
                <c:pt idx="149">
                  <c:v>54.526691443738599</c:v>
                </c:pt>
                <c:pt idx="150">
                  <c:v>75.192574075260097</c:v>
                </c:pt>
                <c:pt idx="151">
                  <c:v>56.211653337613498</c:v>
                </c:pt>
                <c:pt idx="152">
                  <c:v>70.755365941206904</c:v>
                </c:pt>
                <c:pt idx="153">
                  <c:v>38.263261949967102</c:v>
                </c:pt>
                <c:pt idx="154">
                  <c:v>48.285999914370201</c:v>
                </c:pt>
                <c:pt idx="155">
                  <c:v>52.756648017187402</c:v>
                </c:pt>
                <c:pt idx="156">
                  <c:v>42.940091936150701</c:v>
                </c:pt>
                <c:pt idx="157">
                  <c:v>48.846795373706797</c:v>
                </c:pt>
                <c:pt idx="158">
                  <c:v>68.432772068902096</c:v>
                </c:pt>
                <c:pt idx="159">
                  <c:v>56.331199751485201</c:v>
                </c:pt>
                <c:pt idx="160">
                  <c:v>71.093857241296703</c:v>
                </c:pt>
                <c:pt idx="161">
                  <c:v>47.748863438948298</c:v>
                </c:pt>
                <c:pt idx="162">
                  <c:v>63.590925967021498</c:v>
                </c:pt>
                <c:pt idx="163">
                  <c:v>76.906317291512295</c:v>
                </c:pt>
                <c:pt idx="164">
                  <c:v>68.764591385139994</c:v>
                </c:pt>
                <c:pt idx="165">
                  <c:v>62.580621989055103</c:v>
                </c:pt>
                <c:pt idx="166">
                  <c:v>52.228071213885002</c:v>
                </c:pt>
                <c:pt idx="167">
                  <c:v>37.058168369218301</c:v>
                </c:pt>
                <c:pt idx="168">
                  <c:v>67.903632284165994</c:v>
                </c:pt>
                <c:pt idx="169">
                  <c:v>52.162654764120902</c:v>
                </c:pt>
                <c:pt idx="170">
                  <c:v>52.260963102452898</c:v>
                </c:pt>
                <c:pt idx="171">
                  <c:v>51.999256572090097</c:v>
                </c:pt>
                <c:pt idx="172">
                  <c:v>51.488832163144302</c:v>
                </c:pt>
                <c:pt idx="173">
                  <c:v>49.009171785412299</c:v>
                </c:pt>
                <c:pt idx="174">
                  <c:v>67.635396416586602</c:v>
                </c:pt>
                <c:pt idx="175">
                  <c:v>52.979734934627999</c:v>
                </c:pt>
                <c:pt idx="176">
                  <c:v>43.989570135946799</c:v>
                </c:pt>
                <c:pt idx="177">
                  <c:v>70.651179203688301</c:v>
                </c:pt>
                <c:pt idx="178">
                  <c:v>53.847698009892</c:v>
                </c:pt>
                <c:pt idx="179">
                  <c:v>64.782492550404001</c:v>
                </c:pt>
                <c:pt idx="180">
                  <c:v>51.687388166452699</c:v>
                </c:pt>
                <c:pt idx="181">
                  <c:v>45.101457423431498</c:v>
                </c:pt>
                <c:pt idx="182">
                  <c:v>66.063912205334603</c:v>
                </c:pt>
                <c:pt idx="183">
                  <c:v>27.985881561136299</c:v>
                </c:pt>
                <c:pt idx="184">
                  <c:v>54.2592113810665</c:v>
                </c:pt>
                <c:pt idx="185">
                  <c:v>49.840392025159403</c:v>
                </c:pt>
                <c:pt idx="186">
                  <c:v>54.637563790980899</c:v>
                </c:pt>
                <c:pt idx="187">
                  <c:v>67.109259900192598</c:v>
                </c:pt>
                <c:pt idx="188">
                  <c:v>60.1512922151976</c:v>
                </c:pt>
                <c:pt idx="189">
                  <c:v>55.223437037876998</c:v>
                </c:pt>
                <c:pt idx="190">
                  <c:v>56.6625362807412</c:v>
                </c:pt>
                <c:pt idx="191">
                  <c:v>50.815543978080903</c:v>
                </c:pt>
                <c:pt idx="192">
                  <c:v>75.606846539182101</c:v>
                </c:pt>
                <c:pt idx="193">
                  <c:v>46.9869152627167</c:v>
                </c:pt>
                <c:pt idx="194">
                  <c:v>47.520139698214102</c:v>
                </c:pt>
                <c:pt idx="195">
                  <c:v>46.315987902472699</c:v>
                </c:pt>
                <c:pt idx="196">
                  <c:v>65.286724821380005</c:v>
                </c:pt>
                <c:pt idx="197">
                  <c:v>60.324440640246202</c:v>
                </c:pt>
                <c:pt idx="198">
                  <c:v>49.851426262169099</c:v>
                </c:pt>
                <c:pt idx="199">
                  <c:v>70.412289309144398</c:v>
                </c:pt>
                <c:pt idx="200">
                  <c:v>31.308167787830399</c:v>
                </c:pt>
                <c:pt idx="201">
                  <c:v>59.223889368471497</c:v>
                </c:pt>
                <c:pt idx="202">
                  <c:v>59.001077672024998</c:v>
                </c:pt>
                <c:pt idx="203">
                  <c:v>45.433091166193201</c:v>
                </c:pt>
                <c:pt idx="204">
                  <c:v>52.952952822794799</c:v>
                </c:pt>
                <c:pt idx="205">
                  <c:v>31.934683259602</c:v>
                </c:pt>
                <c:pt idx="206">
                  <c:v>66.971362683960507</c:v>
                </c:pt>
                <c:pt idx="207">
                  <c:v>36.096375649022903</c:v>
                </c:pt>
                <c:pt idx="208">
                  <c:v>59.6412817803471</c:v>
                </c:pt>
                <c:pt idx="209">
                  <c:v>54.790189522879302</c:v>
                </c:pt>
                <c:pt idx="210">
                  <c:v>60.826313233139203</c:v>
                </c:pt>
                <c:pt idx="211">
                  <c:v>51.9356854990369</c:v>
                </c:pt>
                <c:pt idx="212">
                  <c:v>59.065201713704496</c:v>
                </c:pt>
                <c:pt idx="213">
                  <c:v>42.242472159188097</c:v>
                </c:pt>
                <c:pt idx="214">
                  <c:v>54.472301503230803</c:v>
                </c:pt>
                <c:pt idx="215">
                  <c:v>60.259387955799703</c:v>
                </c:pt>
                <c:pt idx="216">
                  <c:v>30.868899475521101</c:v>
                </c:pt>
                <c:pt idx="217">
                  <c:v>36.894735270520798</c:v>
                </c:pt>
                <c:pt idx="218">
                  <c:v>45.606245925547803</c:v>
                </c:pt>
                <c:pt idx="219">
                  <c:v>55.843714523368703</c:v>
                </c:pt>
                <c:pt idx="220">
                  <c:v>31.155211776591798</c:v>
                </c:pt>
                <c:pt idx="221">
                  <c:v>50.748057305221799</c:v>
                </c:pt>
                <c:pt idx="222">
                  <c:v>58.0290247415492</c:v>
                </c:pt>
                <c:pt idx="223">
                  <c:v>41.000284984001802</c:v>
                </c:pt>
                <c:pt idx="224">
                  <c:v>54.068462339065903</c:v>
                </c:pt>
                <c:pt idx="225">
                  <c:v>69.137858767567394</c:v>
                </c:pt>
                <c:pt idx="226">
                  <c:v>42.990008479852499</c:v>
                </c:pt>
                <c:pt idx="227">
                  <c:v>33.499299100843501</c:v>
                </c:pt>
                <c:pt idx="228">
                  <c:v>59.083023540164099</c:v>
                </c:pt>
                <c:pt idx="229">
                  <c:v>54.401734980352202</c:v>
                </c:pt>
                <c:pt idx="230">
                  <c:v>70.983496962599801</c:v>
                </c:pt>
                <c:pt idx="231">
                  <c:v>42.280161391491198</c:v>
                </c:pt>
                <c:pt idx="232">
                  <c:v>56.883508068888702</c:v>
                </c:pt>
                <c:pt idx="233">
                  <c:v>57.0240135484378</c:v>
                </c:pt>
                <c:pt idx="234">
                  <c:v>57.955703235564201</c:v>
                </c:pt>
                <c:pt idx="235">
                  <c:v>43.5314750530246</c:v>
                </c:pt>
                <c:pt idx="236">
                  <c:v>50.664581374276104</c:v>
                </c:pt>
                <c:pt idx="237">
                  <c:v>36.603483778226597</c:v>
                </c:pt>
                <c:pt idx="238">
                  <c:v>54.4311322425566</c:v>
                </c:pt>
                <c:pt idx="239">
                  <c:v>40.939998979766997</c:v>
                </c:pt>
                <c:pt idx="240">
                  <c:v>49.660595598154899</c:v>
                </c:pt>
                <c:pt idx="241">
                  <c:v>49.263777346776102</c:v>
                </c:pt>
                <c:pt idx="242">
                  <c:v>51.011070271085302</c:v>
                </c:pt>
                <c:pt idx="243">
                  <c:v>66.610148000527403</c:v>
                </c:pt>
                <c:pt idx="244">
                  <c:v>47.972404582197399</c:v>
                </c:pt>
                <c:pt idx="245">
                  <c:v>61.1601612302223</c:v>
                </c:pt>
                <c:pt idx="246">
                  <c:v>60.026672189200603</c:v>
                </c:pt>
                <c:pt idx="247">
                  <c:v>21.7647749498853</c:v>
                </c:pt>
                <c:pt idx="248">
                  <c:v>58.572987816476598</c:v>
                </c:pt>
                <c:pt idx="249">
                  <c:v>52.5323875572468</c:v>
                </c:pt>
                <c:pt idx="250">
                  <c:v>52.998580150862303</c:v>
                </c:pt>
                <c:pt idx="251">
                  <c:v>54.4942167787001</c:v>
                </c:pt>
                <c:pt idx="252">
                  <c:v>49.855690965553698</c:v>
                </c:pt>
                <c:pt idx="253">
                  <c:v>58.956414858443502</c:v>
                </c:pt>
                <c:pt idx="254">
                  <c:v>76.731228560061794</c:v>
                </c:pt>
                <c:pt idx="255">
                  <c:v>27.240965868897799</c:v>
                </c:pt>
                <c:pt idx="256">
                  <c:v>50.909235898459002</c:v>
                </c:pt>
                <c:pt idx="257">
                  <c:v>68.736162365080204</c:v>
                </c:pt>
                <c:pt idx="258">
                  <c:v>73.733485074619594</c:v>
                </c:pt>
                <c:pt idx="259">
                  <c:v>46.551512182548699</c:v>
                </c:pt>
                <c:pt idx="260">
                  <c:v>53.482651487735303</c:v>
                </c:pt>
                <c:pt idx="261">
                  <c:v>39.100818098411203</c:v>
                </c:pt>
                <c:pt idx="262">
                  <c:v>51.214858763842997</c:v>
                </c:pt>
                <c:pt idx="263">
                  <c:v>46.053050275939199</c:v>
                </c:pt>
                <c:pt idx="264">
                  <c:v>35.825806557620197</c:v>
                </c:pt>
                <c:pt idx="265">
                  <c:v>62.783162679559901</c:v>
                </c:pt>
                <c:pt idx="266">
                  <c:v>46.514628516579599</c:v>
                </c:pt>
                <c:pt idx="267">
                  <c:v>53.995020481960999</c:v>
                </c:pt>
                <c:pt idx="268">
                  <c:v>43.071453824174398</c:v>
                </c:pt>
                <c:pt idx="269">
                  <c:v>49.074829233558397</c:v>
                </c:pt>
                <c:pt idx="270">
                  <c:v>49.765163778967398</c:v>
                </c:pt>
                <c:pt idx="271">
                  <c:v>61.623355253410502</c:v>
                </c:pt>
                <c:pt idx="272">
                  <c:v>32.918851551533301</c:v>
                </c:pt>
                <c:pt idx="273">
                  <c:v>43.388638800723101</c:v>
                </c:pt>
                <c:pt idx="274">
                  <c:v>60.609318615525503</c:v>
                </c:pt>
                <c:pt idx="275">
                  <c:v>63.064100310151197</c:v>
                </c:pt>
                <c:pt idx="276">
                  <c:v>32.4962147027219</c:v>
                </c:pt>
                <c:pt idx="277">
                  <c:v>58.957866142950202</c:v>
                </c:pt>
                <c:pt idx="278">
                  <c:v>41.316779690310597</c:v>
                </c:pt>
                <c:pt idx="279">
                  <c:v>52.326392150361897</c:v>
                </c:pt>
                <c:pt idx="280">
                  <c:v>62.787637125143704</c:v>
                </c:pt>
                <c:pt idx="281">
                  <c:v>64.568523738090605</c:v>
                </c:pt>
                <c:pt idx="282">
                  <c:v>58.071389846438898</c:v>
                </c:pt>
                <c:pt idx="283">
                  <c:v>51.754538072477203</c:v>
                </c:pt>
                <c:pt idx="284">
                  <c:v>55.174748251138801</c:v>
                </c:pt>
                <c:pt idx="285">
                  <c:v>53.095891989383297</c:v>
                </c:pt>
                <c:pt idx="286">
                  <c:v>44.844932333790403</c:v>
                </c:pt>
                <c:pt idx="287">
                  <c:v>69.430604336269397</c:v>
                </c:pt>
                <c:pt idx="288">
                  <c:v>58.472214987243703</c:v>
                </c:pt>
                <c:pt idx="289">
                  <c:v>59.932507698279501</c:v>
                </c:pt>
                <c:pt idx="290">
                  <c:v>59.966679205323103</c:v>
                </c:pt>
                <c:pt idx="291">
                  <c:v>49.6493396048718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D66-4A70-8549-44361CEE7FA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3284096"/>
        <c:axId val="33285632"/>
      </c:scatterChart>
      <c:valAx>
        <c:axId val="3328409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285632"/>
        <c:crosses val="autoZero"/>
        <c:crossBetween val="midCat"/>
      </c:valAx>
      <c:valAx>
        <c:axId val="332856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28409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sz="1862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sz="2000" b="1" i="0" u="none" strike="noStrike" kern="1200" spc="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%PodSet-GY</a:t>
            </a:r>
          </a:p>
        </c:rich>
      </c:tx>
      <c:layout>
        <c:manualLayout>
          <c:xMode val="edge"/>
          <c:yMode val="edge"/>
          <c:x val="0.32421522309711287"/>
          <c:y val="1.322751322751322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sz="1862" b="0" i="0" u="none" strike="noStrike" kern="1200" spc="0" baseline="0">
              <a:solidFill>
                <a:prstClr val="black">
                  <a:lumMod val="65000"/>
                  <a:lumOff val="35000"/>
                </a:prst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Sheet1!$H$1</c:f>
              <c:strCache>
                <c:ptCount val="1"/>
                <c:pt idx="0">
                  <c:v>GY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8.652843394575678E-2"/>
                  <c:y val="-0.25029822661056256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 algn="ctr" rtl="0">
                      <a:defRPr sz="1197" b="0" i="0" u="none" strike="noStrike" kern="1200" baseline="0">
                        <a:solidFill>
                          <a:prstClr val="black">
                            <a:lumMod val="65000"/>
                            <a:lumOff val="35000"/>
                          </a:prst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rPr>
                      <a:t>y = 0.8045x + 22.59</a:t>
                    </a:r>
                    <a:b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rPr>
                    </a:br>
                    <a: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rPr>
                      <a:t>R² = 0.4786</a:t>
                    </a: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 algn="ctr" rtl="0">
                    <a:defRPr sz="1197" b="0" i="0" u="none" strike="noStrike" kern="1200" baseline="0">
                      <a:solidFill>
                        <a:prstClr val="black">
                          <a:lumMod val="65000"/>
                          <a:lumOff val="35000"/>
                        </a:prst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Sheet1!$G$2:$G$293</c:f>
              <c:numCache>
                <c:formatCode>0.00</c:formatCode>
                <c:ptCount val="292"/>
                <c:pt idx="0">
                  <c:v>42.452505315577199</c:v>
                </c:pt>
                <c:pt idx="1">
                  <c:v>35.936882827436897</c:v>
                </c:pt>
                <c:pt idx="2">
                  <c:v>34.398481795115998</c:v>
                </c:pt>
                <c:pt idx="3">
                  <c:v>54.674672531880297</c:v>
                </c:pt>
                <c:pt idx="4">
                  <c:v>52.6651340527713</c:v>
                </c:pt>
                <c:pt idx="5">
                  <c:v>47.464294548784601</c:v>
                </c:pt>
                <c:pt idx="6">
                  <c:v>37.555571007738699</c:v>
                </c:pt>
                <c:pt idx="7">
                  <c:v>44.866000396971799</c:v>
                </c:pt>
                <c:pt idx="8">
                  <c:v>23.532899214352</c:v>
                </c:pt>
                <c:pt idx="9">
                  <c:v>35.192566935772</c:v>
                </c:pt>
                <c:pt idx="10">
                  <c:v>31.978297925589899</c:v>
                </c:pt>
                <c:pt idx="11">
                  <c:v>41.497038814702499</c:v>
                </c:pt>
                <c:pt idx="12">
                  <c:v>33.688044673329003</c:v>
                </c:pt>
                <c:pt idx="13">
                  <c:v>33.699724812637299</c:v>
                </c:pt>
                <c:pt idx="14">
                  <c:v>38.375041379090199</c:v>
                </c:pt>
                <c:pt idx="15">
                  <c:v>33.523866192939998</c:v>
                </c:pt>
                <c:pt idx="16">
                  <c:v>30.009871111335201</c:v>
                </c:pt>
                <c:pt idx="17">
                  <c:v>54.640353072550496</c:v>
                </c:pt>
                <c:pt idx="18">
                  <c:v>35.605732177571397</c:v>
                </c:pt>
                <c:pt idx="19">
                  <c:v>45.432552555485003</c:v>
                </c:pt>
                <c:pt idx="20">
                  <c:v>34.5921288033393</c:v>
                </c:pt>
                <c:pt idx="21">
                  <c:v>26.054299253525599</c:v>
                </c:pt>
                <c:pt idx="22">
                  <c:v>46.6221430454274</c:v>
                </c:pt>
                <c:pt idx="23">
                  <c:v>38.078007782062102</c:v>
                </c:pt>
                <c:pt idx="24">
                  <c:v>35.934076680708003</c:v>
                </c:pt>
                <c:pt idx="25">
                  <c:v>2.6085154582358698</c:v>
                </c:pt>
                <c:pt idx="26">
                  <c:v>40.702802913711501</c:v>
                </c:pt>
                <c:pt idx="27">
                  <c:v>31.973941491576898</c:v>
                </c:pt>
                <c:pt idx="28">
                  <c:v>44.219325818479099</c:v>
                </c:pt>
                <c:pt idx="29">
                  <c:v>35.042563480418998</c:v>
                </c:pt>
                <c:pt idx="30">
                  <c:v>35.3702608085677</c:v>
                </c:pt>
                <c:pt idx="31">
                  <c:v>40.090406861548402</c:v>
                </c:pt>
                <c:pt idx="32">
                  <c:v>44.413257790781202</c:v>
                </c:pt>
                <c:pt idx="33">
                  <c:v>63.852714714856603</c:v>
                </c:pt>
                <c:pt idx="34">
                  <c:v>48.9606871115177</c:v>
                </c:pt>
                <c:pt idx="35">
                  <c:v>24.371929198654399</c:v>
                </c:pt>
                <c:pt idx="36">
                  <c:v>39.855124822334901</c:v>
                </c:pt>
                <c:pt idx="37">
                  <c:v>39.144306404206503</c:v>
                </c:pt>
                <c:pt idx="38">
                  <c:v>39.952786246574703</c:v>
                </c:pt>
                <c:pt idx="39">
                  <c:v>54.390566526209803</c:v>
                </c:pt>
                <c:pt idx="40">
                  <c:v>46.690946103671202</c:v>
                </c:pt>
                <c:pt idx="41">
                  <c:v>47.536565504965203</c:v>
                </c:pt>
                <c:pt idx="42">
                  <c:v>30.670733012253301</c:v>
                </c:pt>
                <c:pt idx="43">
                  <c:v>21.166792754121602</c:v>
                </c:pt>
                <c:pt idx="44">
                  <c:v>40.2866034735939</c:v>
                </c:pt>
                <c:pt idx="45">
                  <c:v>26.256348393143199</c:v>
                </c:pt>
                <c:pt idx="46">
                  <c:v>15.273554152732499</c:v>
                </c:pt>
                <c:pt idx="47">
                  <c:v>40.213986549000097</c:v>
                </c:pt>
                <c:pt idx="48">
                  <c:v>49.116977451992298</c:v>
                </c:pt>
                <c:pt idx="49">
                  <c:v>28.859726100634202</c:v>
                </c:pt>
                <c:pt idx="50">
                  <c:v>39.760515166477298</c:v>
                </c:pt>
                <c:pt idx="51">
                  <c:v>25.891950892878899</c:v>
                </c:pt>
                <c:pt idx="52">
                  <c:v>48.388238305469201</c:v>
                </c:pt>
                <c:pt idx="53">
                  <c:v>46.852390714716798</c:v>
                </c:pt>
                <c:pt idx="54">
                  <c:v>51.171290779974598</c:v>
                </c:pt>
                <c:pt idx="55">
                  <c:v>43.425718589418302</c:v>
                </c:pt>
                <c:pt idx="56">
                  <c:v>45.858931040015001</c:v>
                </c:pt>
                <c:pt idx="57">
                  <c:v>39.958461388338499</c:v>
                </c:pt>
                <c:pt idx="58">
                  <c:v>40.370453967061401</c:v>
                </c:pt>
                <c:pt idx="59">
                  <c:v>24.1318746298153</c:v>
                </c:pt>
                <c:pt idx="60">
                  <c:v>57.490107904128898</c:v>
                </c:pt>
                <c:pt idx="61">
                  <c:v>31.550111247482299</c:v>
                </c:pt>
                <c:pt idx="62">
                  <c:v>27.4353478953932</c:v>
                </c:pt>
                <c:pt idx="63">
                  <c:v>14.341639622320001</c:v>
                </c:pt>
                <c:pt idx="64">
                  <c:v>46.244909542127502</c:v>
                </c:pt>
                <c:pt idx="65">
                  <c:v>32.403286538482398</c:v>
                </c:pt>
                <c:pt idx="66">
                  <c:v>35.0321589648537</c:v>
                </c:pt>
                <c:pt idx="67">
                  <c:v>41.867795157861799</c:v>
                </c:pt>
                <c:pt idx="68">
                  <c:v>24.555234593219701</c:v>
                </c:pt>
                <c:pt idx="69">
                  <c:v>35.424787248843998</c:v>
                </c:pt>
                <c:pt idx="70">
                  <c:v>13.191336576489601</c:v>
                </c:pt>
                <c:pt idx="71">
                  <c:v>31.0310448441764</c:v>
                </c:pt>
                <c:pt idx="72">
                  <c:v>48.302130199795599</c:v>
                </c:pt>
                <c:pt idx="73">
                  <c:v>39.0394216836456</c:v>
                </c:pt>
                <c:pt idx="74">
                  <c:v>53.259291350026999</c:v>
                </c:pt>
                <c:pt idx="75">
                  <c:v>27.8853980667147</c:v>
                </c:pt>
                <c:pt idx="76">
                  <c:v>46.725881339870199</c:v>
                </c:pt>
                <c:pt idx="77">
                  <c:v>40.953766169972901</c:v>
                </c:pt>
                <c:pt idx="78">
                  <c:v>32.935709865836799</c:v>
                </c:pt>
                <c:pt idx="79">
                  <c:v>30.3811817559031</c:v>
                </c:pt>
                <c:pt idx="80">
                  <c:v>47.188265879022097</c:v>
                </c:pt>
                <c:pt idx="81">
                  <c:v>46.157032361508001</c:v>
                </c:pt>
                <c:pt idx="82">
                  <c:v>28.030985128027599</c:v>
                </c:pt>
                <c:pt idx="83">
                  <c:v>41.422051289128198</c:v>
                </c:pt>
                <c:pt idx="84">
                  <c:v>30.801973509339</c:v>
                </c:pt>
                <c:pt idx="85">
                  <c:v>22.679212575355301</c:v>
                </c:pt>
                <c:pt idx="86">
                  <c:v>27.089206113783401</c:v>
                </c:pt>
                <c:pt idx="87">
                  <c:v>19.789079044043699</c:v>
                </c:pt>
                <c:pt idx="88">
                  <c:v>23.305463748576098</c:v>
                </c:pt>
                <c:pt idx="89">
                  <c:v>35.757637634252902</c:v>
                </c:pt>
                <c:pt idx="90">
                  <c:v>44.465576627984802</c:v>
                </c:pt>
                <c:pt idx="91">
                  <c:v>37.374792515476202</c:v>
                </c:pt>
                <c:pt idx="92">
                  <c:v>29.209364955547301</c:v>
                </c:pt>
                <c:pt idx="93">
                  <c:v>33.343287434905598</c:v>
                </c:pt>
                <c:pt idx="94">
                  <c:v>34.228471290518698</c:v>
                </c:pt>
                <c:pt idx="95">
                  <c:v>25.663959604605999</c:v>
                </c:pt>
                <c:pt idx="96">
                  <c:v>26.729764813869298</c:v>
                </c:pt>
                <c:pt idx="97">
                  <c:v>40.108202840598103</c:v>
                </c:pt>
                <c:pt idx="98">
                  <c:v>42.575114755191102</c:v>
                </c:pt>
                <c:pt idx="99">
                  <c:v>35.613140540887997</c:v>
                </c:pt>
                <c:pt idx="100">
                  <c:v>40.475636494023398</c:v>
                </c:pt>
                <c:pt idx="101">
                  <c:v>42.498742422754198</c:v>
                </c:pt>
                <c:pt idx="102">
                  <c:v>48.061629599207798</c:v>
                </c:pt>
                <c:pt idx="103">
                  <c:v>27.250840065820999</c:v>
                </c:pt>
                <c:pt idx="104">
                  <c:v>35.891203844885098</c:v>
                </c:pt>
                <c:pt idx="105">
                  <c:v>44.491987200693899</c:v>
                </c:pt>
                <c:pt idx="106">
                  <c:v>46.036777062760301</c:v>
                </c:pt>
                <c:pt idx="107">
                  <c:v>44.291768174581698</c:v>
                </c:pt>
                <c:pt idx="108">
                  <c:v>38.597381033792601</c:v>
                </c:pt>
                <c:pt idx="109">
                  <c:v>43.937016756329697</c:v>
                </c:pt>
                <c:pt idx="110">
                  <c:v>54.115645148770902</c:v>
                </c:pt>
                <c:pt idx="111">
                  <c:v>25.530860273895399</c:v>
                </c:pt>
                <c:pt idx="112">
                  <c:v>23.490960656531598</c:v>
                </c:pt>
                <c:pt idx="113">
                  <c:v>49.663664476250901</c:v>
                </c:pt>
                <c:pt idx="114">
                  <c:v>36.804176458190497</c:v>
                </c:pt>
                <c:pt idx="115">
                  <c:v>47.651536979035498</c:v>
                </c:pt>
                <c:pt idx="116">
                  <c:v>39.996619992946599</c:v>
                </c:pt>
                <c:pt idx="117">
                  <c:v>25.600138629550202</c:v>
                </c:pt>
                <c:pt idx="118">
                  <c:v>50.870597937621397</c:v>
                </c:pt>
                <c:pt idx="119">
                  <c:v>23.897167747293899</c:v>
                </c:pt>
                <c:pt idx="120">
                  <c:v>30.125014358791301</c:v>
                </c:pt>
                <c:pt idx="121">
                  <c:v>32.757916231042302</c:v>
                </c:pt>
                <c:pt idx="122">
                  <c:v>46.366803995754601</c:v>
                </c:pt>
                <c:pt idx="123">
                  <c:v>42.0762606256095</c:v>
                </c:pt>
                <c:pt idx="124">
                  <c:v>50.475166908122802</c:v>
                </c:pt>
                <c:pt idx="125">
                  <c:v>37.859638373052697</c:v>
                </c:pt>
                <c:pt idx="126">
                  <c:v>44.290702090023103</c:v>
                </c:pt>
                <c:pt idx="127">
                  <c:v>49.139508284858302</c:v>
                </c:pt>
                <c:pt idx="128">
                  <c:v>44.8787846001199</c:v>
                </c:pt>
                <c:pt idx="129">
                  <c:v>47.714933560878102</c:v>
                </c:pt>
                <c:pt idx="130">
                  <c:v>36.188088015314101</c:v>
                </c:pt>
                <c:pt idx="131">
                  <c:v>34.669328397329103</c:v>
                </c:pt>
                <c:pt idx="132">
                  <c:v>43.272017874564298</c:v>
                </c:pt>
                <c:pt idx="133">
                  <c:v>34.712225022530397</c:v>
                </c:pt>
                <c:pt idx="134">
                  <c:v>43.029354875788002</c:v>
                </c:pt>
                <c:pt idx="135">
                  <c:v>39.9074411051308</c:v>
                </c:pt>
                <c:pt idx="136">
                  <c:v>26.614854225674801</c:v>
                </c:pt>
                <c:pt idx="137">
                  <c:v>44.608826069553302</c:v>
                </c:pt>
                <c:pt idx="138">
                  <c:v>25.589262155597002</c:v>
                </c:pt>
                <c:pt idx="139">
                  <c:v>47.047607278995301</c:v>
                </c:pt>
                <c:pt idx="140">
                  <c:v>42.785720745122802</c:v>
                </c:pt>
                <c:pt idx="141">
                  <c:v>34.298580855184397</c:v>
                </c:pt>
                <c:pt idx="142">
                  <c:v>26.7932070879191</c:v>
                </c:pt>
                <c:pt idx="143">
                  <c:v>38.0535432973575</c:v>
                </c:pt>
                <c:pt idx="144">
                  <c:v>44.908335078788902</c:v>
                </c:pt>
                <c:pt idx="145">
                  <c:v>31.512278614502101</c:v>
                </c:pt>
                <c:pt idx="146">
                  <c:v>42.472523576507797</c:v>
                </c:pt>
                <c:pt idx="147">
                  <c:v>32.702506129817998</c:v>
                </c:pt>
                <c:pt idx="148">
                  <c:v>40.367664120388902</c:v>
                </c:pt>
                <c:pt idx="149">
                  <c:v>37.131753734241897</c:v>
                </c:pt>
                <c:pt idx="150">
                  <c:v>37.786057497393301</c:v>
                </c:pt>
                <c:pt idx="151">
                  <c:v>46.654444338453501</c:v>
                </c:pt>
                <c:pt idx="152">
                  <c:v>46.521954712533798</c:v>
                </c:pt>
                <c:pt idx="153">
                  <c:v>32.419976889047398</c:v>
                </c:pt>
                <c:pt idx="154">
                  <c:v>30.429756089986199</c:v>
                </c:pt>
                <c:pt idx="155">
                  <c:v>37.084681651887898</c:v>
                </c:pt>
                <c:pt idx="156">
                  <c:v>20.7159524726307</c:v>
                </c:pt>
                <c:pt idx="157">
                  <c:v>44.043650147033397</c:v>
                </c:pt>
                <c:pt idx="158">
                  <c:v>40.4546820572765</c:v>
                </c:pt>
                <c:pt idx="159">
                  <c:v>39.019316516118202</c:v>
                </c:pt>
                <c:pt idx="160">
                  <c:v>47.033440107403301</c:v>
                </c:pt>
                <c:pt idx="161">
                  <c:v>50.147906769928603</c:v>
                </c:pt>
                <c:pt idx="162">
                  <c:v>33.990324356268403</c:v>
                </c:pt>
                <c:pt idx="163">
                  <c:v>45.8872229294359</c:v>
                </c:pt>
                <c:pt idx="164">
                  <c:v>45.4063012312116</c:v>
                </c:pt>
                <c:pt idx="165">
                  <c:v>33.423730213467401</c:v>
                </c:pt>
                <c:pt idx="166">
                  <c:v>28.3863112656182</c:v>
                </c:pt>
                <c:pt idx="167">
                  <c:v>25.9157252610215</c:v>
                </c:pt>
                <c:pt idx="168">
                  <c:v>42.380173419372198</c:v>
                </c:pt>
                <c:pt idx="169">
                  <c:v>44.167032401147203</c:v>
                </c:pt>
                <c:pt idx="170">
                  <c:v>38.828907397476897</c:v>
                </c:pt>
                <c:pt idx="171">
                  <c:v>46.388890047693998</c:v>
                </c:pt>
                <c:pt idx="172">
                  <c:v>39.1086785374386</c:v>
                </c:pt>
                <c:pt idx="173">
                  <c:v>31.545717954069602</c:v>
                </c:pt>
                <c:pt idx="174">
                  <c:v>42.042794592963702</c:v>
                </c:pt>
                <c:pt idx="175">
                  <c:v>42.146993110595403</c:v>
                </c:pt>
                <c:pt idx="176">
                  <c:v>39.706720959617101</c:v>
                </c:pt>
                <c:pt idx="177">
                  <c:v>58.415550185759699</c:v>
                </c:pt>
                <c:pt idx="178">
                  <c:v>34.575980645650198</c:v>
                </c:pt>
                <c:pt idx="179">
                  <c:v>37.7925979780007</c:v>
                </c:pt>
                <c:pt idx="180">
                  <c:v>29.827055899044101</c:v>
                </c:pt>
                <c:pt idx="181">
                  <c:v>32.846123288394402</c:v>
                </c:pt>
                <c:pt idx="182">
                  <c:v>59.015920991999899</c:v>
                </c:pt>
                <c:pt idx="183">
                  <c:v>20.5059866111513</c:v>
                </c:pt>
                <c:pt idx="184">
                  <c:v>38.817096222411202</c:v>
                </c:pt>
                <c:pt idx="185">
                  <c:v>38.160894956867097</c:v>
                </c:pt>
                <c:pt idx="186">
                  <c:v>34.6073802071271</c:v>
                </c:pt>
                <c:pt idx="187">
                  <c:v>37.528482130006502</c:v>
                </c:pt>
                <c:pt idx="188">
                  <c:v>46.692436709989799</c:v>
                </c:pt>
                <c:pt idx="189">
                  <c:v>44.321068119611297</c:v>
                </c:pt>
                <c:pt idx="190">
                  <c:v>42.566810633264197</c:v>
                </c:pt>
                <c:pt idx="191">
                  <c:v>43.911888082256397</c:v>
                </c:pt>
                <c:pt idx="192">
                  <c:v>48.015346485324798</c:v>
                </c:pt>
                <c:pt idx="193">
                  <c:v>37.655157892325199</c:v>
                </c:pt>
                <c:pt idx="194">
                  <c:v>25.651449614291899</c:v>
                </c:pt>
                <c:pt idx="195">
                  <c:v>30.179496613956399</c:v>
                </c:pt>
                <c:pt idx="196">
                  <c:v>55.520361309433497</c:v>
                </c:pt>
                <c:pt idx="197">
                  <c:v>20.3376856811316</c:v>
                </c:pt>
                <c:pt idx="198">
                  <c:v>35.8950065877859</c:v>
                </c:pt>
                <c:pt idx="199">
                  <c:v>50.147715198023803</c:v>
                </c:pt>
                <c:pt idx="200">
                  <c:v>26.424915758071101</c:v>
                </c:pt>
                <c:pt idx="201">
                  <c:v>34.760209272327003</c:v>
                </c:pt>
                <c:pt idx="202">
                  <c:v>38.480532164640202</c:v>
                </c:pt>
                <c:pt idx="203">
                  <c:v>29.907098214387201</c:v>
                </c:pt>
                <c:pt idx="204">
                  <c:v>37.902423685329303</c:v>
                </c:pt>
                <c:pt idx="205">
                  <c:v>21.0491808566453</c:v>
                </c:pt>
                <c:pt idx="206">
                  <c:v>42.947400129911699</c:v>
                </c:pt>
                <c:pt idx="207">
                  <c:v>30.005203603044599</c:v>
                </c:pt>
                <c:pt idx="208">
                  <c:v>43.714459540397399</c:v>
                </c:pt>
                <c:pt idx="209">
                  <c:v>37.689304267693402</c:v>
                </c:pt>
                <c:pt idx="210">
                  <c:v>39.626306684776097</c:v>
                </c:pt>
                <c:pt idx="211">
                  <c:v>38.509386998306802</c:v>
                </c:pt>
                <c:pt idx="212">
                  <c:v>41.811810966076401</c:v>
                </c:pt>
                <c:pt idx="213">
                  <c:v>36.655671978535203</c:v>
                </c:pt>
                <c:pt idx="214">
                  <c:v>33.456673049801203</c:v>
                </c:pt>
                <c:pt idx="215">
                  <c:v>37.223866502141703</c:v>
                </c:pt>
                <c:pt idx="216">
                  <c:v>28.217198798835099</c:v>
                </c:pt>
                <c:pt idx="217">
                  <c:v>34.3430643501299</c:v>
                </c:pt>
                <c:pt idx="218">
                  <c:v>18.600725710379901</c:v>
                </c:pt>
                <c:pt idx="219">
                  <c:v>44.800856852600702</c:v>
                </c:pt>
                <c:pt idx="220">
                  <c:v>19.055717750279499</c:v>
                </c:pt>
                <c:pt idx="221">
                  <c:v>28.325701872547199</c:v>
                </c:pt>
                <c:pt idx="222">
                  <c:v>48.442470943132598</c:v>
                </c:pt>
                <c:pt idx="223">
                  <c:v>28.849069192693701</c:v>
                </c:pt>
                <c:pt idx="224">
                  <c:v>37.217352635716701</c:v>
                </c:pt>
                <c:pt idx="225">
                  <c:v>45.824075244132999</c:v>
                </c:pt>
                <c:pt idx="226">
                  <c:v>33.165606214798103</c:v>
                </c:pt>
                <c:pt idx="227">
                  <c:v>25.227670369873799</c:v>
                </c:pt>
                <c:pt idx="228">
                  <c:v>50.529180243205701</c:v>
                </c:pt>
                <c:pt idx="229">
                  <c:v>39.325353446249103</c:v>
                </c:pt>
                <c:pt idx="230">
                  <c:v>44.791131405724599</c:v>
                </c:pt>
                <c:pt idx="231">
                  <c:v>24.843106814998901</c:v>
                </c:pt>
                <c:pt idx="232">
                  <c:v>42.708180844973299</c:v>
                </c:pt>
                <c:pt idx="233">
                  <c:v>32.053939422656804</c:v>
                </c:pt>
                <c:pt idx="234">
                  <c:v>36.908565547512097</c:v>
                </c:pt>
                <c:pt idx="235">
                  <c:v>23.938087315053899</c:v>
                </c:pt>
                <c:pt idx="236">
                  <c:v>35.926181786937001</c:v>
                </c:pt>
                <c:pt idx="237">
                  <c:v>20.918781143580599</c:v>
                </c:pt>
                <c:pt idx="238">
                  <c:v>44.8174557709292</c:v>
                </c:pt>
                <c:pt idx="239">
                  <c:v>33.607257268185499</c:v>
                </c:pt>
                <c:pt idx="240">
                  <c:v>35.8853099415768</c:v>
                </c:pt>
                <c:pt idx="241">
                  <c:v>37.934746495004603</c:v>
                </c:pt>
                <c:pt idx="242">
                  <c:v>43.7893111558637</c:v>
                </c:pt>
                <c:pt idx="243">
                  <c:v>46.233777122037502</c:v>
                </c:pt>
                <c:pt idx="244">
                  <c:v>54.579081089695798</c:v>
                </c:pt>
                <c:pt idx="245">
                  <c:v>40.345430493029703</c:v>
                </c:pt>
                <c:pt idx="246">
                  <c:v>46.658565417499403</c:v>
                </c:pt>
                <c:pt idx="247">
                  <c:v>12.306598043095899</c:v>
                </c:pt>
                <c:pt idx="248">
                  <c:v>49.536008320485401</c:v>
                </c:pt>
                <c:pt idx="249">
                  <c:v>26.1677678666947</c:v>
                </c:pt>
                <c:pt idx="250">
                  <c:v>46.929368133159898</c:v>
                </c:pt>
                <c:pt idx="251">
                  <c:v>41.186007865332598</c:v>
                </c:pt>
                <c:pt idx="252">
                  <c:v>41.172607073240101</c:v>
                </c:pt>
                <c:pt idx="253">
                  <c:v>46.701795204509601</c:v>
                </c:pt>
                <c:pt idx="254">
                  <c:v>46.403998812622198</c:v>
                </c:pt>
                <c:pt idx="255">
                  <c:v>23.589735451473899</c:v>
                </c:pt>
                <c:pt idx="256">
                  <c:v>31.814893664310599</c:v>
                </c:pt>
                <c:pt idx="257">
                  <c:v>48.4735708830231</c:v>
                </c:pt>
                <c:pt idx="258">
                  <c:v>50.479637400604801</c:v>
                </c:pt>
                <c:pt idx="259">
                  <c:v>34.098827164015198</c:v>
                </c:pt>
                <c:pt idx="260">
                  <c:v>32.782271329064002</c:v>
                </c:pt>
                <c:pt idx="261">
                  <c:v>37.440306718044603</c:v>
                </c:pt>
                <c:pt idx="262">
                  <c:v>45.915037721620699</c:v>
                </c:pt>
                <c:pt idx="263">
                  <c:v>39.211413567498099</c:v>
                </c:pt>
                <c:pt idx="264">
                  <c:v>30.765960017202399</c:v>
                </c:pt>
                <c:pt idx="265">
                  <c:v>54.568625044782301</c:v>
                </c:pt>
                <c:pt idx="266">
                  <c:v>36.3778242896271</c:v>
                </c:pt>
                <c:pt idx="267">
                  <c:v>36.333601386660398</c:v>
                </c:pt>
                <c:pt idx="268">
                  <c:v>33.211508069314803</c:v>
                </c:pt>
                <c:pt idx="269">
                  <c:v>39.553747451458101</c:v>
                </c:pt>
                <c:pt idx="270">
                  <c:v>38.372494034038098</c:v>
                </c:pt>
                <c:pt idx="271">
                  <c:v>47.036364190757098</c:v>
                </c:pt>
                <c:pt idx="272">
                  <c:v>20.4232150301738</c:v>
                </c:pt>
                <c:pt idx="273">
                  <c:v>24.234543341938</c:v>
                </c:pt>
                <c:pt idx="274">
                  <c:v>42.463876338977698</c:v>
                </c:pt>
                <c:pt idx="275">
                  <c:v>38.0948758297884</c:v>
                </c:pt>
                <c:pt idx="276">
                  <c:v>33.579416651736302</c:v>
                </c:pt>
                <c:pt idx="277">
                  <c:v>46.859746449222499</c:v>
                </c:pt>
                <c:pt idx="278">
                  <c:v>32.889883330264603</c:v>
                </c:pt>
                <c:pt idx="279">
                  <c:v>49.516098193979502</c:v>
                </c:pt>
                <c:pt idx="280">
                  <c:v>40.696489991453703</c:v>
                </c:pt>
                <c:pt idx="281">
                  <c:v>53.826292180262001</c:v>
                </c:pt>
                <c:pt idx="282">
                  <c:v>46.9842617041691</c:v>
                </c:pt>
                <c:pt idx="283">
                  <c:v>39.912666878435999</c:v>
                </c:pt>
                <c:pt idx="284">
                  <c:v>33.849716923468897</c:v>
                </c:pt>
                <c:pt idx="285">
                  <c:v>31.200714908923398</c:v>
                </c:pt>
                <c:pt idx="286">
                  <c:v>41.105371495282903</c:v>
                </c:pt>
                <c:pt idx="287">
                  <c:v>50.1652921147302</c:v>
                </c:pt>
                <c:pt idx="288">
                  <c:v>59.287960174299101</c:v>
                </c:pt>
                <c:pt idx="289">
                  <c:v>29.850721143383002</c:v>
                </c:pt>
                <c:pt idx="290">
                  <c:v>35.501377730286997</c:v>
                </c:pt>
                <c:pt idx="291">
                  <c:v>31.971950487362701</c:v>
                </c:pt>
              </c:numCache>
            </c:numRef>
          </c:xVal>
          <c:yVal>
            <c:numRef>
              <c:f>Sheet1!$H$2:$H$293</c:f>
              <c:numCache>
                <c:formatCode>0.00</c:formatCode>
                <c:ptCount val="292"/>
                <c:pt idx="0">
                  <c:v>56.972077100385398</c:v>
                </c:pt>
                <c:pt idx="1">
                  <c:v>50.274495062583703</c:v>
                </c:pt>
                <c:pt idx="2">
                  <c:v>51.893962270069103</c:v>
                </c:pt>
                <c:pt idx="3">
                  <c:v>71.713090752602795</c:v>
                </c:pt>
                <c:pt idx="4">
                  <c:v>50.053466729707203</c:v>
                </c:pt>
                <c:pt idx="5">
                  <c:v>57.995876173584897</c:v>
                </c:pt>
                <c:pt idx="6">
                  <c:v>61.7723183678198</c:v>
                </c:pt>
                <c:pt idx="7">
                  <c:v>61.180472178970199</c:v>
                </c:pt>
                <c:pt idx="8">
                  <c:v>44.037192089527601</c:v>
                </c:pt>
                <c:pt idx="9">
                  <c:v>50.879199692966601</c:v>
                </c:pt>
                <c:pt idx="10">
                  <c:v>50.302686169060799</c:v>
                </c:pt>
                <c:pt idx="11">
                  <c:v>54.101407795382499</c:v>
                </c:pt>
                <c:pt idx="12">
                  <c:v>56.347289590662399</c:v>
                </c:pt>
                <c:pt idx="13">
                  <c:v>56.779356748393703</c:v>
                </c:pt>
                <c:pt idx="14">
                  <c:v>47.872790316589096</c:v>
                </c:pt>
                <c:pt idx="15">
                  <c:v>46.936973608139702</c:v>
                </c:pt>
                <c:pt idx="16">
                  <c:v>42.991609451018903</c:v>
                </c:pt>
                <c:pt idx="17">
                  <c:v>53.781982524356799</c:v>
                </c:pt>
                <c:pt idx="18">
                  <c:v>56.869674615574503</c:v>
                </c:pt>
                <c:pt idx="19">
                  <c:v>53.646277321138598</c:v>
                </c:pt>
                <c:pt idx="20">
                  <c:v>48.098484237270803</c:v>
                </c:pt>
                <c:pt idx="21">
                  <c:v>40.027290026322</c:v>
                </c:pt>
                <c:pt idx="22">
                  <c:v>54.007265579851101</c:v>
                </c:pt>
                <c:pt idx="23">
                  <c:v>44.144985457485802</c:v>
                </c:pt>
                <c:pt idx="24">
                  <c:v>53.762647668883702</c:v>
                </c:pt>
                <c:pt idx="25">
                  <c:v>9.0131931736008006</c:v>
                </c:pt>
                <c:pt idx="26">
                  <c:v>52.398549481149097</c:v>
                </c:pt>
                <c:pt idx="27">
                  <c:v>57.434719609964901</c:v>
                </c:pt>
                <c:pt idx="28">
                  <c:v>47.967287803390398</c:v>
                </c:pt>
                <c:pt idx="29">
                  <c:v>36.310119942835698</c:v>
                </c:pt>
                <c:pt idx="30">
                  <c:v>55.676408319631101</c:v>
                </c:pt>
                <c:pt idx="31">
                  <c:v>48.581742345490099</c:v>
                </c:pt>
                <c:pt idx="32">
                  <c:v>62.594002300875502</c:v>
                </c:pt>
                <c:pt idx="33">
                  <c:v>59.854779654009597</c:v>
                </c:pt>
                <c:pt idx="34">
                  <c:v>54.451483677633703</c:v>
                </c:pt>
                <c:pt idx="35">
                  <c:v>38.007132229040202</c:v>
                </c:pt>
                <c:pt idx="36">
                  <c:v>62.626498851359003</c:v>
                </c:pt>
                <c:pt idx="37">
                  <c:v>57.662376091029998</c:v>
                </c:pt>
                <c:pt idx="38">
                  <c:v>53.879139369179299</c:v>
                </c:pt>
                <c:pt idx="39">
                  <c:v>55.809472138745598</c:v>
                </c:pt>
                <c:pt idx="40">
                  <c:v>58.794624656558298</c:v>
                </c:pt>
                <c:pt idx="41">
                  <c:v>60.375381862704003</c:v>
                </c:pt>
                <c:pt idx="42">
                  <c:v>41.696600406779197</c:v>
                </c:pt>
                <c:pt idx="43">
                  <c:v>26.2433277633552</c:v>
                </c:pt>
                <c:pt idx="44">
                  <c:v>58.641955807548101</c:v>
                </c:pt>
                <c:pt idx="45">
                  <c:v>36.4543313130388</c:v>
                </c:pt>
                <c:pt idx="46">
                  <c:v>21.785192929797201</c:v>
                </c:pt>
                <c:pt idx="47">
                  <c:v>64.993278644278902</c:v>
                </c:pt>
                <c:pt idx="48">
                  <c:v>61.614071168195402</c:v>
                </c:pt>
                <c:pt idx="49">
                  <c:v>49.677969121519403</c:v>
                </c:pt>
                <c:pt idx="50">
                  <c:v>47.505857965697899</c:v>
                </c:pt>
                <c:pt idx="51">
                  <c:v>38.737598262460899</c:v>
                </c:pt>
                <c:pt idx="52">
                  <c:v>70.781531285897103</c:v>
                </c:pt>
                <c:pt idx="53">
                  <c:v>62.907709950822202</c:v>
                </c:pt>
                <c:pt idx="54">
                  <c:v>61.335014178162801</c:v>
                </c:pt>
                <c:pt idx="55">
                  <c:v>56.919721777076802</c:v>
                </c:pt>
                <c:pt idx="56">
                  <c:v>52.448920107840401</c:v>
                </c:pt>
                <c:pt idx="57">
                  <c:v>49.935286212189098</c:v>
                </c:pt>
                <c:pt idx="58">
                  <c:v>52.909163062357997</c:v>
                </c:pt>
                <c:pt idx="59">
                  <c:v>28.537327549817299</c:v>
                </c:pt>
                <c:pt idx="60">
                  <c:v>72.2613551862256</c:v>
                </c:pt>
                <c:pt idx="61">
                  <c:v>55.991890964098801</c:v>
                </c:pt>
                <c:pt idx="62">
                  <c:v>56.114212597211299</c:v>
                </c:pt>
                <c:pt idx="63">
                  <c:v>27.575735701159999</c:v>
                </c:pt>
                <c:pt idx="64">
                  <c:v>55.569873870355202</c:v>
                </c:pt>
                <c:pt idx="65">
                  <c:v>53.895857340886302</c:v>
                </c:pt>
                <c:pt idx="66">
                  <c:v>49.875933443380902</c:v>
                </c:pt>
                <c:pt idx="67">
                  <c:v>46.410331813190403</c:v>
                </c:pt>
                <c:pt idx="68">
                  <c:v>38.706625116673301</c:v>
                </c:pt>
                <c:pt idx="69">
                  <c:v>49.195967025716698</c:v>
                </c:pt>
                <c:pt idx="70">
                  <c:v>26.5962564349357</c:v>
                </c:pt>
                <c:pt idx="71">
                  <c:v>29.163189362389101</c:v>
                </c:pt>
                <c:pt idx="72">
                  <c:v>49.660122124788501</c:v>
                </c:pt>
                <c:pt idx="73">
                  <c:v>42.178618792316598</c:v>
                </c:pt>
                <c:pt idx="74">
                  <c:v>82.350829867282002</c:v>
                </c:pt>
                <c:pt idx="75">
                  <c:v>60.671912046148798</c:v>
                </c:pt>
                <c:pt idx="76">
                  <c:v>60.504169400802198</c:v>
                </c:pt>
                <c:pt idx="77">
                  <c:v>48.896858626788699</c:v>
                </c:pt>
                <c:pt idx="78">
                  <c:v>63.628476899675597</c:v>
                </c:pt>
                <c:pt idx="79">
                  <c:v>34.696388549660398</c:v>
                </c:pt>
                <c:pt idx="80">
                  <c:v>42.325771435721897</c:v>
                </c:pt>
                <c:pt idx="81">
                  <c:v>77.710995594919694</c:v>
                </c:pt>
                <c:pt idx="82">
                  <c:v>41.556897161641103</c:v>
                </c:pt>
                <c:pt idx="83">
                  <c:v>59.164431243312002</c:v>
                </c:pt>
                <c:pt idx="84">
                  <c:v>56.008452316598699</c:v>
                </c:pt>
                <c:pt idx="85">
                  <c:v>44.163139359274098</c:v>
                </c:pt>
                <c:pt idx="86">
                  <c:v>41.953259237189698</c:v>
                </c:pt>
                <c:pt idx="87">
                  <c:v>40.528014882408897</c:v>
                </c:pt>
                <c:pt idx="88">
                  <c:v>35.529732105963497</c:v>
                </c:pt>
                <c:pt idx="89">
                  <c:v>42.404185261799498</c:v>
                </c:pt>
                <c:pt idx="90">
                  <c:v>52.576625844025799</c:v>
                </c:pt>
                <c:pt idx="91">
                  <c:v>51.104169695579998</c:v>
                </c:pt>
                <c:pt idx="92">
                  <c:v>55.760705799723297</c:v>
                </c:pt>
                <c:pt idx="93">
                  <c:v>54.631439628722099</c:v>
                </c:pt>
                <c:pt idx="94">
                  <c:v>58.180254171333502</c:v>
                </c:pt>
                <c:pt idx="95">
                  <c:v>45.070798536212799</c:v>
                </c:pt>
                <c:pt idx="96">
                  <c:v>47.922707330841099</c:v>
                </c:pt>
                <c:pt idx="97">
                  <c:v>54.428116453079099</c:v>
                </c:pt>
                <c:pt idx="98">
                  <c:v>58.625309188636201</c:v>
                </c:pt>
                <c:pt idx="99">
                  <c:v>59.299487585082801</c:v>
                </c:pt>
                <c:pt idx="100">
                  <c:v>60.443382341604</c:v>
                </c:pt>
                <c:pt idx="101">
                  <c:v>47.891579937556301</c:v>
                </c:pt>
                <c:pt idx="102">
                  <c:v>64.870201651673696</c:v>
                </c:pt>
                <c:pt idx="103">
                  <c:v>53.223518046519999</c:v>
                </c:pt>
                <c:pt idx="104">
                  <c:v>58.926591542835297</c:v>
                </c:pt>
                <c:pt idx="105">
                  <c:v>48.721980122787798</c:v>
                </c:pt>
                <c:pt idx="106">
                  <c:v>59.578476197647198</c:v>
                </c:pt>
                <c:pt idx="107">
                  <c:v>58.823210911687397</c:v>
                </c:pt>
                <c:pt idx="108">
                  <c:v>56.118116021475402</c:v>
                </c:pt>
                <c:pt idx="109">
                  <c:v>61.316908802032501</c:v>
                </c:pt>
                <c:pt idx="110">
                  <c:v>58.807713792167696</c:v>
                </c:pt>
                <c:pt idx="111">
                  <c:v>49.9405798905712</c:v>
                </c:pt>
                <c:pt idx="112">
                  <c:v>48.235066642264101</c:v>
                </c:pt>
                <c:pt idx="113">
                  <c:v>61.0272653661861</c:v>
                </c:pt>
                <c:pt idx="114">
                  <c:v>45.281684756388103</c:v>
                </c:pt>
                <c:pt idx="115">
                  <c:v>67.459578250342005</c:v>
                </c:pt>
                <c:pt idx="116">
                  <c:v>59.086077576673397</c:v>
                </c:pt>
                <c:pt idx="117">
                  <c:v>43.254642058866999</c:v>
                </c:pt>
                <c:pt idx="118">
                  <c:v>53.600342353512502</c:v>
                </c:pt>
                <c:pt idx="119">
                  <c:v>43.791365948270297</c:v>
                </c:pt>
                <c:pt idx="120">
                  <c:v>58.663991372634399</c:v>
                </c:pt>
                <c:pt idx="121">
                  <c:v>46.274977903686903</c:v>
                </c:pt>
                <c:pt idx="122">
                  <c:v>48.8320315144001</c:v>
                </c:pt>
                <c:pt idx="123">
                  <c:v>70.647393984881703</c:v>
                </c:pt>
                <c:pt idx="124">
                  <c:v>58.8909029726642</c:v>
                </c:pt>
                <c:pt idx="125">
                  <c:v>51.267353876218799</c:v>
                </c:pt>
                <c:pt idx="126">
                  <c:v>63.742125779656497</c:v>
                </c:pt>
                <c:pt idx="127">
                  <c:v>67.928542553243503</c:v>
                </c:pt>
                <c:pt idx="128">
                  <c:v>71.563198014722801</c:v>
                </c:pt>
                <c:pt idx="129">
                  <c:v>59.757550948477999</c:v>
                </c:pt>
                <c:pt idx="130">
                  <c:v>64.022905187432698</c:v>
                </c:pt>
                <c:pt idx="131">
                  <c:v>60.165871537049298</c:v>
                </c:pt>
                <c:pt idx="132">
                  <c:v>51.3146924951781</c:v>
                </c:pt>
                <c:pt idx="133">
                  <c:v>48.590047888970197</c:v>
                </c:pt>
                <c:pt idx="134">
                  <c:v>58.565460347918403</c:v>
                </c:pt>
                <c:pt idx="135">
                  <c:v>64.668024867013898</c:v>
                </c:pt>
                <c:pt idx="136">
                  <c:v>50.876788832705003</c:v>
                </c:pt>
                <c:pt idx="137">
                  <c:v>63.8255387105796</c:v>
                </c:pt>
                <c:pt idx="138">
                  <c:v>43.244778023986598</c:v>
                </c:pt>
                <c:pt idx="139">
                  <c:v>53.201433081363099</c:v>
                </c:pt>
                <c:pt idx="140">
                  <c:v>56.090280126204803</c:v>
                </c:pt>
                <c:pt idx="141">
                  <c:v>49.327301478742903</c:v>
                </c:pt>
                <c:pt idx="142">
                  <c:v>45.867252173397702</c:v>
                </c:pt>
                <c:pt idx="143">
                  <c:v>60.428261133375401</c:v>
                </c:pt>
                <c:pt idx="144">
                  <c:v>67.807811681852698</c:v>
                </c:pt>
                <c:pt idx="145">
                  <c:v>60.341604093229101</c:v>
                </c:pt>
                <c:pt idx="146">
                  <c:v>59.637683669478598</c:v>
                </c:pt>
                <c:pt idx="147">
                  <c:v>61.627867827255599</c:v>
                </c:pt>
                <c:pt idx="148">
                  <c:v>59.646336852831503</c:v>
                </c:pt>
                <c:pt idx="149">
                  <c:v>54.526691443738599</c:v>
                </c:pt>
                <c:pt idx="150">
                  <c:v>75.192574075260097</c:v>
                </c:pt>
                <c:pt idx="151">
                  <c:v>56.211653337613498</c:v>
                </c:pt>
                <c:pt idx="152">
                  <c:v>70.755365941206904</c:v>
                </c:pt>
                <c:pt idx="153">
                  <c:v>38.263261949967102</c:v>
                </c:pt>
                <c:pt idx="154">
                  <c:v>48.285999914370201</c:v>
                </c:pt>
                <c:pt idx="155">
                  <c:v>52.756648017187402</c:v>
                </c:pt>
                <c:pt idx="156">
                  <c:v>42.940091936150701</c:v>
                </c:pt>
                <c:pt idx="157">
                  <c:v>48.846795373706797</c:v>
                </c:pt>
                <c:pt idx="158">
                  <c:v>68.432772068902096</c:v>
                </c:pt>
                <c:pt idx="159">
                  <c:v>56.331199751485201</c:v>
                </c:pt>
                <c:pt idx="160">
                  <c:v>71.093857241296703</c:v>
                </c:pt>
                <c:pt idx="161">
                  <c:v>47.748863438948298</c:v>
                </c:pt>
                <c:pt idx="162">
                  <c:v>63.590925967021498</c:v>
                </c:pt>
                <c:pt idx="163">
                  <c:v>76.906317291512295</c:v>
                </c:pt>
                <c:pt idx="164">
                  <c:v>68.764591385139994</c:v>
                </c:pt>
                <c:pt idx="165">
                  <c:v>62.580621989055103</c:v>
                </c:pt>
                <c:pt idx="166">
                  <c:v>52.228071213885002</c:v>
                </c:pt>
                <c:pt idx="167">
                  <c:v>37.058168369218301</c:v>
                </c:pt>
                <c:pt idx="168">
                  <c:v>67.903632284165994</c:v>
                </c:pt>
                <c:pt idx="169">
                  <c:v>52.162654764120902</c:v>
                </c:pt>
                <c:pt idx="170">
                  <c:v>52.260963102452898</c:v>
                </c:pt>
                <c:pt idx="171">
                  <c:v>51.999256572090097</c:v>
                </c:pt>
                <c:pt idx="172">
                  <c:v>51.488832163144302</c:v>
                </c:pt>
                <c:pt idx="173">
                  <c:v>49.009171785412299</c:v>
                </c:pt>
                <c:pt idx="174">
                  <c:v>67.635396416586602</c:v>
                </c:pt>
                <c:pt idx="175">
                  <c:v>52.979734934627999</c:v>
                </c:pt>
                <c:pt idx="176">
                  <c:v>43.989570135946799</c:v>
                </c:pt>
                <c:pt idx="177">
                  <c:v>70.651179203688301</c:v>
                </c:pt>
                <c:pt idx="178">
                  <c:v>53.847698009892</c:v>
                </c:pt>
                <c:pt idx="179">
                  <c:v>64.782492550404001</c:v>
                </c:pt>
                <c:pt idx="180">
                  <c:v>51.687388166452699</c:v>
                </c:pt>
                <c:pt idx="181">
                  <c:v>45.101457423431498</c:v>
                </c:pt>
                <c:pt idx="182">
                  <c:v>66.063912205334603</c:v>
                </c:pt>
                <c:pt idx="183">
                  <c:v>27.985881561136299</c:v>
                </c:pt>
                <c:pt idx="184">
                  <c:v>54.2592113810665</c:v>
                </c:pt>
                <c:pt idx="185">
                  <c:v>49.840392025159403</c:v>
                </c:pt>
                <c:pt idx="186">
                  <c:v>54.637563790980899</c:v>
                </c:pt>
                <c:pt idx="187">
                  <c:v>67.109259900192598</c:v>
                </c:pt>
                <c:pt idx="188">
                  <c:v>60.1512922151976</c:v>
                </c:pt>
                <c:pt idx="189">
                  <c:v>55.223437037876998</c:v>
                </c:pt>
                <c:pt idx="190">
                  <c:v>56.6625362807412</c:v>
                </c:pt>
                <c:pt idx="191">
                  <c:v>50.815543978080903</c:v>
                </c:pt>
                <c:pt idx="192">
                  <c:v>75.606846539182101</c:v>
                </c:pt>
                <c:pt idx="193">
                  <c:v>46.9869152627167</c:v>
                </c:pt>
                <c:pt idx="194">
                  <c:v>47.520139698214102</c:v>
                </c:pt>
                <c:pt idx="195">
                  <c:v>46.315987902472699</c:v>
                </c:pt>
                <c:pt idx="196">
                  <c:v>65.286724821380005</c:v>
                </c:pt>
                <c:pt idx="197">
                  <c:v>60.324440640246202</c:v>
                </c:pt>
                <c:pt idx="198">
                  <c:v>49.851426262169099</c:v>
                </c:pt>
                <c:pt idx="199">
                  <c:v>70.412289309144398</c:v>
                </c:pt>
                <c:pt idx="200">
                  <c:v>31.308167787830399</c:v>
                </c:pt>
                <c:pt idx="201">
                  <c:v>59.223889368471497</c:v>
                </c:pt>
                <c:pt idx="202">
                  <c:v>59.001077672024998</c:v>
                </c:pt>
                <c:pt idx="203">
                  <c:v>45.433091166193201</c:v>
                </c:pt>
                <c:pt idx="204">
                  <c:v>52.952952822794799</c:v>
                </c:pt>
                <c:pt idx="205">
                  <c:v>31.934683259602</c:v>
                </c:pt>
                <c:pt idx="206">
                  <c:v>66.971362683960507</c:v>
                </c:pt>
                <c:pt idx="207">
                  <c:v>36.096375649022903</c:v>
                </c:pt>
                <c:pt idx="208">
                  <c:v>59.6412817803471</c:v>
                </c:pt>
                <c:pt idx="209">
                  <c:v>54.790189522879302</c:v>
                </c:pt>
                <c:pt idx="210">
                  <c:v>60.826313233139203</c:v>
                </c:pt>
                <c:pt idx="211">
                  <c:v>51.9356854990369</c:v>
                </c:pt>
                <c:pt idx="212">
                  <c:v>59.065201713704496</c:v>
                </c:pt>
                <c:pt idx="213">
                  <c:v>42.242472159188097</c:v>
                </c:pt>
                <c:pt idx="214">
                  <c:v>54.472301503230803</c:v>
                </c:pt>
                <c:pt idx="215">
                  <c:v>60.259387955799703</c:v>
                </c:pt>
                <c:pt idx="216">
                  <c:v>30.868899475521101</c:v>
                </c:pt>
                <c:pt idx="217">
                  <c:v>36.894735270520798</c:v>
                </c:pt>
                <c:pt idx="218">
                  <c:v>45.606245925547803</c:v>
                </c:pt>
                <c:pt idx="219">
                  <c:v>55.843714523368703</c:v>
                </c:pt>
                <c:pt idx="220">
                  <c:v>31.155211776591798</c:v>
                </c:pt>
                <c:pt idx="221">
                  <c:v>50.748057305221799</c:v>
                </c:pt>
                <c:pt idx="222">
                  <c:v>58.0290247415492</c:v>
                </c:pt>
                <c:pt idx="223">
                  <c:v>41.000284984001802</c:v>
                </c:pt>
                <c:pt idx="224">
                  <c:v>54.068462339065903</c:v>
                </c:pt>
                <c:pt idx="225">
                  <c:v>69.137858767567394</c:v>
                </c:pt>
                <c:pt idx="226">
                  <c:v>42.990008479852499</c:v>
                </c:pt>
                <c:pt idx="227">
                  <c:v>33.499299100843501</c:v>
                </c:pt>
                <c:pt idx="228">
                  <c:v>59.083023540164099</c:v>
                </c:pt>
                <c:pt idx="229">
                  <c:v>54.401734980352202</c:v>
                </c:pt>
                <c:pt idx="230">
                  <c:v>70.983496962599801</c:v>
                </c:pt>
                <c:pt idx="231">
                  <c:v>42.280161391491198</c:v>
                </c:pt>
                <c:pt idx="232">
                  <c:v>56.883508068888702</c:v>
                </c:pt>
                <c:pt idx="233">
                  <c:v>57.0240135484378</c:v>
                </c:pt>
                <c:pt idx="234">
                  <c:v>57.955703235564201</c:v>
                </c:pt>
                <c:pt idx="235">
                  <c:v>43.5314750530246</c:v>
                </c:pt>
                <c:pt idx="236">
                  <c:v>50.664581374276104</c:v>
                </c:pt>
                <c:pt idx="237">
                  <c:v>36.603483778226597</c:v>
                </c:pt>
                <c:pt idx="238">
                  <c:v>54.4311322425566</c:v>
                </c:pt>
                <c:pt idx="239">
                  <c:v>40.939998979766997</c:v>
                </c:pt>
                <c:pt idx="240">
                  <c:v>49.660595598154899</c:v>
                </c:pt>
                <c:pt idx="241">
                  <c:v>49.263777346776102</c:v>
                </c:pt>
                <c:pt idx="242">
                  <c:v>51.011070271085302</c:v>
                </c:pt>
                <c:pt idx="243">
                  <c:v>66.610148000527403</c:v>
                </c:pt>
                <c:pt idx="244">
                  <c:v>47.972404582197399</c:v>
                </c:pt>
                <c:pt idx="245">
                  <c:v>61.1601612302223</c:v>
                </c:pt>
                <c:pt idx="246">
                  <c:v>60.026672189200603</c:v>
                </c:pt>
                <c:pt idx="247">
                  <c:v>21.7647749498853</c:v>
                </c:pt>
                <c:pt idx="248">
                  <c:v>58.572987816476598</c:v>
                </c:pt>
                <c:pt idx="249">
                  <c:v>52.5323875572468</c:v>
                </c:pt>
                <c:pt idx="250">
                  <c:v>52.998580150862303</c:v>
                </c:pt>
                <c:pt idx="251">
                  <c:v>54.4942167787001</c:v>
                </c:pt>
                <c:pt idx="252">
                  <c:v>49.855690965553698</c:v>
                </c:pt>
                <c:pt idx="253">
                  <c:v>58.956414858443502</c:v>
                </c:pt>
                <c:pt idx="254">
                  <c:v>76.731228560061794</c:v>
                </c:pt>
                <c:pt idx="255">
                  <c:v>27.240965868897799</c:v>
                </c:pt>
                <c:pt idx="256">
                  <c:v>50.909235898459002</c:v>
                </c:pt>
                <c:pt idx="257">
                  <c:v>68.736162365080204</c:v>
                </c:pt>
                <c:pt idx="258">
                  <c:v>73.733485074619594</c:v>
                </c:pt>
                <c:pt idx="259">
                  <c:v>46.551512182548699</c:v>
                </c:pt>
                <c:pt idx="260">
                  <c:v>53.482651487735303</c:v>
                </c:pt>
                <c:pt idx="261">
                  <c:v>39.100818098411203</c:v>
                </c:pt>
                <c:pt idx="262">
                  <c:v>51.214858763842997</c:v>
                </c:pt>
                <c:pt idx="263">
                  <c:v>46.053050275939199</c:v>
                </c:pt>
                <c:pt idx="264">
                  <c:v>35.825806557620197</c:v>
                </c:pt>
                <c:pt idx="265">
                  <c:v>62.783162679559901</c:v>
                </c:pt>
                <c:pt idx="266">
                  <c:v>46.514628516579599</c:v>
                </c:pt>
                <c:pt idx="267">
                  <c:v>53.995020481960999</c:v>
                </c:pt>
                <c:pt idx="268">
                  <c:v>43.071453824174398</c:v>
                </c:pt>
                <c:pt idx="269">
                  <c:v>49.074829233558397</c:v>
                </c:pt>
                <c:pt idx="270">
                  <c:v>49.765163778967398</c:v>
                </c:pt>
                <c:pt idx="271">
                  <c:v>61.623355253410502</c:v>
                </c:pt>
                <c:pt idx="272">
                  <c:v>32.918851551533301</c:v>
                </c:pt>
                <c:pt idx="273">
                  <c:v>43.388638800723101</c:v>
                </c:pt>
                <c:pt idx="274">
                  <c:v>60.609318615525503</c:v>
                </c:pt>
                <c:pt idx="275">
                  <c:v>63.064100310151197</c:v>
                </c:pt>
                <c:pt idx="276">
                  <c:v>32.4962147027219</c:v>
                </c:pt>
                <c:pt idx="277">
                  <c:v>58.957866142950202</c:v>
                </c:pt>
                <c:pt idx="278">
                  <c:v>41.316779690310597</c:v>
                </c:pt>
                <c:pt idx="279">
                  <c:v>52.326392150361897</c:v>
                </c:pt>
                <c:pt idx="280">
                  <c:v>62.787637125143704</c:v>
                </c:pt>
                <c:pt idx="281">
                  <c:v>64.568523738090605</c:v>
                </c:pt>
                <c:pt idx="282">
                  <c:v>58.071389846438898</c:v>
                </c:pt>
                <c:pt idx="283">
                  <c:v>51.754538072477203</c:v>
                </c:pt>
                <c:pt idx="284">
                  <c:v>55.174748251138801</c:v>
                </c:pt>
                <c:pt idx="285">
                  <c:v>53.095891989383297</c:v>
                </c:pt>
                <c:pt idx="286">
                  <c:v>44.844932333790403</c:v>
                </c:pt>
                <c:pt idx="287">
                  <c:v>69.430604336269397</c:v>
                </c:pt>
                <c:pt idx="288">
                  <c:v>58.472214987243703</c:v>
                </c:pt>
                <c:pt idx="289">
                  <c:v>59.932507698279501</c:v>
                </c:pt>
                <c:pt idx="290">
                  <c:v>59.966679205323103</c:v>
                </c:pt>
                <c:pt idx="291">
                  <c:v>49.6493396048718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6F5-4348-A498-D639853AE71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3277440"/>
        <c:axId val="33278976"/>
      </c:scatterChart>
      <c:valAx>
        <c:axId val="3327744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278976"/>
        <c:crosses val="autoZero"/>
        <c:crossBetween val="midCat"/>
      </c:valAx>
      <c:valAx>
        <c:axId val="332789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27744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C9359-BA4C-49E8-9E67-A697447FEF4E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4833B-EEDB-43BC-8E39-CFDDF885B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93629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C9359-BA4C-49E8-9E67-A697447FEF4E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4833B-EEDB-43BC-8E39-CFDDF885B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49960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C9359-BA4C-49E8-9E67-A697447FEF4E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4833B-EEDB-43BC-8E39-CFDDF885B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1319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C9359-BA4C-49E8-9E67-A697447FEF4E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4833B-EEDB-43BC-8E39-CFDDF885B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4041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C9359-BA4C-49E8-9E67-A697447FEF4E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4833B-EEDB-43BC-8E39-CFDDF885B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9084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C9359-BA4C-49E8-9E67-A697447FEF4E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4833B-EEDB-43BC-8E39-CFDDF885B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26506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C9359-BA4C-49E8-9E67-A697447FEF4E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4833B-EEDB-43BC-8E39-CFDDF885B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1383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C9359-BA4C-49E8-9E67-A697447FEF4E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4833B-EEDB-43BC-8E39-CFDDF885B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21070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C9359-BA4C-49E8-9E67-A697447FEF4E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4833B-EEDB-43BC-8E39-CFDDF885B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89797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C9359-BA4C-49E8-9E67-A697447FEF4E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4833B-EEDB-43BC-8E39-CFDDF885B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43295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C9359-BA4C-49E8-9E67-A697447FEF4E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4833B-EEDB-43BC-8E39-CFDDF885B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35627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AC9359-BA4C-49E8-9E67-A697447FEF4E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84833B-EEDB-43BC-8E39-CFDDF885B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0828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>
            <p:extLst>
              <p:ext uri="{D42A27DB-BD31-4B8C-83A1-F6EECF244321}">
                <p14:modId xmlns:p14="http://schemas.microsoft.com/office/powerpoint/2010/main" val="1751335512"/>
              </p:ext>
            </p:extLst>
          </p:nvPr>
        </p:nvGraphicFramePr>
        <p:xfrm>
          <a:off x="245165" y="347869"/>
          <a:ext cx="5715000" cy="2880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/>
          <p:nvPr>
            <p:extLst>
              <p:ext uri="{D42A27DB-BD31-4B8C-83A1-F6EECF244321}">
                <p14:modId xmlns:p14="http://schemas.microsoft.com/office/powerpoint/2010/main" val="2617410011"/>
              </p:ext>
            </p:extLst>
          </p:nvPr>
        </p:nvGraphicFramePr>
        <p:xfrm>
          <a:off x="6211956" y="347869"/>
          <a:ext cx="5715000" cy="2880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/>
          <p:cNvGraphicFramePr/>
          <p:nvPr>
            <p:extLst>
              <p:ext uri="{D42A27DB-BD31-4B8C-83A1-F6EECF244321}">
                <p14:modId xmlns:p14="http://schemas.microsoft.com/office/powerpoint/2010/main" val="3582014148"/>
              </p:ext>
            </p:extLst>
          </p:nvPr>
        </p:nvGraphicFramePr>
        <p:xfrm>
          <a:off x="245165" y="3581400"/>
          <a:ext cx="5715000" cy="2880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Chart 6"/>
          <p:cNvGraphicFramePr/>
          <p:nvPr>
            <p:extLst>
              <p:ext uri="{D42A27DB-BD31-4B8C-83A1-F6EECF244321}">
                <p14:modId xmlns:p14="http://schemas.microsoft.com/office/powerpoint/2010/main" val="1219382422"/>
              </p:ext>
            </p:extLst>
          </p:nvPr>
        </p:nvGraphicFramePr>
        <p:xfrm>
          <a:off x="6211956" y="3581400"/>
          <a:ext cx="5715000" cy="2880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25970788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/>
          <p:nvPr>
            <p:extLst>
              <p:ext uri="{D42A27DB-BD31-4B8C-83A1-F6EECF244321}">
                <p14:modId xmlns:p14="http://schemas.microsoft.com/office/powerpoint/2010/main" val="2358536962"/>
              </p:ext>
            </p:extLst>
          </p:nvPr>
        </p:nvGraphicFramePr>
        <p:xfrm>
          <a:off x="324679" y="944217"/>
          <a:ext cx="5715000" cy="2880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/>
          <p:cNvGraphicFramePr/>
          <p:nvPr>
            <p:extLst>
              <p:ext uri="{D42A27DB-BD31-4B8C-83A1-F6EECF244321}">
                <p14:modId xmlns:p14="http://schemas.microsoft.com/office/powerpoint/2010/main" val="3294759930"/>
              </p:ext>
            </p:extLst>
          </p:nvPr>
        </p:nvGraphicFramePr>
        <p:xfrm>
          <a:off x="6301408" y="947530"/>
          <a:ext cx="5715000" cy="2880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16336207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</TotalTime>
  <Words>7</Words>
  <Application>Microsoft Office PowerPoint</Application>
  <PresentationFormat>Widescreen</PresentationFormat>
  <Paragraphs>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RONOB PAUL</dc:creator>
  <cp:lastModifiedBy>Pronob J. Paul</cp:lastModifiedBy>
  <cp:revision>5</cp:revision>
  <dcterms:created xsi:type="dcterms:W3CDTF">2016-06-06T07:28:20Z</dcterms:created>
  <dcterms:modified xsi:type="dcterms:W3CDTF">2017-09-12T08:30:55Z</dcterms:modified>
</cp:coreProperties>
</file>